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  <p:sldId id="288" r:id="rId3"/>
    <p:sldId id="289" r:id="rId4"/>
    <p:sldId id="259" r:id="rId5"/>
    <p:sldId id="290" r:id="rId6"/>
    <p:sldId id="291" r:id="rId7"/>
    <p:sldId id="29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B4C04-4796-F742-5D94-FE11ECA2AB2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540A32-580B-03BB-3C99-2CFF88DCC7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1CB9FB-108D-1B19-D095-2A8822791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E908BA-AEC4-5F7B-A375-6DC93DAFD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8CA97B-D9A4-765F-3B93-3377FFB87A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851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E288D-A9EE-BDB2-3F9F-6B01631B04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B4DC7D-43C4-EC85-464E-9B6AA23C1F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6EE894-538B-CD1A-155F-1AF4787A89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98BC43-1CDE-03EE-C4E0-663FE839F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381059-F3F0-56CB-2CE8-0F6C3CE60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843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CFB9B16-F868-627F-EC2E-81E93119C0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03BE38-ECC0-EF1F-37BA-378A873F31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830021-6167-08BC-A2B9-7B36EBB48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D3E6EE-65C3-CFDA-686F-9103BD143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B589E1-ABC2-6D7D-6A94-8C1104FDBE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498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FBE573-279E-6577-5D3E-B93DD8F0D1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F55E6B-49E8-AC76-C34D-9E5EA3A5D2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4E22D1-CE8A-2FC8-1D0A-3A62A9CE4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4E70AE-7EEA-91F7-412F-3D63BF478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A3B629-9688-F813-7381-C9CE30325D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90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6BF738-D801-D173-8495-C8EF390E7D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183F02-C7E1-0993-378E-C4E34AD267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246999-67A1-C91F-FA74-26D929048B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42AA6-5F34-791B-7CB8-26A7D3765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5EE28C-9F60-4EEB-7009-DC62304DC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773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FCDBEF-104D-9DA9-5D30-A03A3808AB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ED545C-9B9A-0356-86E1-B2497E87C4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744C20-3966-89B1-EDA1-5F2FAB3ED8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7038EB-9D35-D9F7-7AA3-E4C7CC7A7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EE8CE1-759C-3127-926C-DBD1742AC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9366D1-D366-6CD7-6A15-A8CCB6CDB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321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C8B9F-991D-1FA9-8CFD-457420017D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1BACC4-80C6-D680-8571-04EC3D149D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C90497-349F-50DE-1582-4A712A50E9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DE1440-5374-D5D6-2642-DD6D5D0481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F2D8E9-4E25-BFDB-2D65-DF46E502DB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84F3A0E-3A20-E542-7E4B-58A72137DA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C16A3EA-BDCC-BA3D-1418-BCAA0DFBC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2AACC0-1A78-440D-2242-AA1FFE5DB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357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BB686A-5167-3C63-EAAA-24D721174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ACBBCC-89B9-2A1B-D038-A16276EDE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9580A7-DA97-48EB-D4EC-2AA95AEA1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848CB0-0DC8-9D2F-F93E-8CB1525BF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490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C54F2D-9814-46CF-BCB8-1F630A2DE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7E790B-FB9B-2596-BF30-8ED44D9BA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B90ACE-7079-4531-6E31-374C2CCED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462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C68AF-D404-5FFF-078A-5D11F15CE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956476-7704-E39A-474B-D894CB6B82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70A8FF-65F2-9ED9-9B57-D8D947181A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D3FB7A-83DF-A8D3-E5B0-D61AF7A0C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767881-6FDB-9FAB-DAD4-2B0408F748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0E4E43-A823-07A5-F2E9-24326B30C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707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8443EB-3E55-A8D4-6AB0-F3CFA3A6E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8728E0-78C3-42CB-9473-9837EA20DF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3AA81F8-8AC5-3826-4872-A65F26F72B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31786A-719E-E55D-14FC-83E50DA6C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AF38EB-C596-5AB1-A4FA-94073FFF85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C5EEFE-A1C9-0F9F-A93E-E80D4AFF83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495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1B55974-C991-B130-4E80-E3C8ACC46D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A7FA21-A938-603B-3A6A-C095F8831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AC119D-498F-FD0E-0A35-AA20818610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DD6FF-4A9B-41C1-8484-97FF3E24D09F}" type="datetimeFigureOut">
              <a:rPr lang="en-US" smtClean="0"/>
              <a:t>5/8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0CF8EA-0139-602D-C15F-BD74405BB2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B5404-DF97-CE49-660E-28112CE7DA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A6212C-FC7B-4FD5-A235-72BD79A475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720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D996BE6D-FF8B-4669-DEA8-14C5EF1B7D67}"/>
              </a:ext>
            </a:extLst>
          </p:cNvPr>
          <p:cNvGrpSpPr>
            <a:grpSpLocks noChangeAspect="1"/>
          </p:cNvGrpSpPr>
          <p:nvPr/>
        </p:nvGrpSpPr>
        <p:grpSpPr>
          <a:xfrm>
            <a:off x="2353458" y="381388"/>
            <a:ext cx="7299753" cy="6402098"/>
            <a:chOff x="2351552" y="-34245"/>
            <a:chExt cx="7806672" cy="6846681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00D1E51-D9F2-1AE2-860B-26D36E9F3E2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37230" y="342900"/>
              <a:ext cx="6571082" cy="6126480"/>
            </a:xfrm>
            <a:prstGeom prst="rect">
              <a:avLst/>
            </a:prstGeom>
          </p:spPr>
        </p:pic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D535EBBE-4414-C777-0756-8B30E089152C}"/>
                </a:ext>
              </a:extLst>
            </p:cNvPr>
            <p:cNvCxnSpPr>
              <a:cxnSpLocks/>
            </p:cNvCxnSpPr>
            <p:nvPr/>
          </p:nvCxnSpPr>
          <p:spPr>
            <a:xfrm rot="840000" flipV="1">
              <a:off x="6693763" y="342900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E93827E-0C76-C622-B69A-07D55BAF7560}"/>
                </a:ext>
              </a:extLst>
            </p:cNvPr>
            <p:cNvSpPr txBox="1"/>
            <p:nvPr/>
          </p:nvSpPr>
          <p:spPr>
            <a:xfrm>
              <a:off x="6505575" y="160580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8F41346-A4FF-D769-925F-1ACE91368E0C}"/>
                </a:ext>
              </a:extLst>
            </p:cNvPr>
            <p:cNvCxnSpPr>
              <a:cxnSpLocks/>
            </p:cNvCxnSpPr>
            <p:nvPr/>
          </p:nvCxnSpPr>
          <p:spPr>
            <a:xfrm rot="1140000" flipV="1">
              <a:off x="7066870" y="453264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75F01ABC-DC59-D779-0797-1FD6B7159CB6}"/>
                </a:ext>
              </a:extLst>
            </p:cNvPr>
            <p:cNvCxnSpPr>
              <a:cxnSpLocks/>
            </p:cNvCxnSpPr>
            <p:nvPr/>
          </p:nvCxnSpPr>
          <p:spPr>
            <a:xfrm rot="1680000" flipV="1">
              <a:off x="7355905" y="575591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3D106BBC-5E60-BF52-538E-939EE788DE87}"/>
                </a:ext>
              </a:extLst>
            </p:cNvPr>
            <p:cNvCxnSpPr>
              <a:cxnSpLocks/>
            </p:cNvCxnSpPr>
            <p:nvPr/>
          </p:nvCxnSpPr>
          <p:spPr>
            <a:xfrm rot="2340000" flipV="1">
              <a:off x="7893683" y="938197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89AE76C1-43C5-53E0-160A-C62854DE3AB8}"/>
                </a:ext>
              </a:extLst>
            </p:cNvPr>
            <p:cNvCxnSpPr>
              <a:cxnSpLocks/>
            </p:cNvCxnSpPr>
            <p:nvPr/>
          </p:nvCxnSpPr>
          <p:spPr>
            <a:xfrm rot="2340000" flipV="1">
              <a:off x="8032069" y="1052752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5911C05F-0063-5184-6115-8F79503EDB10}"/>
                </a:ext>
              </a:extLst>
            </p:cNvPr>
            <p:cNvCxnSpPr>
              <a:cxnSpLocks/>
            </p:cNvCxnSpPr>
            <p:nvPr/>
          </p:nvCxnSpPr>
          <p:spPr>
            <a:xfrm rot="2340000" flipV="1">
              <a:off x="8145932" y="1156798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4C2F2AEC-3E7B-39D0-D097-4F21CC2FB4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74770" y="1242959"/>
              <a:ext cx="194513" cy="1033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>
              <a:extLst>
                <a:ext uri="{FF2B5EF4-FFF2-40B4-BE49-F238E27FC236}">
                  <a16:creationId xmlns:a16="http://schemas.microsoft.com/office/drawing/2014/main" id="{D2EF8D5B-B873-E1E7-0C73-F68E37AAE420}"/>
                </a:ext>
              </a:extLst>
            </p:cNvPr>
            <p:cNvCxnSpPr>
              <a:cxnSpLocks/>
            </p:cNvCxnSpPr>
            <p:nvPr/>
          </p:nvCxnSpPr>
          <p:spPr>
            <a:xfrm rot="2820000" flipV="1">
              <a:off x="8350480" y="1400149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CC5C55E-1E7A-4FDF-ECA6-CDCDD9631DEA}"/>
                </a:ext>
              </a:extLst>
            </p:cNvPr>
            <p:cNvSpPr txBox="1"/>
            <p:nvPr/>
          </p:nvSpPr>
          <p:spPr>
            <a:xfrm>
              <a:off x="8278504" y="1078066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b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5240BFE2-71C9-3D90-354F-339C88DD266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64478" y="1539113"/>
              <a:ext cx="111356" cy="541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E9DB8F1-38BC-BB45-A667-CF4B42F901F1}"/>
                </a:ext>
              </a:extLst>
            </p:cNvPr>
            <p:cNvCxnSpPr>
              <a:cxnSpLocks/>
            </p:cNvCxnSpPr>
            <p:nvPr/>
          </p:nvCxnSpPr>
          <p:spPr>
            <a:xfrm>
              <a:off x="8401376" y="1625949"/>
              <a:ext cx="201574" cy="44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7CFA1AD-9351-FBCF-DE1F-DE7E723AEAD4}"/>
                </a:ext>
              </a:extLst>
            </p:cNvPr>
            <p:cNvSpPr txBox="1"/>
            <p:nvPr/>
          </p:nvSpPr>
          <p:spPr>
            <a:xfrm>
              <a:off x="8524707" y="1532514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R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1E49783C-781E-4253-BAA5-DA285E67C868}"/>
                </a:ext>
              </a:extLst>
            </p:cNvPr>
            <p:cNvCxnSpPr>
              <a:cxnSpLocks/>
            </p:cNvCxnSpPr>
            <p:nvPr/>
          </p:nvCxnSpPr>
          <p:spPr>
            <a:xfrm rot="3420000" flipV="1">
              <a:off x="8576735" y="1715797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D6D81FAF-409A-326C-5609-3484773B2F52}"/>
                </a:ext>
              </a:extLst>
            </p:cNvPr>
            <p:cNvCxnSpPr>
              <a:cxnSpLocks/>
            </p:cNvCxnSpPr>
            <p:nvPr/>
          </p:nvCxnSpPr>
          <p:spPr>
            <a:xfrm rot="3780000" flipV="1">
              <a:off x="8685237" y="1914814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DF1E39B-50B4-0E09-5D7F-20D353F7D282}"/>
                </a:ext>
              </a:extLst>
            </p:cNvPr>
            <p:cNvSpPr txBox="1"/>
            <p:nvPr/>
          </p:nvSpPr>
          <p:spPr>
            <a:xfrm>
              <a:off x="8662816" y="1811555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V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52C0AD49-AA13-3B16-6532-DFD3C8835D1A}"/>
                </a:ext>
              </a:extLst>
            </p:cNvPr>
            <p:cNvCxnSpPr>
              <a:cxnSpLocks/>
            </p:cNvCxnSpPr>
            <p:nvPr/>
          </p:nvCxnSpPr>
          <p:spPr>
            <a:xfrm rot="3960000" flipV="1">
              <a:off x="8797192" y="2147348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F1A301BD-B4B6-FEAF-BA2C-9E790AF7A0D8}"/>
                </a:ext>
              </a:extLst>
            </p:cNvPr>
            <p:cNvCxnSpPr>
              <a:cxnSpLocks/>
            </p:cNvCxnSpPr>
            <p:nvPr/>
          </p:nvCxnSpPr>
          <p:spPr>
            <a:xfrm rot="4620000" flipV="1">
              <a:off x="8939721" y="2575862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ACEB323-BBAA-3404-8E21-E85FE2B71951}"/>
                </a:ext>
              </a:extLst>
            </p:cNvPr>
            <p:cNvSpPr txBox="1"/>
            <p:nvPr/>
          </p:nvSpPr>
          <p:spPr>
            <a:xfrm>
              <a:off x="8911818" y="2499732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M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5045D194-BBA9-0D87-3591-8FB26B938E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19999" y="651538"/>
              <a:ext cx="1038225" cy="1647825"/>
            </a:xfrm>
            <a:prstGeom prst="rect">
              <a:avLst/>
            </a:prstGeom>
          </p:spPr>
        </p:pic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3A491184-7CE0-6848-4A4A-6C3492A71407}"/>
                </a:ext>
              </a:extLst>
            </p:cNvPr>
            <p:cNvCxnSpPr>
              <a:cxnSpLocks/>
            </p:cNvCxnSpPr>
            <p:nvPr/>
          </p:nvCxnSpPr>
          <p:spPr>
            <a:xfrm rot="3840000" flipV="1">
              <a:off x="9024937" y="3032811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4AA7667-4077-59BA-A3B2-149AA9DF5CD9}"/>
                </a:ext>
              </a:extLst>
            </p:cNvPr>
            <p:cNvSpPr txBox="1"/>
            <p:nvPr/>
          </p:nvSpPr>
          <p:spPr>
            <a:xfrm>
              <a:off x="8975434" y="2907451"/>
              <a:ext cx="43749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lm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BA8F13C5-CB2F-051D-0C5E-EC88B8CD0497}"/>
                </a:ext>
              </a:extLst>
            </p:cNvPr>
            <p:cNvCxnSpPr>
              <a:cxnSpLocks/>
            </p:cNvCxnSpPr>
            <p:nvPr/>
          </p:nvCxnSpPr>
          <p:spPr>
            <a:xfrm>
              <a:off x="8964894" y="3150120"/>
              <a:ext cx="140862" cy="332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F5CB2BB4-ECD0-A2E6-8BBF-F7D476BA1686}"/>
                </a:ext>
              </a:extLst>
            </p:cNvPr>
            <p:cNvCxnSpPr>
              <a:cxnSpLocks/>
            </p:cNvCxnSpPr>
            <p:nvPr/>
          </p:nvCxnSpPr>
          <p:spPr>
            <a:xfrm rot="5160000" flipV="1">
              <a:off x="9033854" y="3252764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244D590C-8991-77C3-12BB-86CF72124E9A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9036717" y="3420095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316295CC-1C57-F598-BD80-88502F42C02F}"/>
                </a:ext>
              </a:extLst>
            </p:cNvPr>
            <p:cNvCxnSpPr>
              <a:cxnSpLocks/>
            </p:cNvCxnSpPr>
            <p:nvPr/>
          </p:nvCxnSpPr>
          <p:spPr>
            <a:xfrm rot="5400000" flipV="1">
              <a:off x="9029639" y="3580211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E9B9DBBB-2276-95E6-3F26-DDAEDE10DE1A}"/>
                </a:ext>
              </a:extLst>
            </p:cNvPr>
            <p:cNvCxnSpPr>
              <a:cxnSpLocks/>
            </p:cNvCxnSpPr>
            <p:nvPr/>
          </p:nvCxnSpPr>
          <p:spPr>
            <a:xfrm>
              <a:off x="8964952" y="3700842"/>
              <a:ext cx="118126" cy="985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C54FF76D-7ADB-EA1A-82D3-104BB25777D0}"/>
                </a:ext>
              </a:extLst>
            </p:cNvPr>
            <p:cNvSpPr txBox="1"/>
            <p:nvPr/>
          </p:nvSpPr>
          <p:spPr>
            <a:xfrm>
              <a:off x="9003107" y="3673083"/>
              <a:ext cx="35520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3E01DACB-49B2-5804-D9E9-916D3E03C905}"/>
                </a:ext>
              </a:extLst>
            </p:cNvPr>
            <p:cNvCxnSpPr>
              <a:cxnSpLocks/>
            </p:cNvCxnSpPr>
            <p:nvPr/>
          </p:nvCxnSpPr>
          <p:spPr>
            <a:xfrm rot="4440000" flipV="1">
              <a:off x="8964952" y="4001263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6F3AA3E-B4FF-60B5-140D-798921BC4EB8}"/>
                </a:ext>
              </a:extLst>
            </p:cNvPr>
            <p:cNvSpPr txBox="1"/>
            <p:nvPr/>
          </p:nvSpPr>
          <p:spPr>
            <a:xfrm>
              <a:off x="8926296" y="4056115"/>
              <a:ext cx="45120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da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38F93241-2087-A0D3-3EB4-DC540B0476D2}"/>
                </a:ext>
              </a:extLst>
            </p:cNvPr>
            <p:cNvCxnSpPr>
              <a:cxnSpLocks/>
            </p:cNvCxnSpPr>
            <p:nvPr/>
          </p:nvCxnSpPr>
          <p:spPr>
            <a:xfrm>
              <a:off x="8884935" y="4125341"/>
              <a:ext cx="120979" cy="4821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FB2FF19B-434F-7C24-D29B-DA6E9D3A2EE3}"/>
                </a:ext>
              </a:extLst>
            </p:cNvPr>
            <p:cNvCxnSpPr>
              <a:cxnSpLocks/>
            </p:cNvCxnSpPr>
            <p:nvPr/>
          </p:nvCxnSpPr>
          <p:spPr>
            <a:xfrm rot="17640000">
              <a:off x="8873963" y="4336627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166E72C9-788D-A0A7-BD36-2746D6BCDC2A}"/>
                </a:ext>
              </a:extLst>
            </p:cNvPr>
            <p:cNvCxnSpPr>
              <a:cxnSpLocks/>
            </p:cNvCxnSpPr>
            <p:nvPr/>
          </p:nvCxnSpPr>
          <p:spPr>
            <a:xfrm rot="17640000">
              <a:off x="8827208" y="4466878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62E9449A-B379-5EEB-0E49-55C58C5EC3A8}"/>
                </a:ext>
              </a:extLst>
            </p:cNvPr>
            <p:cNvSpPr txBox="1"/>
            <p:nvPr/>
          </p:nvSpPr>
          <p:spPr>
            <a:xfrm>
              <a:off x="8809568" y="4423411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ch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0636D765-F82A-A0DA-6294-2F6CF0EB8AC1}"/>
                </a:ext>
              </a:extLst>
            </p:cNvPr>
            <p:cNvCxnSpPr>
              <a:cxnSpLocks/>
            </p:cNvCxnSpPr>
            <p:nvPr/>
          </p:nvCxnSpPr>
          <p:spPr>
            <a:xfrm rot="17640000">
              <a:off x="8751094" y="4637650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B23C4E81-2B47-6195-811B-C4E1E986D25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76735" y="4861276"/>
              <a:ext cx="152549" cy="4873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BB0A40CD-E243-F867-0829-C054318FB6F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45868" y="4949407"/>
              <a:ext cx="199332" cy="1267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85BDE832-5D0D-1D1F-9773-20CF9F095B20}"/>
                </a:ext>
              </a:extLst>
            </p:cNvPr>
            <p:cNvCxnSpPr>
              <a:cxnSpLocks/>
            </p:cNvCxnSpPr>
            <p:nvPr/>
          </p:nvCxnSpPr>
          <p:spPr>
            <a:xfrm>
              <a:off x="8520815" y="4994767"/>
              <a:ext cx="118652" cy="514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3C5381C7-1BC9-7E49-82AC-D7A4323DAD53}"/>
                </a:ext>
              </a:extLst>
            </p:cNvPr>
            <p:cNvCxnSpPr>
              <a:cxnSpLocks/>
            </p:cNvCxnSpPr>
            <p:nvPr/>
          </p:nvCxnSpPr>
          <p:spPr>
            <a:xfrm rot="18240000">
              <a:off x="8514339" y="5065192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F6D34051-2EA5-B41F-011C-C4DC969CC37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287555" y="5329008"/>
              <a:ext cx="108787" cy="163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50D532D1-220C-4753-7DF7-5779ED5EBDCE}"/>
                </a:ext>
              </a:extLst>
            </p:cNvPr>
            <p:cNvCxnSpPr>
              <a:cxnSpLocks/>
            </p:cNvCxnSpPr>
            <p:nvPr/>
          </p:nvCxnSpPr>
          <p:spPr>
            <a:xfrm rot="18240000">
              <a:off x="8268725" y="5378544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BD92F375-9D02-8879-EB3B-E45F32C696A7}"/>
                </a:ext>
              </a:extLst>
            </p:cNvPr>
            <p:cNvCxnSpPr>
              <a:cxnSpLocks/>
            </p:cNvCxnSpPr>
            <p:nvPr/>
          </p:nvCxnSpPr>
          <p:spPr>
            <a:xfrm rot="18240000">
              <a:off x="8125844" y="5531285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06561A20-D328-2263-D03F-E710E73AC3D0}"/>
                </a:ext>
              </a:extLst>
            </p:cNvPr>
            <p:cNvCxnSpPr>
              <a:cxnSpLocks/>
            </p:cNvCxnSpPr>
            <p:nvPr/>
          </p:nvCxnSpPr>
          <p:spPr>
            <a:xfrm rot="18240000">
              <a:off x="8032068" y="5617092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8502F164-855E-B0D5-307B-4BCD495F8328}"/>
                </a:ext>
              </a:extLst>
            </p:cNvPr>
            <p:cNvCxnSpPr>
              <a:cxnSpLocks/>
            </p:cNvCxnSpPr>
            <p:nvPr/>
          </p:nvCxnSpPr>
          <p:spPr>
            <a:xfrm rot="18240000">
              <a:off x="7907179" y="5734022"/>
              <a:ext cx="0" cy="128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401F65E-3870-C794-496B-126908B83B45}"/>
                </a:ext>
              </a:extLst>
            </p:cNvPr>
            <p:cNvSpPr txBox="1"/>
            <p:nvPr/>
          </p:nvSpPr>
          <p:spPr>
            <a:xfrm>
              <a:off x="8307005" y="5194215"/>
              <a:ext cx="485495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629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F1FB6F56-F6FA-9C16-E2F3-F03D6673E7BC}"/>
                </a:ext>
              </a:extLst>
            </p:cNvPr>
            <p:cNvCxnSpPr>
              <a:cxnSpLocks/>
            </p:cNvCxnSpPr>
            <p:nvPr/>
          </p:nvCxnSpPr>
          <p:spPr>
            <a:xfrm>
              <a:off x="7564564" y="5964789"/>
              <a:ext cx="53242" cy="17148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FB2A3B34-5B3C-5C0F-B63F-5608754C6C0A}"/>
                </a:ext>
              </a:extLst>
            </p:cNvPr>
            <p:cNvCxnSpPr>
              <a:cxnSpLocks/>
            </p:cNvCxnSpPr>
            <p:nvPr/>
          </p:nvCxnSpPr>
          <p:spPr>
            <a:xfrm rot="600000">
              <a:off x="7682840" y="5886960"/>
              <a:ext cx="124644" cy="2633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2AC821CE-5771-61BA-DAA9-46A85640AEF5}"/>
                </a:ext>
              </a:extLst>
            </p:cNvPr>
            <p:cNvCxnSpPr>
              <a:cxnSpLocks/>
            </p:cNvCxnSpPr>
            <p:nvPr/>
          </p:nvCxnSpPr>
          <p:spPr>
            <a:xfrm rot="300000">
              <a:off x="7451008" y="6025096"/>
              <a:ext cx="42373" cy="164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33FD878F-191F-183F-6040-5E1EC80BEE02}"/>
                </a:ext>
              </a:extLst>
            </p:cNvPr>
            <p:cNvSpPr txBox="1"/>
            <p:nvPr/>
          </p:nvSpPr>
          <p:spPr>
            <a:xfrm>
              <a:off x="7873659" y="5724268"/>
              <a:ext cx="43749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D9B565D0-0C4B-1898-B905-BA16FF049A79}"/>
                </a:ext>
              </a:extLst>
            </p:cNvPr>
            <p:cNvCxnSpPr>
              <a:cxnSpLocks/>
            </p:cNvCxnSpPr>
            <p:nvPr/>
          </p:nvCxnSpPr>
          <p:spPr>
            <a:xfrm>
              <a:off x="7607676" y="5941487"/>
              <a:ext cx="205289" cy="1096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4A6B9A05-A97E-5715-DF03-E080DD54EA5C}"/>
                </a:ext>
              </a:extLst>
            </p:cNvPr>
            <p:cNvSpPr txBox="1"/>
            <p:nvPr/>
          </p:nvSpPr>
          <p:spPr>
            <a:xfrm>
              <a:off x="7484596" y="6046018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cd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3" name="Straight Connector 72">
              <a:extLst>
                <a:ext uri="{FF2B5EF4-FFF2-40B4-BE49-F238E27FC236}">
                  <a16:creationId xmlns:a16="http://schemas.microsoft.com/office/drawing/2014/main" id="{AE575304-D669-4E3B-2261-C288535B0987}"/>
                </a:ext>
              </a:extLst>
            </p:cNvPr>
            <p:cNvCxnSpPr>
              <a:cxnSpLocks/>
            </p:cNvCxnSpPr>
            <p:nvPr/>
          </p:nvCxnSpPr>
          <p:spPr>
            <a:xfrm>
              <a:off x="7045809" y="6234683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9B2EBC21-8ED8-CAC1-09B8-BC511D32D1D8}"/>
                </a:ext>
              </a:extLst>
            </p:cNvPr>
            <p:cNvCxnSpPr>
              <a:cxnSpLocks/>
            </p:cNvCxnSpPr>
            <p:nvPr/>
          </p:nvCxnSpPr>
          <p:spPr>
            <a:xfrm>
              <a:off x="6832619" y="6301692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FA056406-0F13-2D54-A58D-5625EC54448F}"/>
                </a:ext>
              </a:extLst>
            </p:cNvPr>
            <p:cNvCxnSpPr>
              <a:cxnSpLocks/>
            </p:cNvCxnSpPr>
            <p:nvPr/>
          </p:nvCxnSpPr>
          <p:spPr>
            <a:xfrm>
              <a:off x="6553541" y="6371634"/>
              <a:ext cx="25871" cy="16225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A7EDD6F5-E741-37BB-8535-51EE17BE12BC}"/>
                </a:ext>
              </a:extLst>
            </p:cNvPr>
            <p:cNvCxnSpPr>
              <a:cxnSpLocks/>
            </p:cNvCxnSpPr>
            <p:nvPr/>
          </p:nvCxnSpPr>
          <p:spPr>
            <a:xfrm rot="720000">
              <a:off x="6657052" y="6347357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7B1F334-21A0-8F8E-DB4F-AC4926370C53}"/>
                </a:ext>
              </a:extLst>
            </p:cNvPr>
            <p:cNvSpPr txBox="1"/>
            <p:nvPr/>
          </p:nvSpPr>
          <p:spPr>
            <a:xfrm>
              <a:off x="6605006" y="6369203"/>
              <a:ext cx="4026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0E01F670-9EB2-40F2-4F5A-E5189E1362C2}"/>
                </a:ext>
              </a:extLst>
            </p:cNvPr>
            <p:cNvCxnSpPr>
              <a:cxnSpLocks/>
            </p:cNvCxnSpPr>
            <p:nvPr/>
          </p:nvCxnSpPr>
          <p:spPr>
            <a:xfrm rot="1560000">
              <a:off x="6298945" y="6423283"/>
              <a:ext cx="183644" cy="14726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954B07CC-60A9-4EDC-063F-6BF2D7934E53}"/>
                </a:ext>
              </a:extLst>
            </p:cNvPr>
            <p:cNvSpPr txBox="1"/>
            <p:nvPr/>
          </p:nvSpPr>
          <p:spPr>
            <a:xfrm>
              <a:off x="6491538" y="6450330"/>
              <a:ext cx="502638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S71A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3E8A2BD-6CE4-A1D5-42ED-06CE97A25008}"/>
                </a:ext>
              </a:extLst>
            </p:cNvPr>
            <p:cNvSpPr txBox="1"/>
            <p:nvPr/>
          </p:nvSpPr>
          <p:spPr>
            <a:xfrm>
              <a:off x="6273347" y="6544415"/>
              <a:ext cx="55406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20</a:t>
              </a: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99B9DF8B-BAD9-68EB-17A5-3DD7AEBD73D7}"/>
                </a:ext>
              </a:extLst>
            </p:cNvPr>
            <p:cNvCxnSpPr>
              <a:cxnSpLocks/>
            </p:cNvCxnSpPr>
            <p:nvPr/>
          </p:nvCxnSpPr>
          <p:spPr>
            <a:xfrm rot="1020000">
              <a:off x="6124323" y="6419584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D9F86F56-6FED-9A73-6FC5-C30EB66CF8F2}"/>
                </a:ext>
              </a:extLst>
            </p:cNvPr>
            <p:cNvCxnSpPr>
              <a:cxnSpLocks/>
            </p:cNvCxnSpPr>
            <p:nvPr/>
          </p:nvCxnSpPr>
          <p:spPr>
            <a:xfrm rot="600000">
              <a:off x="6038258" y="6425404"/>
              <a:ext cx="47308" cy="164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A10A1D30-6C92-E442-E744-A10ADA756388}"/>
                </a:ext>
              </a:extLst>
            </p:cNvPr>
            <p:cNvCxnSpPr>
              <a:cxnSpLocks/>
            </p:cNvCxnSpPr>
            <p:nvPr/>
          </p:nvCxnSpPr>
          <p:spPr>
            <a:xfrm rot="1560000">
              <a:off x="5844809" y="643010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03A6BAAA-BC36-FE75-7399-D62C3865CFFB}"/>
                </a:ext>
              </a:extLst>
            </p:cNvPr>
            <p:cNvCxnSpPr>
              <a:cxnSpLocks/>
            </p:cNvCxnSpPr>
            <p:nvPr/>
          </p:nvCxnSpPr>
          <p:spPr>
            <a:xfrm rot="1560000">
              <a:off x="5643147" y="6417704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FEF158D-8EE5-A635-D8D1-5268826B96D0}"/>
                </a:ext>
              </a:extLst>
            </p:cNvPr>
            <p:cNvSpPr txBox="1"/>
            <p:nvPr/>
          </p:nvSpPr>
          <p:spPr>
            <a:xfrm>
              <a:off x="5471004" y="6462980"/>
              <a:ext cx="362064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flS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34586552-38AB-0C1A-2C71-F00E0B10AE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66349" y="6259649"/>
              <a:ext cx="65770" cy="1755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8CF33D3E-49EF-464B-E9CE-E612BD940C73}"/>
                </a:ext>
              </a:extLst>
            </p:cNvPr>
            <p:cNvCxnSpPr>
              <a:cxnSpLocks/>
            </p:cNvCxnSpPr>
            <p:nvPr/>
          </p:nvCxnSpPr>
          <p:spPr>
            <a:xfrm>
              <a:off x="5417920" y="6397152"/>
              <a:ext cx="10262" cy="2286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7F78A85A-9EEB-2D18-D40B-D08D44D10989}"/>
                </a:ext>
              </a:extLst>
            </p:cNvPr>
            <p:cNvCxnSpPr>
              <a:cxnSpLocks/>
            </p:cNvCxnSpPr>
            <p:nvPr/>
          </p:nvCxnSpPr>
          <p:spPr>
            <a:xfrm rot="2100000">
              <a:off x="5319901" y="6383471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1EA14337-A186-87D6-835D-41AD0C9B41F4}"/>
                </a:ext>
              </a:extLst>
            </p:cNvPr>
            <p:cNvSpPr txBox="1"/>
            <p:nvPr/>
          </p:nvSpPr>
          <p:spPr>
            <a:xfrm>
              <a:off x="5240212" y="6565574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91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0BA0C11C-2D23-6631-6D7F-E88ADADECAC2}"/>
                </a:ext>
              </a:extLst>
            </p:cNvPr>
            <p:cNvSpPr txBox="1"/>
            <p:nvPr/>
          </p:nvSpPr>
          <p:spPr>
            <a:xfrm>
              <a:off x="6029384" y="6441716"/>
              <a:ext cx="412292" cy="2139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sC</a:t>
              </a:r>
              <a:endParaRPr 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29D90A6-164A-A369-A869-95F7E208934D}"/>
                </a:ext>
              </a:extLst>
            </p:cNvPr>
            <p:cNvSpPr txBox="1"/>
            <p:nvPr/>
          </p:nvSpPr>
          <p:spPr>
            <a:xfrm>
              <a:off x="5888560" y="6524667"/>
              <a:ext cx="421910" cy="230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s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106B3868-2890-40FE-5575-9CFE3197C2C2}"/>
                </a:ext>
              </a:extLst>
            </p:cNvPr>
            <p:cNvSpPr txBox="1"/>
            <p:nvPr/>
          </p:nvSpPr>
          <p:spPr>
            <a:xfrm>
              <a:off x="5678869" y="6445608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s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E031C7D-D98C-1549-9C99-93A8D695F19B}"/>
                </a:ext>
              </a:extLst>
            </p:cNvPr>
            <p:cNvSpPr txBox="1"/>
            <p:nvPr/>
          </p:nvSpPr>
          <p:spPr>
            <a:xfrm>
              <a:off x="5117161" y="6407742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zraP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E198CC48-1112-5036-DA66-FBC2CB9AB09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01473" y="6198511"/>
              <a:ext cx="3401" cy="24320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26B245C0-8529-DAC1-1D6A-5610A0DD6545}"/>
                </a:ext>
              </a:extLst>
            </p:cNvPr>
            <p:cNvSpPr txBox="1"/>
            <p:nvPr/>
          </p:nvSpPr>
          <p:spPr>
            <a:xfrm>
              <a:off x="4614325" y="6384712"/>
              <a:ext cx="55406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Cro1</a:t>
              </a: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5CF4E6F3-5F11-F901-F1F3-D2CAA4D97B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03248" y="6100889"/>
              <a:ext cx="89377" cy="1179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162E6EDD-4E5B-43BC-B035-DA733E0E1EE1}"/>
                </a:ext>
              </a:extLst>
            </p:cNvPr>
            <p:cNvSpPr txBox="1"/>
            <p:nvPr/>
          </p:nvSpPr>
          <p:spPr>
            <a:xfrm>
              <a:off x="4323393" y="6151809"/>
              <a:ext cx="350065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4</a:t>
              </a: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FFCEA8F0-863B-1D14-D37F-9FC9A0F1DF4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6947" y="5984227"/>
              <a:ext cx="409589" cy="16246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AE1BABCA-A26B-540C-D090-C745E85085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214762" y="6004269"/>
              <a:ext cx="197232" cy="22204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6AAA2CB9-3F27-8387-6CA1-4025849C53A9}"/>
                </a:ext>
              </a:extLst>
            </p:cNvPr>
            <p:cNvSpPr txBox="1"/>
            <p:nvPr/>
          </p:nvSpPr>
          <p:spPr>
            <a:xfrm>
              <a:off x="3948443" y="6167284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B1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4A7FCA7-9A97-F9E9-019B-274C5FA99F8A}"/>
                </a:ext>
              </a:extLst>
            </p:cNvPr>
            <p:cNvSpPr txBox="1"/>
            <p:nvPr/>
          </p:nvSpPr>
          <p:spPr>
            <a:xfrm>
              <a:off x="3593857" y="6076507"/>
              <a:ext cx="588355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Bam1</a:t>
              </a:r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5F53EB4C-B7EA-64EF-4036-866D9A31A90A}"/>
                </a:ext>
              </a:extLst>
            </p:cNvPr>
            <p:cNvCxnSpPr>
              <a:cxnSpLocks/>
            </p:cNvCxnSpPr>
            <p:nvPr/>
          </p:nvCxnSpPr>
          <p:spPr>
            <a:xfrm rot="3720000">
              <a:off x="4130991" y="5847744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F0360635-7305-059D-CE8C-873F22C6E277}"/>
                </a:ext>
              </a:extLst>
            </p:cNvPr>
            <p:cNvSpPr txBox="1"/>
            <p:nvPr/>
          </p:nvSpPr>
          <p:spPr>
            <a:xfrm>
              <a:off x="3912865" y="5861167"/>
              <a:ext cx="410065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D8E5E98C-9EAE-A1B7-EDA2-640CC0D9F0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01942" y="5497761"/>
              <a:ext cx="61970" cy="25359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CDF89C4B-DDCC-3ABF-F5AB-5DB5B20F9A7A}"/>
                </a:ext>
              </a:extLst>
            </p:cNvPr>
            <p:cNvCxnSpPr>
              <a:cxnSpLocks/>
            </p:cNvCxnSpPr>
            <p:nvPr/>
          </p:nvCxnSpPr>
          <p:spPr>
            <a:xfrm rot="4080000">
              <a:off x="3969751" y="5729052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0DCDC9C2-0C42-2F71-4E0D-CB0256EADA0D}"/>
                </a:ext>
              </a:extLst>
            </p:cNvPr>
            <p:cNvSpPr txBox="1"/>
            <p:nvPr/>
          </p:nvSpPr>
          <p:spPr>
            <a:xfrm>
              <a:off x="3758174" y="5738558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erC2</a:t>
              </a:r>
            </a:p>
          </p:txBody>
        </p: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625356C8-94E2-CF79-113B-A5EA0E61D46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77389" y="5431730"/>
              <a:ext cx="128016" cy="12777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514C96F8-AB44-290D-20BF-F878DEC1157D}"/>
                </a:ext>
              </a:extLst>
            </p:cNvPr>
            <p:cNvCxnSpPr>
              <a:cxnSpLocks/>
            </p:cNvCxnSpPr>
            <p:nvPr/>
          </p:nvCxnSpPr>
          <p:spPr>
            <a:xfrm rot="6360000">
              <a:off x="2844364" y="3387850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EBC41B5-7BA8-20F9-7286-D94F2A360372}"/>
                </a:ext>
              </a:extLst>
            </p:cNvPr>
            <p:cNvSpPr txBox="1"/>
            <p:nvPr/>
          </p:nvSpPr>
          <p:spPr>
            <a:xfrm>
              <a:off x="3422606" y="5682109"/>
              <a:ext cx="55406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17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EE463341-8091-474B-8D41-B47D81ABAEC6}"/>
                </a:ext>
              </a:extLst>
            </p:cNvPr>
            <p:cNvSpPr txBox="1"/>
            <p:nvPr/>
          </p:nvSpPr>
          <p:spPr>
            <a:xfrm>
              <a:off x="3387434" y="5504403"/>
              <a:ext cx="36206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3</a:t>
              </a:r>
            </a:p>
          </p:txBody>
        </p: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1AF5AD3F-A786-2AAE-A018-A7A8F1A7DFDE}"/>
                </a:ext>
              </a:extLst>
            </p:cNvPr>
            <p:cNvCxnSpPr>
              <a:cxnSpLocks/>
            </p:cNvCxnSpPr>
            <p:nvPr/>
          </p:nvCxnSpPr>
          <p:spPr>
            <a:xfrm rot="4320000">
              <a:off x="3504609" y="5265010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147AB6F0-E435-C1A5-9456-7BD6634A2289}"/>
                </a:ext>
              </a:extLst>
            </p:cNvPr>
            <p:cNvSpPr txBox="1"/>
            <p:nvPr/>
          </p:nvSpPr>
          <p:spPr>
            <a:xfrm>
              <a:off x="3207094" y="5270251"/>
              <a:ext cx="36206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2</a:t>
              </a: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E5FAEB1B-5D67-A72F-AB92-06B9021E6AFA}"/>
                </a:ext>
              </a:extLst>
            </p:cNvPr>
            <p:cNvCxnSpPr>
              <a:cxnSpLocks/>
            </p:cNvCxnSpPr>
            <p:nvPr/>
          </p:nvCxnSpPr>
          <p:spPr>
            <a:xfrm rot="5100000">
              <a:off x="3081130" y="4534056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451B35E2-65D8-E012-7B43-97F6CF7701AF}"/>
                </a:ext>
              </a:extLst>
            </p:cNvPr>
            <p:cNvCxnSpPr>
              <a:cxnSpLocks/>
            </p:cNvCxnSpPr>
            <p:nvPr/>
          </p:nvCxnSpPr>
          <p:spPr>
            <a:xfrm rot="4320000">
              <a:off x="3282008" y="4926177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60088870-31D8-E4CB-E5D3-ECE9EAAA9D2F}"/>
                </a:ext>
              </a:extLst>
            </p:cNvPr>
            <p:cNvSpPr txBox="1"/>
            <p:nvPr/>
          </p:nvSpPr>
          <p:spPr>
            <a:xfrm>
              <a:off x="2945456" y="4931863"/>
              <a:ext cx="43749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r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AF0D590F-3463-AD37-6471-B0DA7878E31E}"/>
                </a:ext>
              </a:extLst>
            </p:cNvPr>
            <p:cNvCxnSpPr>
              <a:cxnSpLocks/>
            </p:cNvCxnSpPr>
            <p:nvPr/>
          </p:nvCxnSpPr>
          <p:spPr>
            <a:xfrm rot="4980000">
              <a:off x="3225109" y="4838581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CFB13052-524F-222B-23DA-7A9763AE601B}"/>
                </a:ext>
              </a:extLst>
            </p:cNvPr>
            <p:cNvCxnSpPr>
              <a:cxnSpLocks/>
            </p:cNvCxnSpPr>
            <p:nvPr/>
          </p:nvCxnSpPr>
          <p:spPr>
            <a:xfrm rot="4980000">
              <a:off x="3173543" y="4715976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CF857C8F-8083-13AC-C1C3-95ED5D3B8BEF}"/>
                </a:ext>
              </a:extLst>
            </p:cNvPr>
            <p:cNvSpPr txBox="1"/>
            <p:nvPr/>
          </p:nvSpPr>
          <p:spPr>
            <a:xfrm>
              <a:off x="2857223" y="4798049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75FFA70D-02CF-11AD-527D-E97E4ECBD682}"/>
                </a:ext>
              </a:extLst>
            </p:cNvPr>
            <p:cNvSpPr txBox="1"/>
            <p:nvPr/>
          </p:nvSpPr>
          <p:spPr>
            <a:xfrm>
              <a:off x="2828068" y="4672130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s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7EDB7084-90EA-6070-6220-4336A3E023E1}"/>
                </a:ext>
              </a:extLst>
            </p:cNvPr>
            <p:cNvSpPr txBox="1"/>
            <p:nvPr/>
          </p:nvSpPr>
          <p:spPr>
            <a:xfrm>
              <a:off x="2712842" y="4488666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oc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3" name="Straight Connector 142">
              <a:extLst>
                <a:ext uri="{FF2B5EF4-FFF2-40B4-BE49-F238E27FC236}">
                  <a16:creationId xmlns:a16="http://schemas.microsoft.com/office/drawing/2014/main" id="{12216D0B-9E40-4BCC-F37B-5BBEE2A8FC14}"/>
                </a:ext>
              </a:extLst>
            </p:cNvPr>
            <p:cNvCxnSpPr>
              <a:cxnSpLocks/>
            </p:cNvCxnSpPr>
            <p:nvPr/>
          </p:nvCxnSpPr>
          <p:spPr>
            <a:xfrm rot="5520000">
              <a:off x="2999300" y="4289603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66FCFF53-65A7-D8B9-72D5-2993766F512B}"/>
                </a:ext>
              </a:extLst>
            </p:cNvPr>
            <p:cNvSpPr txBox="1"/>
            <p:nvPr/>
          </p:nvSpPr>
          <p:spPr>
            <a:xfrm>
              <a:off x="2670195" y="4241030"/>
              <a:ext cx="403208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ra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49BE89C0-15B2-7D55-7D12-1480E86800BB}"/>
                </a:ext>
              </a:extLst>
            </p:cNvPr>
            <p:cNvCxnSpPr>
              <a:cxnSpLocks/>
            </p:cNvCxnSpPr>
            <p:nvPr/>
          </p:nvCxnSpPr>
          <p:spPr>
            <a:xfrm rot="5580000">
              <a:off x="2925415" y="402508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429A15E5-1B32-2A44-EA24-3A963BC770D2}"/>
                </a:ext>
              </a:extLst>
            </p:cNvPr>
            <p:cNvSpPr txBox="1"/>
            <p:nvPr/>
          </p:nvSpPr>
          <p:spPr>
            <a:xfrm>
              <a:off x="2536329" y="3978162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m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8D5DBD85-1047-3DCD-7ECA-DAD036DA64EA}"/>
                </a:ext>
              </a:extLst>
            </p:cNvPr>
            <p:cNvCxnSpPr>
              <a:cxnSpLocks/>
            </p:cNvCxnSpPr>
            <p:nvPr/>
          </p:nvCxnSpPr>
          <p:spPr>
            <a:xfrm rot="6120000">
              <a:off x="2860579" y="355214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958AB0E-DCD8-4D36-DB90-158A086693E3}"/>
                </a:ext>
              </a:extLst>
            </p:cNvPr>
            <p:cNvSpPr txBox="1"/>
            <p:nvPr/>
          </p:nvSpPr>
          <p:spPr>
            <a:xfrm>
              <a:off x="2493171" y="3495752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deL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1681EF7E-6A4A-0F64-AB19-3565D0C5F94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28553" y="3173374"/>
              <a:ext cx="107263" cy="296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Connector 149">
              <a:extLst>
                <a:ext uri="{FF2B5EF4-FFF2-40B4-BE49-F238E27FC236}">
                  <a16:creationId xmlns:a16="http://schemas.microsoft.com/office/drawing/2014/main" id="{277141BD-E782-C7EE-B292-8F5A1B2E9853}"/>
                </a:ext>
              </a:extLst>
            </p:cNvPr>
            <p:cNvCxnSpPr>
              <a:cxnSpLocks/>
            </p:cNvCxnSpPr>
            <p:nvPr/>
          </p:nvCxnSpPr>
          <p:spPr>
            <a:xfrm rot="6840000">
              <a:off x="2845279" y="3288442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id="{506DF769-5E3E-A090-AE49-92134A40BB1A}"/>
                </a:ext>
              </a:extLst>
            </p:cNvPr>
            <p:cNvSpPr txBox="1"/>
            <p:nvPr/>
          </p:nvSpPr>
          <p:spPr>
            <a:xfrm>
              <a:off x="2476362" y="3322937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haR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TextBox 151">
              <a:extLst>
                <a:ext uri="{FF2B5EF4-FFF2-40B4-BE49-F238E27FC236}">
                  <a16:creationId xmlns:a16="http://schemas.microsoft.com/office/drawing/2014/main" id="{31ABEEDF-3CB1-2154-BB3E-AEF32F7277FC}"/>
                </a:ext>
              </a:extLst>
            </p:cNvPr>
            <p:cNvSpPr txBox="1"/>
            <p:nvPr/>
          </p:nvSpPr>
          <p:spPr>
            <a:xfrm>
              <a:off x="2544458" y="3207954"/>
              <a:ext cx="368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b</a:t>
              </a:r>
            </a:p>
          </p:txBody>
        </p: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D70E8CB8-C847-0676-6238-A3DEE1CEEFC1}"/>
                </a:ext>
              </a:extLst>
            </p:cNvPr>
            <p:cNvCxnSpPr>
              <a:cxnSpLocks/>
            </p:cNvCxnSpPr>
            <p:nvPr/>
          </p:nvCxnSpPr>
          <p:spPr>
            <a:xfrm rot="7140000">
              <a:off x="2866128" y="2991080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645AD226-5E26-CC4A-3A7C-0FED01F03E5F}"/>
                </a:ext>
              </a:extLst>
            </p:cNvPr>
            <p:cNvSpPr txBox="1"/>
            <p:nvPr/>
          </p:nvSpPr>
          <p:spPr>
            <a:xfrm>
              <a:off x="2418433" y="3105735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25</a:t>
              </a:r>
            </a:p>
          </p:txBody>
        </p: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FD9E5A55-ED84-6443-75BA-47D1D975F2D1}"/>
                </a:ext>
              </a:extLst>
            </p:cNvPr>
            <p:cNvSpPr txBox="1"/>
            <p:nvPr/>
          </p:nvSpPr>
          <p:spPr>
            <a:xfrm>
              <a:off x="2498169" y="2902109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p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id="{22665BCD-14B0-00C6-154D-51C33D9FE82B}"/>
                </a:ext>
              </a:extLst>
            </p:cNvPr>
            <p:cNvCxnSpPr>
              <a:cxnSpLocks/>
            </p:cNvCxnSpPr>
            <p:nvPr/>
          </p:nvCxnSpPr>
          <p:spPr>
            <a:xfrm rot="7140000">
              <a:off x="2891005" y="2802703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>
              <a:extLst>
                <a:ext uri="{FF2B5EF4-FFF2-40B4-BE49-F238E27FC236}">
                  <a16:creationId xmlns:a16="http://schemas.microsoft.com/office/drawing/2014/main" id="{9ECFB3D3-2F4C-3641-2F50-FFDADFC92353}"/>
                </a:ext>
              </a:extLst>
            </p:cNvPr>
            <p:cNvCxnSpPr>
              <a:cxnSpLocks/>
            </p:cNvCxnSpPr>
            <p:nvPr/>
          </p:nvCxnSpPr>
          <p:spPr>
            <a:xfrm rot="7140000">
              <a:off x="2935710" y="2577463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C9AC6F6A-0573-6DF4-B9C6-158773B998AD}"/>
                </a:ext>
              </a:extLst>
            </p:cNvPr>
            <p:cNvSpPr txBox="1"/>
            <p:nvPr/>
          </p:nvSpPr>
          <p:spPr>
            <a:xfrm>
              <a:off x="2519565" y="2730809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np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id="{3BF02C54-2236-4E13-DF44-2A73F0EEE72E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2977620" y="2449828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>
              <a:extLst>
                <a:ext uri="{FF2B5EF4-FFF2-40B4-BE49-F238E27FC236}">
                  <a16:creationId xmlns:a16="http://schemas.microsoft.com/office/drawing/2014/main" id="{BFB4056E-1917-D0C8-56ED-CB272543651D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037368" y="225576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8A9847C1-EB8B-B5FF-C4FC-F0FB7DFFC4B3}"/>
                </a:ext>
              </a:extLst>
            </p:cNvPr>
            <p:cNvSpPr txBox="1"/>
            <p:nvPr/>
          </p:nvSpPr>
          <p:spPr>
            <a:xfrm>
              <a:off x="2546685" y="2491758"/>
              <a:ext cx="464923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ud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48D2E1B1-6C94-373A-90E5-BFCE94B0E8F7}"/>
                </a:ext>
              </a:extLst>
            </p:cNvPr>
            <p:cNvSpPr txBox="1"/>
            <p:nvPr/>
          </p:nvSpPr>
          <p:spPr>
            <a:xfrm>
              <a:off x="2638390" y="2363144"/>
              <a:ext cx="403208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xe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3" name="Straight Connector 162">
              <a:extLst>
                <a:ext uri="{FF2B5EF4-FFF2-40B4-BE49-F238E27FC236}">
                  <a16:creationId xmlns:a16="http://schemas.microsoft.com/office/drawing/2014/main" id="{067C595F-34C3-6884-412B-C478DF518D0D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284495" y="1768937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AEB7CC7F-58A6-48F7-4024-7DC14D617EB4}"/>
                </a:ext>
              </a:extLst>
            </p:cNvPr>
            <p:cNvSpPr txBox="1"/>
            <p:nvPr/>
          </p:nvSpPr>
          <p:spPr>
            <a:xfrm>
              <a:off x="2623017" y="2161214"/>
              <a:ext cx="478638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ae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id="{BC6A31AA-D3E6-5F55-7D7C-4C3BD2F79840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116685" y="2047873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Connector 165">
              <a:extLst>
                <a:ext uri="{FF2B5EF4-FFF2-40B4-BE49-F238E27FC236}">
                  <a16:creationId xmlns:a16="http://schemas.microsoft.com/office/drawing/2014/main" id="{94943F83-7329-0B04-E5FC-7D9ACA8C1AE6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357960" y="1644544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167EC382-56A4-2359-EDDA-990959934D75}"/>
                </a:ext>
              </a:extLst>
            </p:cNvPr>
            <p:cNvCxnSpPr>
              <a:cxnSpLocks/>
            </p:cNvCxnSpPr>
            <p:nvPr/>
          </p:nvCxnSpPr>
          <p:spPr>
            <a:xfrm rot="8820000">
              <a:off x="3672271" y="1248297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4527D168-7756-D2F7-1C67-81C00A1F8E14}"/>
                </a:ext>
              </a:extLst>
            </p:cNvPr>
            <p:cNvSpPr txBox="1"/>
            <p:nvPr/>
          </p:nvSpPr>
          <p:spPr>
            <a:xfrm>
              <a:off x="2791980" y="1959284"/>
              <a:ext cx="396351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tdT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BCACDA18-12B2-C6B4-B5BB-BD3C6F3D587D}"/>
                </a:ext>
              </a:extLst>
            </p:cNvPr>
            <p:cNvSpPr txBox="1"/>
            <p:nvPr/>
          </p:nvSpPr>
          <p:spPr>
            <a:xfrm>
              <a:off x="2960202" y="1688774"/>
              <a:ext cx="389493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t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0EDBD195-0B7C-E4D1-1345-F15A4109D890}"/>
                </a:ext>
              </a:extLst>
            </p:cNvPr>
            <p:cNvSpPr txBox="1"/>
            <p:nvPr/>
          </p:nvSpPr>
          <p:spPr>
            <a:xfrm>
              <a:off x="2880668" y="1546145"/>
              <a:ext cx="560926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Ppu7</a:t>
              </a:r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FDB9504D-380D-678F-A081-8F77653B384C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905853" y="1032451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08666BFE-9A0B-5A81-5BE1-3C647E491CED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3987285" y="97337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27B524C0-37B4-DC27-AEA2-B10CD699A37D}"/>
                </a:ext>
              </a:extLst>
            </p:cNvPr>
            <p:cNvSpPr txBox="1"/>
            <p:nvPr/>
          </p:nvSpPr>
          <p:spPr>
            <a:xfrm>
              <a:off x="3350212" y="1122672"/>
              <a:ext cx="389493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m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id="{FE6720A7-08C3-C4C3-61D2-0343C675F56E}"/>
                </a:ext>
              </a:extLst>
            </p:cNvPr>
            <p:cNvSpPr txBox="1"/>
            <p:nvPr/>
          </p:nvSpPr>
          <p:spPr>
            <a:xfrm>
              <a:off x="3599767" y="950640"/>
              <a:ext cx="365493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I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id="{75E7AAF2-9A68-100D-7833-861E0015CC79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4082882" y="898501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32D57E5E-6AA7-5F85-4065-A8DE9E13297B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4365002" y="711569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id="{D68ACBA5-8DF8-728B-67ED-8443A061A3B9}"/>
                </a:ext>
              </a:extLst>
            </p:cNvPr>
            <p:cNvSpPr txBox="1"/>
            <p:nvPr/>
          </p:nvSpPr>
          <p:spPr>
            <a:xfrm>
              <a:off x="3651202" y="87444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H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TextBox 177">
              <a:extLst>
                <a:ext uri="{FF2B5EF4-FFF2-40B4-BE49-F238E27FC236}">
                  <a16:creationId xmlns:a16="http://schemas.microsoft.com/office/drawing/2014/main" id="{192B39EA-8132-C2E8-E520-84067E9A549F}"/>
                </a:ext>
              </a:extLst>
            </p:cNvPr>
            <p:cNvSpPr txBox="1"/>
            <p:nvPr/>
          </p:nvSpPr>
          <p:spPr>
            <a:xfrm>
              <a:off x="3740737" y="79824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G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9" name="Straight Connector 178">
              <a:extLst>
                <a:ext uri="{FF2B5EF4-FFF2-40B4-BE49-F238E27FC236}">
                  <a16:creationId xmlns:a16="http://schemas.microsoft.com/office/drawing/2014/main" id="{4A4713D7-B5AD-D065-940C-12118DB1D4A8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4277164" y="776080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07A0B414-4C40-8270-238B-2C763C55B99B}"/>
                </a:ext>
              </a:extLst>
            </p:cNvPr>
            <p:cNvSpPr txBox="1"/>
            <p:nvPr/>
          </p:nvSpPr>
          <p:spPr>
            <a:xfrm>
              <a:off x="3935047" y="702990"/>
              <a:ext cx="398066" cy="230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F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TextBox 181">
              <a:extLst>
                <a:ext uri="{FF2B5EF4-FFF2-40B4-BE49-F238E27FC236}">
                  <a16:creationId xmlns:a16="http://schemas.microsoft.com/office/drawing/2014/main" id="{EA0B0BF8-D436-6DA8-E770-7CE84EB01429}"/>
                </a:ext>
              </a:extLst>
            </p:cNvPr>
            <p:cNvSpPr txBox="1"/>
            <p:nvPr/>
          </p:nvSpPr>
          <p:spPr>
            <a:xfrm>
              <a:off x="4034107" y="624885"/>
              <a:ext cx="39626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E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id="{30F04CD3-BD20-1CB8-0F4F-DF18F703E402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4518765" y="640078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98E5A542-3476-B7C6-F99A-70C917F8F143}"/>
                </a:ext>
              </a:extLst>
            </p:cNvPr>
            <p:cNvSpPr txBox="1"/>
            <p:nvPr/>
          </p:nvSpPr>
          <p:spPr>
            <a:xfrm>
              <a:off x="4168832" y="54297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D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8A6FA7CD-934D-ABC4-90A3-05E0791375E4}"/>
                </a:ext>
              </a:extLst>
            </p:cNvPr>
            <p:cNvCxnSpPr>
              <a:cxnSpLocks/>
            </p:cNvCxnSpPr>
            <p:nvPr/>
          </p:nvCxnSpPr>
          <p:spPr>
            <a:xfrm rot="7860000">
              <a:off x="4711483" y="541738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id="{188C3866-6A19-1337-A429-BA393182845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788365" y="504649"/>
              <a:ext cx="95460" cy="618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F8EC69F6-A5A2-EF47-B0A5-1FE28171C78B}"/>
                </a:ext>
              </a:extLst>
            </p:cNvPr>
            <p:cNvSpPr txBox="1"/>
            <p:nvPr/>
          </p:nvSpPr>
          <p:spPr>
            <a:xfrm>
              <a:off x="4347109" y="439835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51788AEE-CF86-4CDF-9802-BCEE32DFFF3E}"/>
                </a:ext>
              </a:extLst>
            </p:cNvPr>
            <p:cNvSpPr txBox="1"/>
            <p:nvPr/>
          </p:nvSpPr>
          <p:spPr>
            <a:xfrm>
              <a:off x="4403677" y="310216"/>
              <a:ext cx="54035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S71A</a:t>
              </a:r>
            </a:p>
          </p:txBody>
        </p:sp>
        <p:cxnSp>
          <p:nvCxnSpPr>
            <p:cNvPr id="190" name="Straight Connector 189">
              <a:extLst>
                <a:ext uri="{FF2B5EF4-FFF2-40B4-BE49-F238E27FC236}">
                  <a16:creationId xmlns:a16="http://schemas.microsoft.com/office/drawing/2014/main" id="{50DA42EA-885F-B133-1E30-929056A7F0E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232415" y="421005"/>
              <a:ext cx="99022" cy="1941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8C49A4A6-362F-847C-01B3-62489AB64AD6}"/>
                </a:ext>
              </a:extLst>
            </p:cNvPr>
            <p:cNvSpPr txBox="1"/>
            <p:nvPr/>
          </p:nvSpPr>
          <p:spPr>
            <a:xfrm>
              <a:off x="4847542" y="287700"/>
              <a:ext cx="49921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pA1</a:t>
              </a:r>
            </a:p>
          </p:txBody>
        </p: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3F9658F9-E056-F20A-6431-8B065A3980B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07747" y="213483"/>
              <a:ext cx="44159" cy="20752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A353E4B5-5551-888A-D16A-9EA198502500}"/>
                </a:ext>
              </a:extLst>
            </p:cNvPr>
            <p:cNvCxnSpPr>
              <a:cxnSpLocks/>
            </p:cNvCxnSpPr>
            <p:nvPr/>
          </p:nvCxnSpPr>
          <p:spPr>
            <a:xfrm rot="540000" flipH="1" flipV="1">
              <a:off x="5265198" y="256212"/>
              <a:ext cx="118872" cy="15544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9" name="TextBox 198">
              <a:extLst>
                <a:ext uri="{FF2B5EF4-FFF2-40B4-BE49-F238E27FC236}">
                  <a16:creationId xmlns:a16="http://schemas.microsoft.com/office/drawing/2014/main" id="{1C8E1F4F-1A6A-2A68-3FEA-4D2B11866EB5}"/>
                </a:ext>
              </a:extLst>
            </p:cNvPr>
            <p:cNvSpPr txBox="1"/>
            <p:nvPr/>
          </p:nvSpPr>
          <p:spPr>
            <a:xfrm>
              <a:off x="4999942" y="83865"/>
              <a:ext cx="45120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p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3" name="Straight Connector 202">
              <a:extLst>
                <a:ext uri="{FF2B5EF4-FFF2-40B4-BE49-F238E27FC236}">
                  <a16:creationId xmlns:a16="http://schemas.microsoft.com/office/drawing/2014/main" id="{2959FCF6-F098-97E5-6791-8093A21646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609359" y="128795"/>
              <a:ext cx="28665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18C9393B-B5C4-A30F-3F68-95D39EE09F4B}"/>
                </a:ext>
              </a:extLst>
            </p:cNvPr>
            <p:cNvSpPr txBox="1"/>
            <p:nvPr/>
          </p:nvSpPr>
          <p:spPr>
            <a:xfrm>
              <a:off x="5234257" y="34335"/>
              <a:ext cx="45120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p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7" name="Straight Connector 206">
              <a:extLst>
                <a:ext uri="{FF2B5EF4-FFF2-40B4-BE49-F238E27FC236}">
                  <a16:creationId xmlns:a16="http://schemas.microsoft.com/office/drawing/2014/main" id="{4F78B3E3-BD8B-0243-28A6-E398B1A7817B}"/>
                </a:ext>
              </a:extLst>
            </p:cNvPr>
            <p:cNvCxnSpPr>
              <a:cxnSpLocks/>
            </p:cNvCxnSpPr>
            <p:nvPr/>
          </p:nvCxnSpPr>
          <p:spPr>
            <a:xfrm rot="12840000">
              <a:off x="5724750" y="278565"/>
              <a:ext cx="42122" cy="99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>
              <a:extLst>
                <a:ext uri="{FF2B5EF4-FFF2-40B4-BE49-F238E27FC236}">
                  <a16:creationId xmlns:a16="http://schemas.microsoft.com/office/drawing/2014/main" id="{A19AC2DD-675E-DCFC-84C8-68CF9D7FD305}"/>
                </a:ext>
              </a:extLst>
            </p:cNvPr>
            <p:cNvCxnSpPr>
              <a:cxnSpLocks/>
            </p:cNvCxnSpPr>
            <p:nvPr/>
          </p:nvCxnSpPr>
          <p:spPr>
            <a:xfrm rot="14340000">
              <a:off x="5873838" y="230606"/>
              <a:ext cx="42122" cy="16459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>
              <a:extLst>
                <a:ext uri="{FF2B5EF4-FFF2-40B4-BE49-F238E27FC236}">
                  <a16:creationId xmlns:a16="http://schemas.microsoft.com/office/drawing/2014/main" id="{9E741B72-3B17-E461-A144-653EB2B6021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28470" y="282414"/>
              <a:ext cx="198464" cy="8588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D18FC17A-DC54-3BDE-79FA-316D88369B11}"/>
                </a:ext>
              </a:extLst>
            </p:cNvPr>
            <p:cNvSpPr txBox="1"/>
            <p:nvPr/>
          </p:nvSpPr>
          <p:spPr>
            <a:xfrm>
              <a:off x="5468572" y="-34245"/>
              <a:ext cx="61578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-pc02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5EE0C1DC-493E-2E8F-3137-5D4BDB147CE7}"/>
                </a:ext>
              </a:extLst>
            </p:cNvPr>
            <p:cNvSpPr txBox="1"/>
            <p:nvPr/>
          </p:nvSpPr>
          <p:spPr>
            <a:xfrm>
              <a:off x="5575252" y="108630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inO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77331C23-1284-9223-41A9-F7C3CDCC312A}"/>
                </a:ext>
              </a:extLst>
            </p:cNvPr>
            <p:cNvSpPr txBox="1"/>
            <p:nvPr/>
          </p:nvSpPr>
          <p:spPr>
            <a:xfrm>
              <a:off x="5801947" y="76245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X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471C99FE-6FF3-F16D-76DF-6447904CBF12}"/>
                </a:ext>
              </a:extLst>
            </p:cNvPr>
            <p:cNvSpPr txBox="1"/>
            <p:nvPr/>
          </p:nvSpPr>
          <p:spPr>
            <a:xfrm>
              <a:off x="6032452" y="148635"/>
              <a:ext cx="382636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2787F67E-5AF0-E362-6F67-2849E2DBB4DE}"/>
                </a:ext>
              </a:extLst>
            </p:cNvPr>
            <p:cNvSpPr txBox="1"/>
            <p:nvPr/>
          </p:nvSpPr>
          <p:spPr>
            <a:xfrm>
              <a:off x="6917055" y="293930"/>
              <a:ext cx="410065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T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1A70C5E3-B2B7-5036-2343-9E72E416090F}"/>
                </a:ext>
              </a:extLst>
            </p:cNvPr>
            <p:cNvSpPr txBox="1"/>
            <p:nvPr/>
          </p:nvSpPr>
          <p:spPr>
            <a:xfrm>
              <a:off x="7242810" y="419660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G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6E455D8C-73A5-BB97-46B6-F88CEB58F71D}"/>
                </a:ext>
              </a:extLst>
            </p:cNvPr>
            <p:cNvSpPr txBox="1"/>
            <p:nvPr/>
          </p:nvSpPr>
          <p:spPr>
            <a:xfrm>
              <a:off x="7774305" y="775895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F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4834A02D-3AC3-5F88-1B38-9C1CB25306AA}"/>
                </a:ext>
              </a:extLst>
            </p:cNvPr>
            <p:cNvSpPr txBox="1"/>
            <p:nvPr/>
          </p:nvSpPr>
          <p:spPr>
            <a:xfrm>
              <a:off x="7962900" y="903530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58BC7E2B-4AF9-285A-6156-0F99E9D484E5}"/>
                </a:ext>
              </a:extLst>
            </p:cNvPr>
            <p:cNvSpPr txBox="1"/>
            <p:nvPr/>
          </p:nvSpPr>
          <p:spPr>
            <a:xfrm>
              <a:off x="8056245" y="1002590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b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E0200AA8-6491-4C8E-B667-8B24AB5A0485}"/>
                </a:ext>
              </a:extLst>
            </p:cNvPr>
            <p:cNvSpPr txBox="1"/>
            <p:nvPr/>
          </p:nvSpPr>
          <p:spPr>
            <a:xfrm>
              <a:off x="8302520" y="1257179"/>
              <a:ext cx="430637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U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EE6CA7E3-839B-A327-8821-F5366972726E}"/>
                </a:ext>
              </a:extLst>
            </p:cNvPr>
            <p:cNvSpPr txBox="1"/>
            <p:nvPr/>
          </p:nvSpPr>
          <p:spPr>
            <a:xfrm>
              <a:off x="8396342" y="1395612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W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E5DC2039-DDA1-2FEC-7BFD-9EBCBC77149B}"/>
                </a:ext>
              </a:extLst>
            </p:cNvPr>
            <p:cNvSpPr txBox="1"/>
            <p:nvPr/>
          </p:nvSpPr>
          <p:spPr>
            <a:xfrm>
              <a:off x="8555885" y="1632465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ACE489B3-955F-AFAD-838A-2B14CD748418}"/>
                </a:ext>
              </a:extLst>
            </p:cNvPr>
            <p:cNvSpPr txBox="1"/>
            <p:nvPr/>
          </p:nvSpPr>
          <p:spPr>
            <a:xfrm>
              <a:off x="8766914" y="2064456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K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A0B423C1-DA95-B08B-37BE-D68FD1AD266D}"/>
                </a:ext>
              </a:extLst>
            </p:cNvPr>
            <p:cNvSpPr txBox="1"/>
            <p:nvPr/>
          </p:nvSpPr>
          <p:spPr>
            <a:xfrm>
              <a:off x="9026868" y="3059851"/>
              <a:ext cx="36206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ok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FCCBB069-7C3D-742B-B0E2-44A9B6EF6623}"/>
                </a:ext>
              </a:extLst>
            </p:cNvPr>
            <p:cNvSpPr txBox="1"/>
            <p:nvPr/>
          </p:nvSpPr>
          <p:spPr>
            <a:xfrm>
              <a:off x="9011629" y="3191296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i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59FB52FC-AC76-7E67-C67F-49342B988119}"/>
                </a:ext>
              </a:extLst>
            </p:cNvPr>
            <p:cNvSpPr txBox="1"/>
            <p:nvPr/>
          </p:nvSpPr>
          <p:spPr>
            <a:xfrm>
              <a:off x="9011629" y="3343695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4E43D4BA-D284-A925-5945-308A94BF9A7C}"/>
                </a:ext>
              </a:extLst>
            </p:cNvPr>
            <p:cNvSpPr txBox="1"/>
            <p:nvPr/>
          </p:nvSpPr>
          <p:spPr>
            <a:xfrm>
              <a:off x="9005914" y="3515147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ubL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82CBD37B-9568-9F9A-CA0A-BE79DEFD181E}"/>
                </a:ext>
              </a:extLst>
            </p:cNvPr>
            <p:cNvSpPr txBox="1"/>
            <p:nvPr/>
          </p:nvSpPr>
          <p:spPr>
            <a:xfrm>
              <a:off x="8937875" y="3906600"/>
              <a:ext cx="61578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S-pc01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98256FD1-3016-7EB5-B9F8-0CBCAF6BD6D4}"/>
                </a:ext>
              </a:extLst>
            </p:cNvPr>
            <p:cNvSpPr txBox="1"/>
            <p:nvPr/>
          </p:nvSpPr>
          <p:spPr>
            <a:xfrm>
              <a:off x="8854055" y="4304745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lc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C58F26D7-27BF-952E-326F-1B7FDF287334}"/>
                </a:ext>
              </a:extLst>
            </p:cNvPr>
            <p:cNvSpPr txBox="1"/>
            <p:nvPr/>
          </p:nvSpPr>
          <p:spPr>
            <a:xfrm>
              <a:off x="8727653" y="4591051"/>
              <a:ext cx="464923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ub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86639745-3549-1C7A-857A-A826DCB1BDE9}"/>
                </a:ext>
              </a:extLst>
            </p:cNvPr>
            <p:cNvSpPr txBox="1"/>
            <p:nvPr/>
          </p:nvSpPr>
          <p:spPr>
            <a:xfrm>
              <a:off x="8649262" y="4728213"/>
              <a:ext cx="49921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13479DDA-7A28-8B27-D919-E95FF1D73A35}"/>
                </a:ext>
              </a:extLst>
            </p:cNvPr>
            <p:cNvSpPr txBox="1"/>
            <p:nvPr/>
          </p:nvSpPr>
          <p:spPr>
            <a:xfrm>
              <a:off x="8656882" y="4825368"/>
              <a:ext cx="55406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muC1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7F758B35-24B0-0C9E-8F98-684860A359FA}"/>
                </a:ext>
              </a:extLst>
            </p:cNvPr>
            <p:cNvSpPr txBox="1"/>
            <p:nvPr/>
          </p:nvSpPr>
          <p:spPr>
            <a:xfrm>
              <a:off x="8554094" y="4928842"/>
              <a:ext cx="485495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629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id="{4C319017-AD77-EB93-5330-D64F500C2353}"/>
                </a:ext>
              </a:extLst>
            </p:cNvPr>
            <p:cNvSpPr txBox="1"/>
            <p:nvPr/>
          </p:nvSpPr>
          <p:spPr>
            <a:xfrm>
              <a:off x="8487093" y="5042976"/>
              <a:ext cx="42378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sK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id="{1BCDBE69-9DE8-DFAD-8D5B-71645785B4C4}"/>
                </a:ext>
              </a:extLst>
            </p:cNvPr>
            <p:cNvSpPr txBox="1"/>
            <p:nvPr/>
          </p:nvSpPr>
          <p:spPr>
            <a:xfrm>
              <a:off x="8233778" y="5346288"/>
              <a:ext cx="554069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muC2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E0F461E2-12EC-D6E5-5D72-C15415C43A1E}"/>
                </a:ext>
              </a:extLst>
            </p:cNvPr>
            <p:cNvSpPr txBox="1"/>
            <p:nvPr/>
          </p:nvSpPr>
          <p:spPr>
            <a:xfrm>
              <a:off x="8098523" y="5504403"/>
              <a:ext cx="410065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id="{B612E2CA-0FBE-3211-C75B-BA9BB5B75E8D}"/>
                </a:ext>
              </a:extLst>
            </p:cNvPr>
            <p:cNvSpPr txBox="1"/>
            <p:nvPr/>
          </p:nvSpPr>
          <p:spPr>
            <a:xfrm>
              <a:off x="7999463" y="5593938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id="{065320C5-FDCD-2C34-B2C9-634014EB74DD}"/>
                </a:ext>
              </a:extLst>
            </p:cNvPr>
            <p:cNvSpPr txBox="1"/>
            <p:nvPr/>
          </p:nvSpPr>
          <p:spPr>
            <a:xfrm>
              <a:off x="7724006" y="5818731"/>
              <a:ext cx="499210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erC1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DA578B91-192E-B12C-4803-3F99109D44D7}"/>
                </a:ext>
              </a:extLst>
            </p:cNvPr>
            <p:cNvSpPr txBox="1"/>
            <p:nvPr/>
          </p:nvSpPr>
          <p:spPr>
            <a:xfrm>
              <a:off x="7738903" y="5930709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cd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728213DD-E0DC-9025-07A2-81429B9C9839}"/>
                </a:ext>
              </a:extLst>
            </p:cNvPr>
            <p:cNvSpPr txBox="1"/>
            <p:nvPr/>
          </p:nvSpPr>
          <p:spPr>
            <a:xfrm>
              <a:off x="7314009" y="6132461"/>
              <a:ext cx="44435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de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71311269-3EDA-E8A5-927E-259B92DFEA11}"/>
                </a:ext>
              </a:extLst>
            </p:cNvPr>
            <p:cNvSpPr txBox="1"/>
            <p:nvPr/>
          </p:nvSpPr>
          <p:spPr>
            <a:xfrm>
              <a:off x="7007483" y="6202280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f1A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D5C32919-C62E-1B79-8C56-549B0B38B4CA}"/>
                </a:ext>
              </a:extLst>
            </p:cNvPr>
            <p:cNvSpPr txBox="1"/>
            <p:nvPr/>
          </p:nvSpPr>
          <p:spPr>
            <a:xfrm>
              <a:off x="6801061" y="6288145"/>
              <a:ext cx="512924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af1M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92246806-D2EB-461A-32B4-E07E0CA519E0}"/>
                </a:ext>
              </a:extLst>
            </p:cNvPr>
            <p:cNvSpPr txBox="1"/>
            <p:nvPr/>
          </p:nvSpPr>
          <p:spPr>
            <a:xfrm>
              <a:off x="4929444" y="3040859"/>
              <a:ext cx="1788381" cy="9874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15-1</a:t>
              </a:r>
            </a:p>
            <a:p>
              <a:pPr algn="ctr"/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FIB</a:t>
              </a:r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FII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44,323 bp</a:t>
              </a:r>
            </a:p>
          </p:txBody>
        </p:sp>
        <p:cxnSp>
          <p:nvCxnSpPr>
            <p:cNvPr id="267" name="Straight Connector 266">
              <a:extLst>
                <a:ext uri="{FF2B5EF4-FFF2-40B4-BE49-F238E27FC236}">
                  <a16:creationId xmlns:a16="http://schemas.microsoft.com/office/drawing/2014/main" id="{48ABFDBD-2898-B5F2-93C9-7EBEC9E3CB0F}"/>
                </a:ext>
              </a:extLst>
            </p:cNvPr>
            <p:cNvCxnSpPr>
              <a:cxnSpLocks/>
            </p:cNvCxnSpPr>
            <p:nvPr/>
          </p:nvCxnSpPr>
          <p:spPr>
            <a:xfrm>
              <a:off x="8781638" y="2333065"/>
              <a:ext cx="121132" cy="1043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495F5E71-9D73-BCC2-5A81-6B17EB47AA74}"/>
                </a:ext>
              </a:extLst>
            </p:cNvPr>
            <p:cNvSpPr txBox="1"/>
            <p:nvPr/>
          </p:nvSpPr>
          <p:spPr>
            <a:xfrm>
              <a:off x="8822148" y="2222779"/>
              <a:ext cx="416922" cy="2468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E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0" name="Straight Connector 269">
              <a:extLst>
                <a:ext uri="{FF2B5EF4-FFF2-40B4-BE49-F238E27FC236}">
                  <a16:creationId xmlns:a16="http://schemas.microsoft.com/office/drawing/2014/main" id="{156C2A49-CEB0-52E0-65B9-5C2913E23BB2}"/>
                </a:ext>
              </a:extLst>
            </p:cNvPr>
            <p:cNvCxnSpPr>
              <a:cxnSpLocks/>
              <a:endCxn id="154" idx="0"/>
            </p:cNvCxnSpPr>
            <p:nvPr/>
          </p:nvCxnSpPr>
          <p:spPr>
            <a:xfrm flipH="1">
              <a:off x="2680685" y="3095180"/>
              <a:ext cx="237930" cy="1055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119BA0CE-1971-F4F9-DFB1-E797E9A0E501}"/>
                </a:ext>
              </a:extLst>
            </p:cNvPr>
            <p:cNvSpPr txBox="1"/>
            <p:nvPr/>
          </p:nvSpPr>
          <p:spPr>
            <a:xfrm>
              <a:off x="2351552" y="2999298"/>
              <a:ext cx="42832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ga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86853B7-5E02-585F-E4A0-26AB0D91A759}"/>
              </a:ext>
            </a:extLst>
          </p:cNvPr>
          <p:cNvSpPr txBox="1"/>
          <p:nvPr/>
        </p:nvSpPr>
        <p:spPr>
          <a:xfrm>
            <a:off x="-269" y="0"/>
            <a:ext cx="731964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visualization of plasmid pEC15-1.</a:t>
            </a:r>
            <a:endParaRPr lang="en-US" sz="4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04609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9" name="Group 168">
            <a:extLst>
              <a:ext uri="{FF2B5EF4-FFF2-40B4-BE49-F238E27FC236}">
                <a16:creationId xmlns:a16="http://schemas.microsoft.com/office/drawing/2014/main" id="{934E40AF-3064-B839-D580-24CB9477A3EF}"/>
              </a:ext>
            </a:extLst>
          </p:cNvPr>
          <p:cNvGrpSpPr>
            <a:grpSpLocks noChangeAspect="1"/>
          </p:cNvGrpSpPr>
          <p:nvPr/>
        </p:nvGrpSpPr>
        <p:grpSpPr>
          <a:xfrm>
            <a:off x="2295408" y="372510"/>
            <a:ext cx="7186596" cy="6413192"/>
            <a:chOff x="2207079" y="-239959"/>
            <a:chExt cx="8169841" cy="729062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B95E0A7-C783-2256-4300-A558AC05ACA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39523" y="0"/>
              <a:ext cx="7312953" cy="6858000"/>
            </a:xfrm>
            <a:prstGeom prst="rect">
              <a:avLst/>
            </a:prstGeom>
          </p:spPr>
        </p:pic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7A493F94-D7CF-812C-C1F4-B62952A715E7}"/>
                </a:ext>
              </a:extLst>
            </p:cNvPr>
            <p:cNvCxnSpPr>
              <a:cxnSpLocks/>
            </p:cNvCxnSpPr>
            <p:nvPr/>
          </p:nvCxnSpPr>
          <p:spPr>
            <a:xfrm rot="1740000" flipV="1">
              <a:off x="7976819" y="422323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1583BFD2-45A3-CD47-F0CE-7F307C46C234}"/>
                </a:ext>
              </a:extLst>
            </p:cNvPr>
            <p:cNvCxnSpPr>
              <a:cxnSpLocks/>
            </p:cNvCxnSpPr>
            <p:nvPr/>
          </p:nvCxnSpPr>
          <p:spPr>
            <a:xfrm rot="1920000" flipV="1">
              <a:off x="8145983" y="531553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775E3E69-C9C1-C7C8-60F5-5DCB19F2518C}"/>
                </a:ext>
              </a:extLst>
            </p:cNvPr>
            <p:cNvCxnSpPr>
              <a:cxnSpLocks/>
            </p:cNvCxnSpPr>
            <p:nvPr/>
          </p:nvCxnSpPr>
          <p:spPr>
            <a:xfrm rot="2400000" flipV="1">
              <a:off x="8792078" y="1119124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389A7C-F043-675F-BF5B-547801C4F3CF}"/>
                </a:ext>
              </a:extLst>
            </p:cNvPr>
            <p:cNvSpPr txBox="1"/>
            <p:nvPr/>
          </p:nvSpPr>
          <p:spPr>
            <a:xfrm>
              <a:off x="7902159" y="256179"/>
              <a:ext cx="443188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gr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D7EC382-C811-B62C-880B-A939F930EA8C}"/>
                </a:ext>
              </a:extLst>
            </p:cNvPr>
            <p:cNvSpPr txBox="1"/>
            <p:nvPr/>
          </p:nvSpPr>
          <p:spPr>
            <a:xfrm>
              <a:off x="8044807" y="374553"/>
              <a:ext cx="474168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mo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E7FAFE80-594B-184C-BB07-EA28A30AA7C2}"/>
                </a:ext>
              </a:extLst>
            </p:cNvPr>
            <p:cNvCxnSpPr>
              <a:cxnSpLocks/>
            </p:cNvCxnSpPr>
            <p:nvPr/>
          </p:nvCxnSpPr>
          <p:spPr>
            <a:xfrm rot="2880000" flipV="1">
              <a:off x="8247938" y="608123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1A4FB40-A7F4-71EC-3C97-07F3589569DA}"/>
                </a:ext>
              </a:extLst>
            </p:cNvPr>
            <p:cNvSpPr txBox="1"/>
            <p:nvPr/>
          </p:nvSpPr>
          <p:spPr>
            <a:xfrm>
              <a:off x="8209537" y="487909"/>
              <a:ext cx="42314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utE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70458646-A652-7912-079B-19233FE5F7F9}"/>
                </a:ext>
              </a:extLst>
            </p:cNvPr>
            <p:cNvCxnSpPr>
              <a:cxnSpLocks/>
            </p:cNvCxnSpPr>
            <p:nvPr/>
          </p:nvCxnSpPr>
          <p:spPr>
            <a:xfrm rot="2220000" flipV="1">
              <a:off x="8464999" y="785939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460533D-75E0-0B8F-DFE6-34944DFEB2B8}"/>
                </a:ext>
              </a:extLst>
            </p:cNvPr>
            <p:cNvSpPr txBox="1"/>
            <p:nvPr/>
          </p:nvSpPr>
          <p:spPr>
            <a:xfrm>
              <a:off x="8392758" y="632089"/>
              <a:ext cx="41585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Y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0D73B462-0084-6497-E94B-D7DA2A1FC0F0}"/>
                </a:ext>
              </a:extLst>
            </p:cNvPr>
            <p:cNvCxnSpPr>
              <a:cxnSpLocks/>
            </p:cNvCxnSpPr>
            <p:nvPr/>
          </p:nvCxnSpPr>
          <p:spPr>
            <a:xfrm rot="2220000" flipV="1">
              <a:off x="8664487" y="982790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22B1C3E-73A2-5504-FBAD-7E450F49CBA8}"/>
                </a:ext>
              </a:extLst>
            </p:cNvPr>
            <p:cNvSpPr txBox="1"/>
            <p:nvPr/>
          </p:nvSpPr>
          <p:spPr>
            <a:xfrm>
              <a:off x="8561596" y="831750"/>
              <a:ext cx="41585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X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2B321B3-854E-8494-2F18-B857517AB315}"/>
                </a:ext>
              </a:extLst>
            </p:cNvPr>
            <p:cNvSpPr txBox="1"/>
            <p:nvPr/>
          </p:nvSpPr>
          <p:spPr>
            <a:xfrm>
              <a:off x="8740709" y="973875"/>
              <a:ext cx="441367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W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E912CC5-8644-5AB7-0DEF-DD46931061BA}"/>
                </a:ext>
              </a:extLst>
            </p:cNvPr>
            <p:cNvCxnSpPr>
              <a:cxnSpLocks/>
            </p:cNvCxnSpPr>
            <p:nvPr/>
          </p:nvCxnSpPr>
          <p:spPr>
            <a:xfrm rot="2640000" flipV="1">
              <a:off x="8905290" y="1260835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CBCD9C0-11B5-F49A-E62F-0C81F866C068}"/>
                </a:ext>
              </a:extLst>
            </p:cNvPr>
            <p:cNvSpPr txBox="1"/>
            <p:nvPr/>
          </p:nvSpPr>
          <p:spPr>
            <a:xfrm>
              <a:off x="8849958" y="1116000"/>
              <a:ext cx="41585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V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149A357A-F914-E82B-A4AF-367EFB9033A1}"/>
                </a:ext>
              </a:extLst>
            </p:cNvPr>
            <p:cNvCxnSpPr>
              <a:cxnSpLocks/>
            </p:cNvCxnSpPr>
            <p:nvPr/>
          </p:nvCxnSpPr>
          <p:spPr>
            <a:xfrm rot="3120000" flipV="1">
              <a:off x="9123577" y="1574357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39EAFD1-1661-E647-A18C-F7C12E380B37}"/>
                </a:ext>
              </a:extLst>
            </p:cNvPr>
            <p:cNvSpPr txBox="1"/>
            <p:nvPr/>
          </p:nvSpPr>
          <p:spPr>
            <a:xfrm>
              <a:off x="9050745" y="1430656"/>
              <a:ext cx="430433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U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28584C21-896D-B63B-3546-C8831903DD8A}"/>
                </a:ext>
              </a:extLst>
            </p:cNvPr>
            <p:cNvCxnSpPr>
              <a:cxnSpLocks/>
            </p:cNvCxnSpPr>
            <p:nvPr/>
          </p:nvCxnSpPr>
          <p:spPr>
            <a:xfrm rot="3360000" flipV="1">
              <a:off x="9306470" y="1917510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C698E5A-9550-7069-048E-0C3430CA6126}"/>
                </a:ext>
              </a:extLst>
            </p:cNvPr>
            <p:cNvSpPr txBox="1"/>
            <p:nvPr/>
          </p:nvSpPr>
          <p:spPr>
            <a:xfrm>
              <a:off x="9232088" y="1770046"/>
              <a:ext cx="41221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T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0D9A97EF-FC67-0078-000E-B92533BE53FE}"/>
                </a:ext>
              </a:extLst>
            </p:cNvPr>
            <p:cNvCxnSpPr>
              <a:cxnSpLocks/>
            </p:cNvCxnSpPr>
            <p:nvPr/>
          </p:nvCxnSpPr>
          <p:spPr>
            <a:xfrm rot="3540000" flipV="1">
              <a:off x="9352241" y="2021850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3F224E8-D109-A5A7-F7C4-A59BF7CBE587}"/>
                </a:ext>
              </a:extLst>
            </p:cNvPr>
            <p:cNvSpPr txBox="1"/>
            <p:nvPr/>
          </p:nvSpPr>
          <p:spPr>
            <a:xfrm>
              <a:off x="9292020" y="1885460"/>
              <a:ext cx="40492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DA55657A-A157-6112-87F8-0442961FC9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55988" y="2242376"/>
              <a:ext cx="105243" cy="3961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F8B45D8-F2BD-F15C-C177-37709346A20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28604" y="2149681"/>
              <a:ext cx="113595" cy="379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EFD4F82C-A8C8-8F77-7905-5A2C740DAB5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01783" y="2770080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A5013440-846E-6A72-72FF-3F99113156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97797" y="2356131"/>
              <a:ext cx="105243" cy="3961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94D17226-C189-A041-4F0D-B692207B792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454637" y="2539354"/>
              <a:ext cx="105243" cy="3961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404F2609-ADF4-ACC0-D0F0-C3E1BA4E68C7}"/>
                </a:ext>
              </a:extLst>
            </p:cNvPr>
            <p:cNvSpPr txBox="1"/>
            <p:nvPr/>
          </p:nvSpPr>
          <p:spPr>
            <a:xfrm>
              <a:off x="9345786" y="1994704"/>
              <a:ext cx="41767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R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576B303-A274-262A-6512-F63D70251E57}"/>
                </a:ext>
              </a:extLst>
            </p:cNvPr>
            <p:cNvSpPr txBox="1"/>
            <p:nvPr/>
          </p:nvSpPr>
          <p:spPr>
            <a:xfrm>
              <a:off x="9366677" y="2099847"/>
              <a:ext cx="430433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Q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0D755DFB-F6B6-706A-3E12-273E56D6D550}"/>
                </a:ext>
              </a:extLst>
            </p:cNvPr>
            <p:cNvSpPr txBox="1"/>
            <p:nvPr/>
          </p:nvSpPr>
          <p:spPr>
            <a:xfrm>
              <a:off x="9411375" y="2222222"/>
              <a:ext cx="41767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P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CA8F078-59AF-14F1-E599-F1858EFA5D59}"/>
                </a:ext>
              </a:extLst>
            </p:cNvPr>
            <p:cNvSpPr txBox="1"/>
            <p:nvPr/>
          </p:nvSpPr>
          <p:spPr>
            <a:xfrm>
              <a:off x="9468107" y="2395749"/>
              <a:ext cx="430433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O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C5B7765-1A25-C5FA-EA20-E38533F730A3}"/>
                </a:ext>
              </a:extLst>
            </p:cNvPr>
            <p:cNvCxnSpPr>
              <a:cxnSpLocks/>
            </p:cNvCxnSpPr>
            <p:nvPr/>
          </p:nvCxnSpPr>
          <p:spPr>
            <a:xfrm rot="420000" flipV="1">
              <a:off x="9527428" y="2955189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86C95EAB-52CF-1F1F-57D5-F1120312DE78}"/>
                </a:ext>
              </a:extLst>
            </p:cNvPr>
            <p:cNvCxnSpPr>
              <a:cxnSpLocks/>
            </p:cNvCxnSpPr>
            <p:nvPr/>
          </p:nvCxnSpPr>
          <p:spPr>
            <a:xfrm rot="600000" flipV="1">
              <a:off x="9559880" y="3398970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B282E85B-85B7-5063-E5CF-F8D20E8BC86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524034" y="3904254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AA6F61F-6E33-BAD2-04F7-0D2FC8AEF3B5}"/>
                </a:ext>
              </a:extLst>
            </p:cNvPr>
            <p:cNvSpPr txBox="1"/>
            <p:nvPr/>
          </p:nvSpPr>
          <p:spPr>
            <a:xfrm>
              <a:off x="9513657" y="2622124"/>
              <a:ext cx="42496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7621AB3-CC20-EB25-4901-850A5152518A}"/>
                </a:ext>
              </a:extLst>
            </p:cNvPr>
            <p:cNvSpPr txBox="1"/>
            <p:nvPr/>
          </p:nvSpPr>
          <p:spPr>
            <a:xfrm>
              <a:off x="9542765" y="2838224"/>
              <a:ext cx="443188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M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AC10A35-3F74-00B9-C6DD-92462BF72337}"/>
                </a:ext>
              </a:extLst>
            </p:cNvPr>
            <p:cNvSpPr txBox="1"/>
            <p:nvPr/>
          </p:nvSpPr>
          <p:spPr>
            <a:xfrm>
              <a:off x="9573911" y="3281548"/>
              <a:ext cx="443188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ogL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DDB70A5-55E9-A5B9-E5C9-45AF419AFE4B}"/>
                </a:ext>
              </a:extLst>
            </p:cNvPr>
            <p:cNvSpPr txBox="1"/>
            <p:nvPr/>
          </p:nvSpPr>
          <p:spPr>
            <a:xfrm>
              <a:off x="9534690" y="3770338"/>
              <a:ext cx="359361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ld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A054E61-DE5C-8120-8F0D-8CA2228E8707}"/>
                </a:ext>
              </a:extLst>
            </p:cNvPr>
            <p:cNvSpPr txBox="1"/>
            <p:nvPr/>
          </p:nvSpPr>
          <p:spPr>
            <a:xfrm>
              <a:off x="9412562" y="4335506"/>
              <a:ext cx="430433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H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19E2E1A4-5026-F753-26AE-F8CE65539194}"/>
                </a:ext>
              </a:extLst>
            </p:cNvPr>
            <p:cNvSpPr txBox="1"/>
            <p:nvPr/>
          </p:nvSpPr>
          <p:spPr>
            <a:xfrm>
              <a:off x="9482492" y="3990980"/>
              <a:ext cx="46323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ggR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5F8716C-AF41-56EB-E493-4A1BFC56133B}"/>
                </a:ext>
              </a:extLst>
            </p:cNvPr>
            <p:cNvSpPr txBox="1"/>
            <p:nvPr/>
          </p:nvSpPr>
          <p:spPr>
            <a:xfrm>
              <a:off x="9445973" y="4205925"/>
              <a:ext cx="38487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I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22462E43-F5EA-C941-B699-269370CB73A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479745" y="4130221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23AFB087-C0FC-F4CE-0B00-3BB2F685F66D}"/>
                </a:ext>
              </a:extLst>
            </p:cNvPr>
            <p:cNvCxnSpPr>
              <a:cxnSpLocks/>
            </p:cNvCxnSpPr>
            <p:nvPr/>
          </p:nvCxnSpPr>
          <p:spPr>
            <a:xfrm rot="900000" flipV="1">
              <a:off x="9427449" y="4324869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48FD6ED5-4EDF-BCA6-8F43-95AC8AB6022D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8920253" y="5395712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CBBF59CF-0589-B730-D0EB-625C9EAFFD0F}"/>
                </a:ext>
              </a:extLst>
            </p:cNvPr>
            <p:cNvCxnSpPr>
              <a:cxnSpLocks/>
            </p:cNvCxnSpPr>
            <p:nvPr/>
          </p:nvCxnSpPr>
          <p:spPr>
            <a:xfrm rot="900000" flipV="1">
              <a:off x="9401656" y="4447657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F9B24924-44AF-DCC3-2202-9E31E4965A48}"/>
                </a:ext>
              </a:extLst>
            </p:cNvPr>
            <p:cNvCxnSpPr>
              <a:cxnSpLocks/>
            </p:cNvCxnSpPr>
            <p:nvPr/>
          </p:nvCxnSpPr>
          <p:spPr>
            <a:xfrm rot="900000" flipV="1">
              <a:off x="9340259" y="4611993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A59ACDE3-BDF7-A8D7-0E89-5692EFD655B5}"/>
                </a:ext>
              </a:extLst>
            </p:cNvPr>
            <p:cNvCxnSpPr>
              <a:cxnSpLocks/>
            </p:cNvCxnSpPr>
            <p:nvPr/>
          </p:nvCxnSpPr>
          <p:spPr>
            <a:xfrm rot="900000" flipV="1">
              <a:off x="9264864" y="4797204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0B63D93A-6E29-D5B3-51CE-AE950A8ADE34}"/>
                </a:ext>
              </a:extLst>
            </p:cNvPr>
            <p:cNvCxnSpPr>
              <a:cxnSpLocks/>
            </p:cNvCxnSpPr>
            <p:nvPr/>
          </p:nvCxnSpPr>
          <p:spPr>
            <a:xfrm rot="900000" flipV="1">
              <a:off x="9175533" y="4982413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67DCF0FB-39FA-868A-FCA5-7CE5DEDDEF3F}"/>
                </a:ext>
              </a:extLst>
            </p:cNvPr>
            <p:cNvSpPr txBox="1"/>
            <p:nvPr/>
          </p:nvSpPr>
          <p:spPr>
            <a:xfrm>
              <a:off x="9278102" y="4682068"/>
              <a:ext cx="41767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F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4BAC0D58-A0EB-CFB5-6376-272C48DB4EEB}"/>
                </a:ext>
              </a:extLst>
            </p:cNvPr>
            <p:cNvSpPr txBox="1"/>
            <p:nvPr/>
          </p:nvSpPr>
          <p:spPr>
            <a:xfrm>
              <a:off x="9356981" y="4501591"/>
              <a:ext cx="34660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is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3296373-A7A5-51DF-C4CF-BA41067EE4D9}"/>
                </a:ext>
              </a:extLst>
            </p:cNvPr>
            <p:cNvSpPr txBox="1"/>
            <p:nvPr/>
          </p:nvSpPr>
          <p:spPr>
            <a:xfrm>
              <a:off x="9188032" y="4869401"/>
              <a:ext cx="41767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E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AB34A2A-D775-193E-778F-F942CD68F0F9}"/>
                </a:ext>
              </a:extLst>
            </p:cNvPr>
            <p:cNvSpPr txBox="1"/>
            <p:nvPr/>
          </p:nvSpPr>
          <p:spPr>
            <a:xfrm>
              <a:off x="8934234" y="5286683"/>
              <a:ext cx="41767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U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6B0D3A92-6195-589C-FA9B-386BC1ED887A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8768676" y="5586943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1B6AB6E2-4B52-95D3-88FA-DBC16E83CC08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8659186" y="5716947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1402153-1C19-229E-0E82-BB2D8C1F2E48}"/>
                </a:ext>
              </a:extLst>
            </p:cNvPr>
            <p:cNvSpPr txBox="1"/>
            <p:nvPr/>
          </p:nvSpPr>
          <p:spPr>
            <a:xfrm>
              <a:off x="8778410" y="5476071"/>
              <a:ext cx="41767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X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C06E737-FF91-C326-637F-71A93F4A3704}"/>
                </a:ext>
              </a:extLst>
            </p:cNvPr>
            <p:cNvSpPr txBox="1"/>
            <p:nvPr/>
          </p:nvSpPr>
          <p:spPr>
            <a:xfrm>
              <a:off x="8671901" y="5605868"/>
              <a:ext cx="41221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R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C1C614B0-9A73-0723-4AE0-F888A94C1D8C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8310869" y="6044020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718D3061-015A-9BFC-3E1C-F9C48F954BEB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8172315" y="6147092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2E85F71D-8A9C-2476-F514-AA0C77644233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7743197" y="6412508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91E55DA-60F0-7A61-3511-2451837F5667}"/>
                </a:ext>
              </a:extLst>
            </p:cNvPr>
            <p:cNvSpPr txBox="1"/>
            <p:nvPr/>
          </p:nvSpPr>
          <p:spPr>
            <a:xfrm>
              <a:off x="8323890" y="5925053"/>
              <a:ext cx="40492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P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903707B7-97AB-3056-3063-85E9FFBB7EEB}"/>
                </a:ext>
              </a:extLst>
            </p:cNvPr>
            <p:cNvSpPr txBox="1"/>
            <p:nvPr/>
          </p:nvSpPr>
          <p:spPr>
            <a:xfrm>
              <a:off x="8184503" y="6038409"/>
              <a:ext cx="41767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O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78D8FBE-4CF7-F543-FED9-E74DFBFD1E8C}"/>
                </a:ext>
              </a:extLst>
            </p:cNvPr>
            <p:cNvSpPr txBox="1"/>
            <p:nvPr/>
          </p:nvSpPr>
          <p:spPr>
            <a:xfrm>
              <a:off x="7759368" y="6290809"/>
              <a:ext cx="437722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ilM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58A8D9F7-782A-EA4D-DC84-29185D394EDA}"/>
                </a:ext>
              </a:extLst>
            </p:cNvPr>
            <p:cNvCxnSpPr>
              <a:cxnSpLocks/>
            </p:cNvCxnSpPr>
            <p:nvPr/>
          </p:nvCxnSpPr>
          <p:spPr>
            <a:xfrm rot="1200000" flipV="1">
              <a:off x="6864071" y="6731349"/>
              <a:ext cx="99754" cy="3003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DDD082A7-93C2-5135-DADB-FE1A87F5F9D5}"/>
                </a:ext>
              </a:extLst>
            </p:cNvPr>
            <p:cNvCxnSpPr>
              <a:cxnSpLocks/>
            </p:cNvCxnSpPr>
            <p:nvPr/>
          </p:nvCxnSpPr>
          <p:spPr>
            <a:xfrm>
              <a:off x="6670837" y="6774583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8557377-FEB9-1833-F456-B0A57CEB24D6}"/>
                </a:ext>
              </a:extLst>
            </p:cNvPr>
            <p:cNvSpPr txBox="1"/>
            <p:nvPr/>
          </p:nvSpPr>
          <p:spPr>
            <a:xfrm>
              <a:off x="6886102" y="6642392"/>
              <a:ext cx="41767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81475D25-8976-D218-0151-99482ED43210}"/>
                </a:ext>
              </a:extLst>
            </p:cNvPr>
            <p:cNvCxnSpPr>
              <a:cxnSpLocks/>
            </p:cNvCxnSpPr>
            <p:nvPr/>
          </p:nvCxnSpPr>
          <p:spPr>
            <a:xfrm rot="1320000">
              <a:off x="6605894" y="6793078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C597D3F4-39E1-3711-E522-F37E61B18ED8}"/>
                </a:ext>
              </a:extLst>
            </p:cNvPr>
            <p:cNvCxnSpPr>
              <a:cxnSpLocks/>
            </p:cNvCxnSpPr>
            <p:nvPr/>
          </p:nvCxnSpPr>
          <p:spPr>
            <a:xfrm rot="1320000">
              <a:off x="6312396" y="6824787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CEAE756-F6D5-BF70-9C92-3C3D61862B3D}"/>
                </a:ext>
              </a:extLst>
            </p:cNvPr>
            <p:cNvSpPr txBox="1"/>
            <p:nvPr/>
          </p:nvSpPr>
          <p:spPr>
            <a:xfrm>
              <a:off x="6691239" y="6712596"/>
              <a:ext cx="41585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973D1D17-6B98-3176-76AE-EFC2D7D1E547}"/>
                </a:ext>
              </a:extLst>
            </p:cNvPr>
            <p:cNvSpPr txBox="1"/>
            <p:nvPr/>
          </p:nvSpPr>
          <p:spPr>
            <a:xfrm>
              <a:off x="6531304" y="6782802"/>
              <a:ext cx="34660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4</a:t>
              </a:r>
            </a:p>
          </p:txBody>
        </p:sp>
        <p:cxnSp>
          <p:nvCxnSpPr>
            <p:cNvPr id="78" name="Straight Connector 77">
              <a:extLst>
                <a:ext uri="{FF2B5EF4-FFF2-40B4-BE49-F238E27FC236}">
                  <a16:creationId xmlns:a16="http://schemas.microsoft.com/office/drawing/2014/main" id="{75170FCC-FE2D-9083-FF24-919FB8D99653}"/>
                </a:ext>
              </a:extLst>
            </p:cNvPr>
            <p:cNvCxnSpPr>
              <a:cxnSpLocks/>
            </p:cNvCxnSpPr>
            <p:nvPr/>
          </p:nvCxnSpPr>
          <p:spPr>
            <a:xfrm rot="4260000">
              <a:off x="5559571" y="6788545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8073D9D-F31E-74DE-5128-E8DF31C3417B}"/>
                </a:ext>
              </a:extLst>
            </p:cNvPr>
            <p:cNvSpPr txBox="1"/>
            <p:nvPr/>
          </p:nvSpPr>
          <p:spPr>
            <a:xfrm>
              <a:off x="6213150" y="6805745"/>
              <a:ext cx="441367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318B51AE-3FF3-4321-A703-E7A3D5BEC08B}"/>
                </a:ext>
              </a:extLst>
            </p:cNvPr>
            <p:cNvCxnSpPr>
              <a:cxnSpLocks/>
            </p:cNvCxnSpPr>
            <p:nvPr/>
          </p:nvCxnSpPr>
          <p:spPr>
            <a:xfrm rot="4260000">
              <a:off x="5241846" y="6729038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>
              <a:extLst>
                <a:ext uri="{FF2B5EF4-FFF2-40B4-BE49-F238E27FC236}">
                  <a16:creationId xmlns:a16="http://schemas.microsoft.com/office/drawing/2014/main" id="{058B0DE2-A9DB-932A-35D1-29CABC1A9CFC}"/>
                </a:ext>
              </a:extLst>
            </p:cNvPr>
            <p:cNvCxnSpPr>
              <a:cxnSpLocks/>
            </p:cNvCxnSpPr>
            <p:nvPr/>
          </p:nvCxnSpPr>
          <p:spPr>
            <a:xfrm rot="4260000">
              <a:off x="4989337" y="6635888"/>
              <a:ext cx="95723" cy="474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4DE394ED-F297-302B-13CB-203782870F22}"/>
                </a:ext>
              </a:extLst>
            </p:cNvPr>
            <p:cNvSpPr txBox="1"/>
            <p:nvPr/>
          </p:nvSpPr>
          <p:spPr>
            <a:xfrm>
              <a:off x="5371630" y="6805745"/>
              <a:ext cx="527015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As1</a:t>
              </a:r>
            </a:p>
          </p:txBody>
        </p:sp>
        <p:cxnSp>
          <p:nvCxnSpPr>
            <p:cNvPr id="83" name="Straight Connector 82">
              <a:extLst>
                <a:ext uri="{FF2B5EF4-FFF2-40B4-BE49-F238E27FC236}">
                  <a16:creationId xmlns:a16="http://schemas.microsoft.com/office/drawing/2014/main" id="{EFC68306-F064-43FD-3E1A-B2F1928C8F0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816117" y="6552243"/>
              <a:ext cx="52285" cy="93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9895DB89-F015-07B0-DA1C-43704B173FA2}"/>
                </a:ext>
              </a:extLst>
            </p:cNvPr>
            <p:cNvSpPr txBox="1"/>
            <p:nvPr/>
          </p:nvSpPr>
          <p:spPr>
            <a:xfrm>
              <a:off x="5073276" y="6733099"/>
              <a:ext cx="48692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am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D4329A9-F817-FC1F-91AF-3112F5D5F46E}"/>
                </a:ext>
              </a:extLst>
            </p:cNvPr>
            <p:cNvSpPr txBox="1"/>
            <p:nvPr/>
          </p:nvSpPr>
          <p:spPr>
            <a:xfrm>
              <a:off x="4824978" y="6645835"/>
              <a:ext cx="410386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t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EF516CCF-DA8D-0A77-828C-13D7DF24E01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177967" y="6187589"/>
              <a:ext cx="52285" cy="93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79A3EC9B-5661-3DE1-BD3E-F358B0ADEC25}"/>
                </a:ext>
              </a:extLst>
            </p:cNvPr>
            <p:cNvSpPr txBox="1"/>
            <p:nvPr/>
          </p:nvSpPr>
          <p:spPr>
            <a:xfrm>
              <a:off x="4609894" y="6584371"/>
              <a:ext cx="40492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t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1DB6BBDD-2856-00A4-4CC1-E72AE30E858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583751" y="6431865"/>
              <a:ext cx="52285" cy="93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06C495B-B56D-6028-33F4-0204FA6A23FE}"/>
                </a:ext>
              </a:extLst>
            </p:cNvPr>
            <p:cNvSpPr txBox="1"/>
            <p:nvPr/>
          </p:nvSpPr>
          <p:spPr>
            <a:xfrm>
              <a:off x="4230252" y="6478440"/>
              <a:ext cx="694669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TEM-1</a:t>
              </a: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EA951DCD-2F33-DF69-CF5D-61E653ED15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31116" y="6363133"/>
              <a:ext cx="52285" cy="931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5D734A0F-8580-F841-D0A8-2F1FB6E1D9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33716" y="5925053"/>
              <a:ext cx="6879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F09CAE06-A39A-3BC0-72D4-21ABEDC699C8}"/>
                </a:ext>
              </a:extLst>
            </p:cNvPr>
            <p:cNvSpPr txBox="1"/>
            <p:nvPr/>
          </p:nvSpPr>
          <p:spPr>
            <a:xfrm>
              <a:off x="4155084" y="6387442"/>
              <a:ext cx="437722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npR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EE4C25D-824F-6911-A5F4-AD845D575573}"/>
                </a:ext>
              </a:extLst>
            </p:cNvPr>
            <p:cNvSpPr txBox="1"/>
            <p:nvPr/>
          </p:nvSpPr>
          <p:spPr>
            <a:xfrm>
              <a:off x="3964540" y="6218587"/>
              <a:ext cx="397631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2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BA5F8929-1559-E459-A174-64FECBABF8E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98421" y="5790980"/>
              <a:ext cx="68790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2448BA3D-ACE8-DD6C-91DC-AB0BC4EEA5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87619" y="5611844"/>
              <a:ext cx="94647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4D87F457-9032-372C-1B8A-1E3BD7348FB6}"/>
                </a:ext>
              </a:extLst>
            </p:cNvPr>
            <p:cNvSpPr txBox="1"/>
            <p:nvPr/>
          </p:nvSpPr>
          <p:spPr>
            <a:xfrm>
              <a:off x="3511397" y="5951455"/>
              <a:ext cx="534304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S71A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6F835E9E-78BB-6ADA-C935-46F951D7231E}"/>
                </a:ext>
              </a:extLst>
            </p:cNvPr>
            <p:cNvSpPr txBox="1"/>
            <p:nvPr/>
          </p:nvSpPr>
          <p:spPr>
            <a:xfrm>
              <a:off x="3408139" y="5828203"/>
              <a:ext cx="428609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DCA54595-AB46-3516-5E83-DA364333244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10443" y="5213913"/>
              <a:ext cx="94647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0D4CE011-4E1E-697B-3249-35912863514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82131" y="5319844"/>
              <a:ext cx="94647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9C27F19D-D9AA-0E2E-7EAB-14B8959137C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96141" y="5071571"/>
              <a:ext cx="122465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06ECAC36-43C8-8946-0DC1-5305AEB2DBA7}"/>
                </a:ext>
              </a:extLst>
            </p:cNvPr>
            <p:cNvSpPr txBox="1"/>
            <p:nvPr/>
          </p:nvSpPr>
          <p:spPr>
            <a:xfrm>
              <a:off x="3151879" y="5606568"/>
              <a:ext cx="434077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D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0EB79DFC-B0C4-ED16-4934-16826EC8CE22}"/>
                </a:ext>
              </a:extLst>
            </p:cNvPr>
            <p:cNvSpPr txBox="1"/>
            <p:nvPr/>
          </p:nvSpPr>
          <p:spPr>
            <a:xfrm>
              <a:off x="3029508" y="5340982"/>
              <a:ext cx="421320" cy="2449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E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C4842A4E-A94B-67D4-088E-38EAFB7401D4}"/>
                </a:ext>
              </a:extLst>
            </p:cNvPr>
            <p:cNvSpPr txBox="1"/>
            <p:nvPr/>
          </p:nvSpPr>
          <p:spPr>
            <a:xfrm>
              <a:off x="2889587" y="5217664"/>
              <a:ext cx="454908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F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7BC64A7-84B1-962D-2ACA-A5E11547EC57}"/>
                </a:ext>
              </a:extLst>
            </p:cNvPr>
            <p:cNvSpPr txBox="1"/>
            <p:nvPr/>
          </p:nvSpPr>
          <p:spPr>
            <a:xfrm>
              <a:off x="2763320" y="5056445"/>
              <a:ext cx="469222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G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3FD33940-8C2B-E44D-E331-EF7D685446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00893" y="4891258"/>
              <a:ext cx="122465" cy="914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B31C85E0-DE65-AABF-C842-41FE60D00DE0}"/>
                </a:ext>
              </a:extLst>
            </p:cNvPr>
            <p:cNvSpPr txBox="1"/>
            <p:nvPr/>
          </p:nvSpPr>
          <p:spPr>
            <a:xfrm>
              <a:off x="2668706" y="4872754"/>
              <a:ext cx="469222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H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36F7E083-1C48-92CB-49D0-BC91478C75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28257" y="4739086"/>
              <a:ext cx="133868" cy="731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19602B64-F612-5CBE-462D-66002700F3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62300" y="4589836"/>
              <a:ext cx="133868" cy="731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CB5F5538-C194-91E3-6946-89F8164D96C0}"/>
                </a:ext>
              </a:extLst>
            </p:cNvPr>
            <p:cNvSpPr txBox="1"/>
            <p:nvPr/>
          </p:nvSpPr>
          <p:spPr>
            <a:xfrm>
              <a:off x="2644569" y="4704860"/>
              <a:ext cx="40248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I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9FCBC1B-15CC-84B8-AE00-BAF558296B48}"/>
                </a:ext>
              </a:extLst>
            </p:cNvPr>
            <p:cNvSpPr txBox="1"/>
            <p:nvPr/>
          </p:nvSpPr>
          <p:spPr>
            <a:xfrm>
              <a:off x="2564731" y="4538149"/>
              <a:ext cx="40248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J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06CF7DE1-AE7B-5F9A-3226-EBD437A09F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89797" y="4327101"/>
              <a:ext cx="133868" cy="7313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7F457FD9-F76A-2C83-2859-61AF2B7094E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5164" y="3537736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E51F743-B471-6E6F-59E3-4D4E4D9CCF86}"/>
                </a:ext>
              </a:extLst>
            </p:cNvPr>
            <p:cNvSpPr txBox="1"/>
            <p:nvPr/>
          </p:nvSpPr>
          <p:spPr>
            <a:xfrm>
              <a:off x="2362365" y="4342138"/>
              <a:ext cx="58448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25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74B76D7F-65D2-EB87-847E-8264E8C2C172}"/>
                </a:ext>
              </a:extLst>
            </p:cNvPr>
            <p:cNvSpPr txBox="1"/>
            <p:nvPr/>
          </p:nvSpPr>
          <p:spPr>
            <a:xfrm>
              <a:off x="2207079" y="3429000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43</a:t>
              </a:r>
            </a:p>
          </p:txBody>
        </p: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6F607CF4-30C0-D58F-7552-183558CA03F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673471" y="3243822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4FECD061-EE7B-9B2F-5545-39614B26F0CC}"/>
                </a:ext>
              </a:extLst>
            </p:cNvPr>
            <p:cNvSpPr txBox="1"/>
            <p:nvPr/>
          </p:nvSpPr>
          <p:spPr>
            <a:xfrm>
              <a:off x="2241793" y="3125526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1663</a:t>
              </a:r>
            </a:p>
          </p:txBody>
        </p: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2FF57653-1DA1-9E8B-BB5A-2F109B500D7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07339" y="2453054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1475ADD-E363-885E-4EF4-1B49D00E5887}"/>
                </a:ext>
              </a:extLst>
            </p:cNvPr>
            <p:cNvSpPr txBox="1"/>
            <p:nvPr/>
          </p:nvSpPr>
          <p:spPr>
            <a:xfrm>
              <a:off x="2489313" y="2321538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xer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00DF2A26-E59D-C37A-36D7-4CC3284431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10753" y="2183644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661962BF-1930-C8E8-5621-5001BC03F39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67900" y="2042131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346BFEC8-2500-C509-9688-784DEF29F5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17916" y="1742776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26133913-5D80-F689-0894-2204466631F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18570" y="1581336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3756E4A4-1AFD-DBE3-1899-0E6413654B4B}"/>
                </a:ext>
              </a:extLst>
            </p:cNvPr>
            <p:cNvSpPr txBox="1"/>
            <p:nvPr/>
          </p:nvSpPr>
          <p:spPr>
            <a:xfrm>
              <a:off x="2556487" y="2070021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rp54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8CC1890F-BCE3-6EC4-98B9-ED01A6A57B6B}"/>
                </a:ext>
              </a:extLst>
            </p:cNvPr>
            <p:cNvSpPr txBox="1"/>
            <p:nvPr/>
          </p:nvSpPr>
          <p:spPr>
            <a:xfrm>
              <a:off x="2718277" y="1613438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CE7BCBFA-2591-6B6D-2DD9-FC6C1899DF72}"/>
                </a:ext>
              </a:extLst>
            </p:cNvPr>
            <p:cNvSpPr txBox="1"/>
            <p:nvPr/>
          </p:nvSpPr>
          <p:spPr>
            <a:xfrm>
              <a:off x="2621806" y="1914900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M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2A0EA9B0-30A1-6FC4-29DD-94CBDE4FC8F4}"/>
                </a:ext>
              </a:extLst>
            </p:cNvPr>
            <p:cNvSpPr txBox="1"/>
            <p:nvPr/>
          </p:nvSpPr>
          <p:spPr>
            <a:xfrm>
              <a:off x="2814105" y="1452562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D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5A7E31C5-461B-3E1C-F51F-6576611C326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76779" y="1231416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89D48592-B0C6-F4B9-6216-03BE74ABBA01}"/>
                </a:ext>
              </a:extLst>
            </p:cNvPr>
            <p:cNvSpPr txBox="1"/>
            <p:nvPr/>
          </p:nvSpPr>
          <p:spPr>
            <a:xfrm>
              <a:off x="3323574" y="889205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ch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36DDD08E-C12A-9769-3AEC-6D4DA39990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674653" y="1016424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AA4E7452-0AB3-04E3-9A57-9B800073ADC6}"/>
                </a:ext>
              </a:extLst>
            </p:cNvPr>
            <p:cNvSpPr txBox="1"/>
            <p:nvPr/>
          </p:nvSpPr>
          <p:spPr>
            <a:xfrm>
              <a:off x="3104043" y="1103586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ubD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E3AE52C1-8153-AC08-EF43-7EBD0BDC387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90979" y="896738"/>
              <a:ext cx="116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1D2998D8-7F7D-9CA0-E03E-BE2CD442BDD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323934" y="430433"/>
              <a:ext cx="93055" cy="5657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AC2F1999-528B-523E-14B7-96AD0D65A8C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44237" y="596240"/>
              <a:ext cx="95176" cy="3328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F9399725-E24E-B890-439F-AE61D78BC516}"/>
                </a:ext>
              </a:extLst>
            </p:cNvPr>
            <p:cNvSpPr txBox="1"/>
            <p:nvPr/>
          </p:nvSpPr>
          <p:spPr>
            <a:xfrm>
              <a:off x="3462523" y="763700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lc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C67643CB-720A-D4A9-1CB5-1006680E4CBA}"/>
                </a:ext>
              </a:extLst>
            </p:cNvPr>
            <p:cNvSpPr txBox="1"/>
            <p:nvPr/>
          </p:nvSpPr>
          <p:spPr>
            <a:xfrm>
              <a:off x="3800559" y="476379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ubL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4" name="Straight Connector 143">
              <a:extLst>
                <a:ext uri="{FF2B5EF4-FFF2-40B4-BE49-F238E27FC236}">
                  <a16:creationId xmlns:a16="http://schemas.microsoft.com/office/drawing/2014/main" id="{BA4FC5BC-FD55-94CD-B664-C3549DDE629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583751" y="332985"/>
              <a:ext cx="93055" cy="5657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>
              <a:extLst>
                <a:ext uri="{FF2B5EF4-FFF2-40B4-BE49-F238E27FC236}">
                  <a16:creationId xmlns:a16="http://schemas.microsoft.com/office/drawing/2014/main" id="{34AACA6B-366A-12ED-A9C6-3DA4BEE0C6A2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211622" y="98612"/>
              <a:ext cx="116104" cy="533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>
              <a:extLst>
                <a:ext uri="{FF2B5EF4-FFF2-40B4-BE49-F238E27FC236}">
                  <a16:creationId xmlns:a16="http://schemas.microsoft.com/office/drawing/2014/main" id="{08F5A097-723A-113C-4F4A-1ABC8CE4CFC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459495" y="0"/>
              <a:ext cx="69722" cy="986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44159456-D0F7-6A26-1D8B-3A0956073836}"/>
                </a:ext>
              </a:extLst>
            </p:cNvPr>
            <p:cNvSpPr txBox="1"/>
            <p:nvPr/>
          </p:nvSpPr>
          <p:spPr>
            <a:xfrm>
              <a:off x="4847651" y="-16804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nd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F77C5158-48A1-99BF-0A15-1A89BC4A3950}"/>
                </a:ext>
              </a:extLst>
            </p:cNvPr>
            <p:cNvSpPr txBox="1"/>
            <p:nvPr/>
          </p:nvSpPr>
          <p:spPr>
            <a:xfrm>
              <a:off x="4264528" y="189338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i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CB33917B-3059-4FBC-A855-1FCFC9F1E926}"/>
                </a:ext>
              </a:extLst>
            </p:cNvPr>
            <p:cNvSpPr txBox="1"/>
            <p:nvPr/>
          </p:nvSpPr>
          <p:spPr>
            <a:xfrm>
              <a:off x="3989508" y="307594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AB07D09F-2F8C-7BAA-60DB-83C926A40DF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00582" y="-74487"/>
              <a:ext cx="52300" cy="1051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>
              <a:extLst>
                <a:ext uri="{FF2B5EF4-FFF2-40B4-BE49-F238E27FC236}">
                  <a16:creationId xmlns:a16="http://schemas.microsoft.com/office/drawing/2014/main" id="{500B77F7-AC88-ABB9-209A-8E07B58BC62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61138" y="-74487"/>
              <a:ext cx="69722" cy="986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DAFEFDE1-48AA-344E-9880-1267BE6BD086}"/>
                </a:ext>
              </a:extLst>
            </p:cNvPr>
            <p:cNvSpPr txBox="1"/>
            <p:nvPr/>
          </p:nvSpPr>
          <p:spPr>
            <a:xfrm>
              <a:off x="5040233" y="-150310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Sen7</a:t>
              </a:r>
            </a:p>
          </p:txBody>
        </p:sp>
        <p:cxnSp>
          <p:nvCxnSpPr>
            <p:cNvPr id="158" name="Straight Connector 157">
              <a:extLst>
                <a:ext uri="{FF2B5EF4-FFF2-40B4-BE49-F238E27FC236}">
                  <a16:creationId xmlns:a16="http://schemas.microsoft.com/office/drawing/2014/main" id="{E20AF271-9DF0-22FB-B4E7-9E02305CD5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525042" y="-55819"/>
              <a:ext cx="52300" cy="1051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>
              <a:extLst>
                <a:ext uri="{FF2B5EF4-FFF2-40B4-BE49-F238E27FC236}">
                  <a16:creationId xmlns:a16="http://schemas.microsoft.com/office/drawing/2014/main" id="{A6527680-8115-5A83-2132-12B9C2E27288}"/>
                </a:ext>
              </a:extLst>
            </p:cNvPr>
            <p:cNvSpPr txBox="1"/>
            <p:nvPr/>
          </p:nvSpPr>
          <p:spPr>
            <a:xfrm>
              <a:off x="5694199" y="-239959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bC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TextBox 159">
              <a:extLst>
                <a:ext uri="{FF2B5EF4-FFF2-40B4-BE49-F238E27FC236}">
                  <a16:creationId xmlns:a16="http://schemas.microsoft.com/office/drawing/2014/main" id="{40C1B145-E3DF-E484-F7C3-88DBC1A73FE1}"/>
                </a:ext>
              </a:extLst>
            </p:cNvPr>
            <p:cNvSpPr txBox="1"/>
            <p:nvPr/>
          </p:nvSpPr>
          <p:spPr>
            <a:xfrm>
              <a:off x="6493605" y="-211192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ik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3F3F6072-4C28-C86F-0AEF-1279A704EB0F}"/>
                </a:ext>
              </a:extLst>
            </p:cNvPr>
            <p:cNvSpPr txBox="1"/>
            <p:nvPr/>
          </p:nvSpPr>
          <p:spPr>
            <a:xfrm>
              <a:off x="6129810" y="-239959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J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2" name="Straight Connector 161">
              <a:extLst>
                <a:ext uri="{FF2B5EF4-FFF2-40B4-BE49-F238E27FC236}">
                  <a16:creationId xmlns:a16="http://schemas.microsoft.com/office/drawing/2014/main" id="{3D9AA859-929C-8D1D-7BE8-39EAD015120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76686" y="155536"/>
              <a:ext cx="52300" cy="1051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47127625-25B6-8403-E931-D7F554B029A9}"/>
                </a:ext>
              </a:extLst>
            </p:cNvPr>
            <p:cNvSpPr txBox="1"/>
            <p:nvPr/>
          </p:nvSpPr>
          <p:spPr>
            <a:xfrm>
              <a:off x="7258140" y="-8140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bB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4" name="Straight Connector 163">
              <a:extLst>
                <a:ext uri="{FF2B5EF4-FFF2-40B4-BE49-F238E27FC236}">
                  <a16:creationId xmlns:a16="http://schemas.microsoft.com/office/drawing/2014/main" id="{E38B96A1-13C8-EAF2-7A93-C5709FC180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600802" y="231737"/>
              <a:ext cx="52300" cy="1051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TextBox 164">
              <a:extLst>
                <a:ext uri="{FF2B5EF4-FFF2-40B4-BE49-F238E27FC236}">
                  <a16:creationId xmlns:a16="http://schemas.microsoft.com/office/drawing/2014/main" id="{30C1920E-84DE-20B3-ECFE-210F45BB1EDC}"/>
                </a:ext>
              </a:extLst>
            </p:cNvPr>
            <p:cNvSpPr txBox="1"/>
            <p:nvPr/>
          </p:nvSpPr>
          <p:spPr>
            <a:xfrm>
              <a:off x="7574997" y="106635"/>
              <a:ext cx="561429" cy="2449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bA</a:t>
              </a:r>
              <a:endParaRPr 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7ECA06CC-8352-E858-DD56-BF3C2F3A1A8E}"/>
                </a:ext>
              </a:extLst>
            </p:cNvPr>
            <p:cNvSpPr txBox="1"/>
            <p:nvPr/>
          </p:nvSpPr>
          <p:spPr>
            <a:xfrm>
              <a:off x="5438028" y="2815876"/>
              <a:ext cx="1419952" cy="10496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15-2</a:t>
              </a: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I1-I</a:t>
              </a: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3,546 bp</a:t>
              </a:r>
            </a:p>
          </p:txBody>
        </p:sp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A6C02087-EDE2-D36C-9BFD-3B3C91E5AA8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24395" y="195768"/>
              <a:ext cx="1152525" cy="1247775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2FB9DAC2-12F8-8EF7-B0A5-F5528A957E7B}"/>
              </a:ext>
            </a:extLst>
          </p:cNvPr>
          <p:cNvSpPr txBox="1"/>
          <p:nvPr/>
        </p:nvSpPr>
        <p:spPr>
          <a:xfrm>
            <a:off x="-270" y="0"/>
            <a:ext cx="4936207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visualization of plasmid pEC15-2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8043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9509830-3E59-7A9B-7B3E-FF02C79628AA}"/>
              </a:ext>
            </a:extLst>
          </p:cNvPr>
          <p:cNvGrpSpPr>
            <a:grpSpLocks noChangeAspect="1"/>
          </p:cNvGrpSpPr>
          <p:nvPr/>
        </p:nvGrpSpPr>
        <p:grpSpPr>
          <a:xfrm>
            <a:off x="2286000" y="354754"/>
            <a:ext cx="7113384" cy="6423660"/>
            <a:chOff x="2343028" y="-297389"/>
            <a:chExt cx="7923681" cy="7155389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CFF24C2-E95D-BE99-2F8F-81AE022590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64070" y="0"/>
              <a:ext cx="7463860" cy="6858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6E22BCF-70CE-490F-400D-A5794AAE62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92493" y="-34978"/>
              <a:ext cx="990600" cy="1285875"/>
            </a:xfrm>
            <a:prstGeom prst="rect">
              <a:avLst/>
            </a:prstGeom>
          </p:spPr>
        </p:pic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F54E14AF-760A-D8BE-0605-91FE13F95090}"/>
                </a:ext>
              </a:extLst>
            </p:cNvPr>
            <p:cNvCxnSpPr>
              <a:cxnSpLocks/>
            </p:cNvCxnSpPr>
            <p:nvPr/>
          </p:nvCxnSpPr>
          <p:spPr>
            <a:xfrm rot="1740000" flipV="1">
              <a:off x="6248137" y="-90297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D1E1983B-81F3-7358-51A8-B170A695237D}"/>
                </a:ext>
              </a:extLst>
            </p:cNvPr>
            <p:cNvCxnSpPr>
              <a:cxnSpLocks/>
            </p:cNvCxnSpPr>
            <p:nvPr/>
          </p:nvCxnSpPr>
          <p:spPr>
            <a:xfrm rot="1920000" flipV="1">
              <a:off x="6557331" y="-100368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6A6FA0F-B4C1-18DB-31A9-0917CFE6E721}"/>
                </a:ext>
              </a:extLst>
            </p:cNvPr>
            <p:cNvSpPr txBox="1"/>
            <p:nvPr/>
          </p:nvSpPr>
          <p:spPr>
            <a:xfrm>
              <a:off x="7523615" y="-9398"/>
              <a:ext cx="427116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35EA90C-19A0-F79A-684B-11F10C30A44A}"/>
                </a:ext>
              </a:extLst>
            </p:cNvPr>
            <p:cNvSpPr txBox="1"/>
            <p:nvPr/>
          </p:nvSpPr>
          <p:spPr>
            <a:xfrm>
              <a:off x="7249816" y="-127893"/>
              <a:ext cx="462828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3A619EC-D6A3-B6A6-5ECD-19B462879329}"/>
                </a:ext>
              </a:extLst>
            </p:cNvPr>
            <p:cNvCxnSpPr>
              <a:cxnSpLocks/>
            </p:cNvCxnSpPr>
            <p:nvPr/>
          </p:nvCxnSpPr>
          <p:spPr>
            <a:xfrm rot="2880000" flipV="1">
              <a:off x="6723656" y="-47101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3B4AE9B-2642-AC56-0EE2-73905A7DBDF0}"/>
                </a:ext>
              </a:extLst>
            </p:cNvPr>
            <p:cNvSpPr txBox="1"/>
            <p:nvPr/>
          </p:nvSpPr>
          <p:spPr>
            <a:xfrm>
              <a:off x="9196006" y="1426698"/>
              <a:ext cx="412831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il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AB4D8F4-F702-C2C6-34A4-780AB73E8F3D}"/>
                </a:ext>
              </a:extLst>
            </p:cNvPr>
            <p:cNvCxnSpPr>
              <a:cxnSpLocks/>
            </p:cNvCxnSpPr>
            <p:nvPr/>
          </p:nvCxnSpPr>
          <p:spPr>
            <a:xfrm rot="2220000" flipV="1">
              <a:off x="7355241" y="60165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27AA9CF-FAD2-1DA9-23AF-F186208136CE}"/>
                </a:ext>
              </a:extLst>
            </p:cNvPr>
            <p:cNvSpPr txBox="1"/>
            <p:nvPr/>
          </p:nvSpPr>
          <p:spPr>
            <a:xfrm>
              <a:off x="9348975" y="1623473"/>
              <a:ext cx="355692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4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394951F1-7A01-90BA-1C88-AC1AEC91F869}"/>
                </a:ext>
              </a:extLst>
            </p:cNvPr>
            <p:cNvCxnSpPr>
              <a:cxnSpLocks/>
            </p:cNvCxnSpPr>
            <p:nvPr/>
          </p:nvCxnSpPr>
          <p:spPr>
            <a:xfrm rot="2220000" flipV="1">
              <a:off x="7589294" y="139552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175B2451-5463-2C16-DA84-24614C8CA6CB}"/>
                </a:ext>
              </a:extLst>
            </p:cNvPr>
            <p:cNvSpPr txBox="1"/>
            <p:nvPr/>
          </p:nvSpPr>
          <p:spPr>
            <a:xfrm>
              <a:off x="9090223" y="1256809"/>
              <a:ext cx="448543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L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0D2B90C1-4F92-B3B0-783C-65E64917DA3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348125" y="30966"/>
              <a:ext cx="84620" cy="844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B730710-BE66-8D14-EBC5-BBE0197A54D3}"/>
                </a:ext>
              </a:extLst>
            </p:cNvPr>
            <p:cNvSpPr txBox="1"/>
            <p:nvPr/>
          </p:nvSpPr>
          <p:spPr>
            <a:xfrm>
              <a:off x="5048839" y="-110308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T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9AB6E63D-E203-6BBF-501B-211658907A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64715" y="22300"/>
              <a:ext cx="0" cy="8494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75FC3C5-4273-9B37-0D2F-27130A301AF1}"/>
                </a:ext>
              </a:extLst>
            </p:cNvPr>
            <p:cNvSpPr txBox="1"/>
            <p:nvPr/>
          </p:nvSpPr>
          <p:spPr>
            <a:xfrm>
              <a:off x="5290454" y="-167544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N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726450B-62EF-88BE-68C8-EEDFA09B8BE0}"/>
                </a:ext>
              </a:extLst>
            </p:cNvPr>
            <p:cNvSpPr txBox="1"/>
            <p:nvPr/>
          </p:nvSpPr>
          <p:spPr>
            <a:xfrm>
              <a:off x="6003152" y="-276038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dg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EDE6B8D-E2B9-B921-791D-6FBE7C1B9618}"/>
                </a:ext>
              </a:extLst>
            </p:cNvPr>
            <p:cNvSpPr txBox="1"/>
            <p:nvPr/>
          </p:nvSpPr>
          <p:spPr>
            <a:xfrm>
              <a:off x="6402383" y="-297389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pf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E69D234B-AD34-CE7D-D7E4-BCC898BFE5D2}"/>
                </a:ext>
              </a:extLst>
            </p:cNvPr>
            <p:cNvCxnSpPr>
              <a:cxnSpLocks/>
            </p:cNvCxnSpPr>
            <p:nvPr/>
          </p:nvCxnSpPr>
          <p:spPr>
            <a:xfrm rot="2880000" flipV="1">
              <a:off x="7016622" y="-2307"/>
              <a:ext cx="0" cy="12937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B6691EB-08C6-E678-8577-9FAAF2E744A9}"/>
                </a:ext>
              </a:extLst>
            </p:cNvPr>
            <p:cNvSpPr txBox="1"/>
            <p:nvPr/>
          </p:nvSpPr>
          <p:spPr>
            <a:xfrm>
              <a:off x="6678759" y="-209888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f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A8CDA04-F4C8-290C-4DFD-8F02C6F80809}"/>
                </a:ext>
              </a:extLst>
            </p:cNvPr>
            <p:cNvSpPr txBox="1"/>
            <p:nvPr/>
          </p:nvSpPr>
          <p:spPr>
            <a:xfrm>
              <a:off x="6960626" y="-176331"/>
              <a:ext cx="561429" cy="257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56495AED-9A25-EF0D-5D80-38ED87BDFFB6}"/>
                </a:ext>
              </a:extLst>
            </p:cNvPr>
            <p:cNvCxnSpPr>
              <a:cxnSpLocks/>
            </p:cNvCxnSpPr>
            <p:nvPr/>
          </p:nvCxnSpPr>
          <p:spPr>
            <a:xfrm>
              <a:off x="9027524" y="1385142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84668E9F-5069-0FCC-5CE0-D1D0D576ADAC}"/>
                </a:ext>
              </a:extLst>
            </p:cNvPr>
            <p:cNvCxnSpPr>
              <a:cxnSpLocks/>
            </p:cNvCxnSpPr>
            <p:nvPr/>
          </p:nvCxnSpPr>
          <p:spPr>
            <a:xfrm>
              <a:off x="9135319" y="1538287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054C4E53-A75D-8464-900C-7D99B70A3DCE}"/>
                </a:ext>
              </a:extLst>
            </p:cNvPr>
            <p:cNvCxnSpPr>
              <a:cxnSpLocks/>
            </p:cNvCxnSpPr>
            <p:nvPr/>
          </p:nvCxnSpPr>
          <p:spPr>
            <a:xfrm>
              <a:off x="9433343" y="2096591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11258CC3-C031-1947-37EB-60CA0B37A08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18062" y="1768252"/>
              <a:ext cx="115281" cy="9457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6F9DCE38-222D-96E6-875F-D3C13C45A8FF}"/>
                </a:ext>
              </a:extLst>
            </p:cNvPr>
            <p:cNvCxnSpPr>
              <a:cxnSpLocks/>
            </p:cNvCxnSpPr>
            <p:nvPr/>
          </p:nvCxnSpPr>
          <p:spPr>
            <a:xfrm>
              <a:off x="9338438" y="1915198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AD23DEC-1CCF-EF76-86F9-C7B0A0E15F64}"/>
                </a:ext>
              </a:extLst>
            </p:cNvPr>
            <p:cNvSpPr txBox="1"/>
            <p:nvPr/>
          </p:nvSpPr>
          <p:spPr>
            <a:xfrm>
              <a:off x="9402364" y="1787552"/>
              <a:ext cx="598535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4-a1bi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CFAFB7F-0C27-AB57-1D88-FA4A38FFA393}"/>
                </a:ext>
              </a:extLst>
            </p:cNvPr>
            <p:cNvSpPr txBox="1"/>
            <p:nvPr/>
          </p:nvSpPr>
          <p:spPr>
            <a:xfrm>
              <a:off x="9488495" y="1962027"/>
              <a:ext cx="405689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fg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6B5FFFC-5268-A7F7-5934-AD667688C3A8}"/>
                </a:ext>
              </a:extLst>
            </p:cNvPr>
            <p:cNvSpPr txBox="1"/>
            <p:nvPr/>
          </p:nvSpPr>
          <p:spPr>
            <a:xfrm>
              <a:off x="9542962" y="2108415"/>
              <a:ext cx="512825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mg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B941172C-7A8C-6844-C3C2-D41AAC328D19}"/>
                </a:ext>
              </a:extLst>
            </p:cNvPr>
            <p:cNvCxnSpPr>
              <a:cxnSpLocks/>
            </p:cNvCxnSpPr>
            <p:nvPr/>
          </p:nvCxnSpPr>
          <p:spPr>
            <a:xfrm>
              <a:off x="9481677" y="2235610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B6D84285-24D7-B63E-B6A4-41ECE7CB6E44}"/>
                </a:ext>
              </a:extLst>
            </p:cNvPr>
            <p:cNvCxnSpPr>
              <a:cxnSpLocks/>
            </p:cNvCxnSpPr>
            <p:nvPr/>
          </p:nvCxnSpPr>
          <p:spPr>
            <a:xfrm>
              <a:off x="9701444" y="3396080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id="{45B56F01-824C-6343-552D-C765747C11A3}"/>
                </a:ext>
              </a:extLst>
            </p:cNvPr>
            <p:cNvCxnSpPr>
              <a:cxnSpLocks/>
            </p:cNvCxnSpPr>
            <p:nvPr/>
          </p:nvCxnSpPr>
          <p:spPr>
            <a:xfrm>
              <a:off x="9170763" y="5216703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CA22C910-ADC1-5F48-22EC-05A428114D81}"/>
                </a:ext>
              </a:extLst>
            </p:cNvPr>
            <p:cNvCxnSpPr>
              <a:cxnSpLocks/>
            </p:cNvCxnSpPr>
            <p:nvPr/>
          </p:nvCxnSpPr>
          <p:spPr>
            <a:xfrm>
              <a:off x="9052767" y="5404304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F14C52C-8D4D-0D3E-1090-B3A78B21950B}"/>
                </a:ext>
              </a:extLst>
            </p:cNvPr>
            <p:cNvSpPr txBox="1"/>
            <p:nvPr/>
          </p:nvSpPr>
          <p:spPr>
            <a:xfrm>
              <a:off x="9761027" y="3262824"/>
              <a:ext cx="505682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mg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110F881-0F59-4034-53AC-E5753467DB95}"/>
                </a:ext>
              </a:extLst>
            </p:cNvPr>
            <p:cNvSpPr txBox="1"/>
            <p:nvPr/>
          </p:nvSpPr>
          <p:spPr>
            <a:xfrm>
              <a:off x="9222554" y="5068459"/>
              <a:ext cx="369977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in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7ECE317-A001-D71B-7DDC-269BC2544F2C}"/>
                </a:ext>
              </a:extLst>
            </p:cNvPr>
            <p:cNvSpPr txBox="1"/>
            <p:nvPr/>
          </p:nvSpPr>
          <p:spPr>
            <a:xfrm>
              <a:off x="9092165" y="5267543"/>
              <a:ext cx="441401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yd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D71B1F9-B9AB-5ECB-2D2F-91858655CD68}"/>
                </a:ext>
              </a:extLst>
            </p:cNvPr>
            <p:cNvSpPr txBox="1"/>
            <p:nvPr/>
          </p:nvSpPr>
          <p:spPr>
            <a:xfrm>
              <a:off x="8689048" y="5754524"/>
              <a:ext cx="462828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d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3672256B-714D-E598-935D-B3D48D1CB072}"/>
                </a:ext>
              </a:extLst>
            </p:cNvPr>
            <p:cNvCxnSpPr>
              <a:cxnSpLocks/>
            </p:cNvCxnSpPr>
            <p:nvPr/>
          </p:nvCxnSpPr>
          <p:spPr>
            <a:xfrm>
              <a:off x="7606548" y="6553254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DD25ED55-727E-120D-41E9-2A0A74784617}"/>
                </a:ext>
              </a:extLst>
            </p:cNvPr>
            <p:cNvCxnSpPr>
              <a:cxnSpLocks/>
            </p:cNvCxnSpPr>
            <p:nvPr/>
          </p:nvCxnSpPr>
          <p:spPr>
            <a:xfrm>
              <a:off x="8629788" y="5888521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3E76E4EC-B0B4-1FB3-9E23-0485D43C6293}"/>
                </a:ext>
              </a:extLst>
            </p:cNvPr>
            <p:cNvCxnSpPr>
              <a:cxnSpLocks/>
            </p:cNvCxnSpPr>
            <p:nvPr/>
          </p:nvCxnSpPr>
          <p:spPr>
            <a:xfrm>
              <a:off x="7841846" y="6428983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A7D3F2F-7EC1-A031-084F-4BF2F2F970F4}"/>
                </a:ext>
              </a:extLst>
            </p:cNvPr>
            <p:cNvSpPr txBox="1"/>
            <p:nvPr/>
          </p:nvSpPr>
          <p:spPr>
            <a:xfrm>
              <a:off x="7896489" y="6277493"/>
              <a:ext cx="391404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jjJ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4320C264-DF2B-C71A-16E4-83E678E11600}"/>
                </a:ext>
              </a:extLst>
            </p:cNvPr>
            <p:cNvCxnSpPr>
              <a:cxnSpLocks/>
            </p:cNvCxnSpPr>
            <p:nvPr/>
          </p:nvCxnSpPr>
          <p:spPr>
            <a:xfrm>
              <a:off x="7426084" y="6620904"/>
              <a:ext cx="119974" cy="519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A56AE63-BAFF-3D9C-F998-88F2FBCC1073}"/>
                </a:ext>
              </a:extLst>
            </p:cNvPr>
            <p:cNvSpPr txBox="1"/>
            <p:nvPr/>
          </p:nvSpPr>
          <p:spPr>
            <a:xfrm>
              <a:off x="7660838" y="6414175"/>
              <a:ext cx="434258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a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B566D5A-4DC8-5FBE-3E6E-FC29D2320E00}"/>
                </a:ext>
              </a:extLst>
            </p:cNvPr>
            <p:cNvSpPr txBox="1"/>
            <p:nvPr/>
          </p:nvSpPr>
          <p:spPr>
            <a:xfrm>
              <a:off x="7458193" y="6534801"/>
              <a:ext cx="369977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s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9BE7A71-13FB-C3D1-A780-36BB4AF4E4B1}"/>
                </a:ext>
              </a:extLst>
            </p:cNvPr>
            <p:cNvSpPr txBox="1"/>
            <p:nvPr/>
          </p:nvSpPr>
          <p:spPr>
            <a:xfrm>
              <a:off x="2866722" y="4837626"/>
              <a:ext cx="355692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4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19CF1BF1-1DAD-A09E-DB68-108EB9337959}"/>
                </a:ext>
              </a:extLst>
            </p:cNvPr>
            <p:cNvCxnSpPr>
              <a:cxnSpLocks/>
            </p:cNvCxnSpPr>
            <p:nvPr/>
          </p:nvCxnSpPr>
          <p:spPr>
            <a:xfrm>
              <a:off x="2778655" y="3586904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FAA766F7-116A-5CC4-A289-BA51EFF2C10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5723" y="4800553"/>
              <a:ext cx="94252" cy="1327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5A9E7A14-44C7-FECE-C553-01CA3025E0C5}"/>
                </a:ext>
              </a:extLst>
            </p:cNvPr>
            <p:cNvCxnSpPr>
              <a:cxnSpLocks/>
            </p:cNvCxnSpPr>
            <p:nvPr/>
          </p:nvCxnSpPr>
          <p:spPr>
            <a:xfrm>
              <a:off x="3064103" y="4764870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380023C7-914C-A6AD-50BA-A83999025878}"/>
                </a:ext>
              </a:extLst>
            </p:cNvPr>
            <p:cNvSpPr txBox="1"/>
            <p:nvPr/>
          </p:nvSpPr>
          <p:spPr>
            <a:xfrm>
              <a:off x="2735386" y="4640534"/>
              <a:ext cx="427116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rK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A60197B4-FB28-8F19-E914-CE809665B171}"/>
                </a:ext>
              </a:extLst>
            </p:cNvPr>
            <p:cNvSpPr txBox="1"/>
            <p:nvPr/>
          </p:nvSpPr>
          <p:spPr>
            <a:xfrm>
              <a:off x="2343028" y="3440086"/>
              <a:ext cx="519967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1E4C35FE-6657-A508-FC3D-7C96C542F747}"/>
                </a:ext>
              </a:extLst>
            </p:cNvPr>
            <p:cNvCxnSpPr>
              <a:cxnSpLocks/>
            </p:cNvCxnSpPr>
            <p:nvPr/>
          </p:nvCxnSpPr>
          <p:spPr>
            <a:xfrm>
              <a:off x="2790558" y="3801751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19CEF0B-975D-A1AD-1882-EB20BB430F80}"/>
                </a:ext>
              </a:extLst>
            </p:cNvPr>
            <p:cNvSpPr txBox="1"/>
            <p:nvPr/>
          </p:nvSpPr>
          <p:spPr>
            <a:xfrm>
              <a:off x="2406056" y="3663938"/>
              <a:ext cx="469970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dc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E3F53D1E-FBF5-0918-9AB5-B52291A2EF56}"/>
                </a:ext>
              </a:extLst>
            </p:cNvPr>
            <p:cNvCxnSpPr>
              <a:cxnSpLocks/>
            </p:cNvCxnSpPr>
            <p:nvPr/>
          </p:nvCxnSpPr>
          <p:spPr>
            <a:xfrm>
              <a:off x="2782428" y="3150524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6D49CCBA-D482-BF74-5710-A0698310AE29}"/>
                </a:ext>
              </a:extLst>
            </p:cNvPr>
            <p:cNvSpPr txBox="1"/>
            <p:nvPr/>
          </p:nvSpPr>
          <p:spPr>
            <a:xfrm>
              <a:off x="4337248" y="133368"/>
              <a:ext cx="477113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na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20174422-F2C4-C96A-F421-B412A6A2D2B1}"/>
                </a:ext>
              </a:extLst>
            </p:cNvPr>
            <p:cNvCxnSpPr>
              <a:cxnSpLocks/>
            </p:cNvCxnSpPr>
            <p:nvPr/>
          </p:nvCxnSpPr>
          <p:spPr>
            <a:xfrm>
              <a:off x="4710275" y="262052"/>
              <a:ext cx="119790" cy="8976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34631C6-4E1C-2E08-4289-EC4EBE1965BA}"/>
                </a:ext>
              </a:extLst>
            </p:cNvPr>
            <p:cNvSpPr txBox="1"/>
            <p:nvPr/>
          </p:nvSpPr>
          <p:spPr>
            <a:xfrm>
              <a:off x="2363987" y="3010887"/>
              <a:ext cx="505682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mgV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8DA42A93-C2B9-49C0-3D24-7440505C57CD}"/>
                </a:ext>
              </a:extLst>
            </p:cNvPr>
            <p:cNvCxnSpPr>
              <a:cxnSpLocks/>
            </p:cNvCxnSpPr>
            <p:nvPr/>
          </p:nvCxnSpPr>
          <p:spPr>
            <a:xfrm>
              <a:off x="2814500" y="2862086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3CE18AD-ECCE-52D7-FDC1-BA3BAEF08EEB}"/>
                </a:ext>
              </a:extLst>
            </p:cNvPr>
            <p:cNvSpPr txBox="1"/>
            <p:nvPr/>
          </p:nvSpPr>
          <p:spPr>
            <a:xfrm>
              <a:off x="2373180" y="2722626"/>
              <a:ext cx="527110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mc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ACB1B20F-46B7-9FE8-25A4-7BF578CFA894}"/>
                </a:ext>
              </a:extLst>
            </p:cNvPr>
            <p:cNvCxnSpPr>
              <a:cxnSpLocks/>
            </p:cNvCxnSpPr>
            <p:nvPr/>
          </p:nvCxnSpPr>
          <p:spPr>
            <a:xfrm>
              <a:off x="3234546" y="1705048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182028F4-0A32-A577-C872-4C0B08064389}"/>
                </a:ext>
              </a:extLst>
            </p:cNvPr>
            <p:cNvCxnSpPr>
              <a:cxnSpLocks/>
            </p:cNvCxnSpPr>
            <p:nvPr/>
          </p:nvCxnSpPr>
          <p:spPr>
            <a:xfrm>
              <a:off x="3158617" y="1835267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0839FD6-1BD9-6F36-C5AC-B6EC1858E03C}"/>
                </a:ext>
              </a:extLst>
            </p:cNvPr>
            <p:cNvSpPr txBox="1"/>
            <p:nvPr/>
          </p:nvSpPr>
          <p:spPr>
            <a:xfrm>
              <a:off x="2849038" y="1553801"/>
              <a:ext cx="477113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ph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81A8520-C99B-D42A-3218-070B90D8521D}"/>
                </a:ext>
              </a:extLst>
            </p:cNvPr>
            <p:cNvSpPr txBox="1"/>
            <p:nvPr/>
          </p:nvSpPr>
          <p:spPr>
            <a:xfrm>
              <a:off x="2728862" y="1682451"/>
              <a:ext cx="519967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mgQ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9" name="Straight Connector 78">
              <a:extLst>
                <a:ext uri="{FF2B5EF4-FFF2-40B4-BE49-F238E27FC236}">
                  <a16:creationId xmlns:a16="http://schemas.microsoft.com/office/drawing/2014/main" id="{020C0DFF-4109-83C4-B843-42FD3E0304E1}"/>
                </a:ext>
              </a:extLst>
            </p:cNvPr>
            <p:cNvCxnSpPr>
              <a:cxnSpLocks/>
            </p:cNvCxnSpPr>
            <p:nvPr/>
          </p:nvCxnSpPr>
          <p:spPr>
            <a:xfrm>
              <a:off x="4907277" y="178045"/>
              <a:ext cx="119790" cy="8976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1B2A57DE-F3FF-787C-1ECE-834E6F992CFC}"/>
                </a:ext>
              </a:extLst>
            </p:cNvPr>
            <p:cNvSpPr txBox="1"/>
            <p:nvPr/>
          </p:nvSpPr>
          <p:spPr>
            <a:xfrm>
              <a:off x="4651950" y="-17025"/>
              <a:ext cx="398546" cy="2571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ED55D44C-C657-4E27-EE3B-A64EF5DC8A2F}"/>
                </a:ext>
              </a:extLst>
            </p:cNvPr>
            <p:cNvSpPr txBox="1"/>
            <p:nvPr/>
          </p:nvSpPr>
          <p:spPr>
            <a:xfrm>
              <a:off x="5516615" y="2815876"/>
              <a:ext cx="1262780" cy="10285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15-3</a:t>
              </a:r>
            </a:p>
            <a:p>
              <a:pPr algn="ctr"/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Y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7,943 bp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B880D21D-4F08-ED68-2104-6E4F29E0E596}"/>
              </a:ext>
            </a:extLst>
          </p:cNvPr>
          <p:cNvSpPr txBox="1"/>
          <p:nvPr/>
        </p:nvSpPr>
        <p:spPr>
          <a:xfrm>
            <a:off x="-270" y="0"/>
            <a:ext cx="4958058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visualization of plasmid pEC15-3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4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80604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138790D0-2A8B-AA18-8433-B1CA58C8905D}"/>
              </a:ext>
            </a:extLst>
          </p:cNvPr>
          <p:cNvGrpSpPr>
            <a:grpSpLocks noChangeAspect="1"/>
          </p:cNvGrpSpPr>
          <p:nvPr/>
        </p:nvGrpSpPr>
        <p:grpSpPr>
          <a:xfrm>
            <a:off x="2286000" y="381388"/>
            <a:ext cx="7198015" cy="6403345"/>
            <a:chOff x="2111441" y="-138651"/>
            <a:chExt cx="7873766" cy="7004492"/>
          </a:xfrm>
        </p:grpSpPr>
        <p:pic>
          <p:nvPicPr>
            <p:cNvPr id="82" name="Picture 81">
              <a:extLst>
                <a:ext uri="{FF2B5EF4-FFF2-40B4-BE49-F238E27FC236}">
                  <a16:creationId xmlns:a16="http://schemas.microsoft.com/office/drawing/2014/main" id="{0752A52B-6490-2EE8-5D99-B09F6E21217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603734" y="0"/>
              <a:ext cx="6984531" cy="6858000"/>
            </a:xfrm>
            <a:prstGeom prst="rect">
              <a:avLst/>
            </a:prstGeom>
          </p:spPr>
        </p:pic>
        <p:pic>
          <p:nvPicPr>
            <p:cNvPr id="84" name="Picture 83">
              <a:extLst>
                <a:ext uri="{FF2B5EF4-FFF2-40B4-BE49-F238E27FC236}">
                  <a16:creationId xmlns:a16="http://schemas.microsoft.com/office/drawing/2014/main" id="{F6F1CF95-A323-48DA-7D04-3EDAF31DFC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94607" y="430041"/>
              <a:ext cx="990600" cy="1104900"/>
            </a:xfrm>
            <a:prstGeom prst="rect">
              <a:avLst/>
            </a:prstGeom>
          </p:spPr>
        </p:pic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E62F407E-A192-D2F7-0035-5AFB9DAF7DA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97739" y="3523"/>
              <a:ext cx="165746" cy="250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id="{3722A452-FF26-33F1-F51A-C072F6D5468A}"/>
                </a:ext>
              </a:extLst>
            </p:cNvPr>
            <p:cNvCxnSpPr>
              <a:cxnSpLocks/>
            </p:cNvCxnSpPr>
            <p:nvPr/>
          </p:nvCxnSpPr>
          <p:spPr>
            <a:xfrm>
              <a:off x="2526580" y="3776262"/>
              <a:ext cx="143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243444F8-E628-47E6-8070-586976E89644}"/>
                </a:ext>
              </a:extLst>
            </p:cNvPr>
            <p:cNvSpPr txBox="1"/>
            <p:nvPr/>
          </p:nvSpPr>
          <p:spPr>
            <a:xfrm>
              <a:off x="6496214" y="-138651"/>
              <a:ext cx="559565" cy="252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po0C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ABF65105-53ED-2021-EB61-B5FB1861485E}"/>
                </a:ext>
              </a:extLst>
            </p:cNvPr>
            <p:cNvSpPr txBox="1"/>
            <p:nvPr/>
          </p:nvSpPr>
          <p:spPr>
            <a:xfrm>
              <a:off x="2111441" y="3650011"/>
              <a:ext cx="540430" cy="252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ob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FDD98808-7265-364F-D8F8-DDAFAFB8B4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994607" y="1604407"/>
              <a:ext cx="104514" cy="7506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BC5E915-D1DC-5237-5736-589903FCDE10}"/>
                </a:ext>
              </a:extLst>
            </p:cNvPr>
            <p:cNvSpPr txBox="1"/>
            <p:nvPr/>
          </p:nvSpPr>
          <p:spPr>
            <a:xfrm>
              <a:off x="9024550" y="1465474"/>
              <a:ext cx="426449" cy="252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si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5FDD62DD-FE66-63BD-67A0-1257824636CB}"/>
                </a:ext>
              </a:extLst>
            </p:cNvPr>
            <p:cNvSpPr txBox="1"/>
            <p:nvPr/>
          </p:nvSpPr>
          <p:spPr>
            <a:xfrm>
              <a:off x="7424917" y="6577667"/>
              <a:ext cx="475547" cy="252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nd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F107A809-11D0-4B0F-FFCC-A5E03D427252}"/>
                </a:ext>
              </a:extLst>
            </p:cNvPr>
            <p:cNvCxnSpPr>
              <a:cxnSpLocks/>
            </p:cNvCxnSpPr>
            <p:nvPr/>
          </p:nvCxnSpPr>
          <p:spPr>
            <a:xfrm>
              <a:off x="7519666" y="6520397"/>
              <a:ext cx="70415" cy="1272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662B37FB-0FF5-0464-2E4A-A3FA74918DF8}"/>
                </a:ext>
              </a:extLst>
            </p:cNvPr>
            <p:cNvSpPr txBox="1"/>
            <p:nvPr/>
          </p:nvSpPr>
          <p:spPr>
            <a:xfrm>
              <a:off x="4567291" y="6613338"/>
              <a:ext cx="559716" cy="25250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Ror2</a:t>
              </a:r>
            </a:p>
          </p:txBody>
        </p: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091AC3CE-567A-AA4B-06C7-2931592D3E3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021317" y="6709589"/>
              <a:ext cx="228101" cy="3805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4A175137-6732-3CBB-9AC1-930FAC7B8204}"/>
                </a:ext>
              </a:extLst>
            </p:cNvPr>
            <p:cNvSpPr txBox="1"/>
            <p:nvPr/>
          </p:nvSpPr>
          <p:spPr>
            <a:xfrm>
              <a:off x="5527969" y="2815876"/>
              <a:ext cx="1240072" cy="7070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15-4</a:t>
              </a: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,743 bp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E25166D7-E8E2-E1E3-1B9A-B8EABC14BFE9}"/>
              </a:ext>
            </a:extLst>
          </p:cNvPr>
          <p:cNvSpPr txBox="1"/>
          <p:nvPr/>
        </p:nvSpPr>
        <p:spPr>
          <a:xfrm>
            <a:off x="-270" y="0"/>
            <a:ext cx="494641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visualization of plasmid pEC15-4.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4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9723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>
            <a:extLst>
              <a:ext uri="{FF2B5EF4-FFF2-40B4-BE49-F238E27FC236}">
                <a16:creationId xmlns:a16="http://schemas.microsoft.com/office/drawing/2014/main" id="{87D3D146-6F10-F2A4-D7EE-F9DA889DB1DE}"/>
              </a:ext>
            </a:extLst>
          </p:cNvPr>
          <p:cNvGrpSpPr/>
          <p:nvPr/>
        </p:nvGrpSpPr>
        <p:grpSpPr>
          <a:xfrm>
            <a:off x="2286000" y="381388"/>
            <a:ext cx="7086228" cy="6400800"/>
            <a:chOff x="2519562" y="0"/>
            <a:chExt cx="7086228" cy="6400800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432AD02B-C657-D273-E6C6-D651DA6ACF65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519562" y="0"/>
              <a:ext cx="7086228" cy="6400800"/>
              <a:chOff x="2519561" y="0"/>
              <a:chExt cx="7592387" cy="685800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B0352F3-1200-4CF0-4E3C-4E42EF2534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519561" y="0"/>
                <a:ext cx="7152877" cy="6858000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C52EBA1D-769C-D8A1-D6CF-3D435986465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814677" y="108560"/>
                <a:ext cx="1028700" cy="1257300"/>
              </a:xfrm>
              <a:prstGeom prst="rect">
                <a:avLst/>
              </a:prstGeom>
            </p:spPr>
          </p:pic>
          <p:cxnSp>
            <p:nvCxnSpPr>
              <p:cNvPr id="6" name="Straight Connector 5">
                <a:extLst>
                  <a:ext uri="{FF2B5EF4-FFF2-40B4-BE49-F238E27FC236}">
                    <a16:creationId xmlns:a16="http://schemas.microsoft.com/office/drawing/2014/main" id="{E78C1E32-1FAE-A536-908D-AB0DE12310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46849" y="1231430"/>
                <a:ext cx="143239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941F3DD-4F33-8214-6E8F-7F676B00EE8D}"/>
                  </a:ext>
                </a:extLst>
              </p:cNvPr>
              <p:cNvSpPr txBox="1"/>
              <p:nvPr/>
            </p:nvSpPr>
            <p:spPr>
              <a:xfrm>
                <a:off x="3053087" y="1108220"/>
                <a:ext cx="527506" cy="247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NAI</a:t>
                </a:r>
              </a:p>
            </p:txBody>
          </p:sp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id="{47C26FA5-9724-3195-7D13-7C395929D14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223203" y="150607"/>
                <a:ext cx="134258" cy="4155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10269AE-91FD-BC61-A3BF-C4A59EADF70D}"/>
                  </a:ext>
                </a:extLst>
              </p:cNvPr>
              <p:cNvSpPr txBox="1"/>
              <p:nvPr/>
            </p:nvSpPr>
            <p:spPr>
              <a:xfrm>
                <a:off x="7272402" y="17930"/>
                <a:ext cx="470000" cy="247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p</a:t>
                </a:r>
                <a:endPara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AEF24A2E-EE82-76BE-731A-003A11CE98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8292353" y="724348"/>
                <a:ext cx="134258" cy="4155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53F0AF6-6D00-D4C2-38D4-5F908AAF382C}"/>
                  </a:ext>
                </a:extLst>
              </p:cNvPr>
              <p:cNvSpPr txBox="1"/>
              <p:nvPr/>
            </p:nvSpPr>
            <p:spPr>
              <a:xfrm>
                <a:off x="8336181" y="583439"/>
                <a:ext cx="501303" cy="247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bC</a:t>
                </a:r>
                <a:endPara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8355FC49-22F3-F357-9D6C-27EA2A5068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554836" y="3244003"/>
                <a:ext cx="13881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C610DD0-7F3F-9382-479E-44FA564F23E7}"/>
                  </a:ext>
                </a:extLst>
              </p:cNvPr>
              <p:cNvSpPr txBox="1"/>
              <p:nvPr/>
            </p:nvSpPr>
            <p:spPr>
              <a:xfrm>
                <a:off x="9608377" y="3106616"/>
                <a:ext cx="503571" cy="247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beA</a:t>
                </a:r>
                <a:endPara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A2B93188-3B28-A0B7-1402-9D5C88BE3B3A}"/>
                  </a:ext>
                </a:extLst>
              </p:cNvPr>
              <p:cNvSpPr txBox="1"/>
              <p:nvPr/>
            </p:nvSpPr>
            <p:spPr>
              <a:xfrm>
                <a:off x="5581915" y="2815876"/>
                <a:ext cx="1132180" cy="692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C15-5</a:t>
                </a:r>
              </a:p>
              <a:p>
                <a:pPr algn="ctr"/>
                <a:r>
                  <a:rPr lang="en-US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,284 bp</a:t>
                </a:r>
              </a:p>
            </p:txBody>
          </p:sp>
        </p:grpSp>
        <p:cxnSp>
          <p:nvCxnSpPr>
            <p:cNvPr id="2" name="Straight Connector 1">
              <a:extLst>
                <a:ext uri="{FF2B5EF4-FFF2-40B4-BE49-F238E27FC236}">
                  <a16:creationId xmlns:a16="http://schemas.microsoft.com/office/drawing/2014/main" id="{7F297BEE-2E89-BEF1-D53A-FA3C325BAA90}"/>
                </a:ext>
              </a:extLst>
            </p:cNvPr>
            <p:cNvCxnSpPr>
              <a:cxnSpLocks/>
            </p:cNvCxnSpPr>
            <p:nvPr/>
          </p:nvCxnSpPr>
          <p:spPr>
            <a:xfrm>
              <a:off x="8950991" y="4225764"/>
              <a:ext cx="1388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8BE6723-13DA-6BCF-3849-1AEEB75C1DCE}"/>
                </a:ext>
              </a:extLst>
            </p:cNvPr>
            <p:cNvSpPr txBox="1"/>
            <p:nvPr/>
          </p:nvSpPr>
          <p:spPr>
            <a:xfrm>
              <a:off x="9004532" y="4106746"/>
              <a:ext cx="470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be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9FD11190-A485-B214-86D9-9FACC14B597F}"/>
              </a:ext>
            </a:extLst>
          </p:cNvPr>
          <p:cNvSpPr txBox="1"/>
          <p:nvPr/>
        </p:nvSpPr>
        <p:spPr>
          <a:xfrm>
            <a:off x="-270" y="0"/>
            <a:ext cx="5317994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visualization of plasmid pEC15-5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37293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8CA551D-6011-B4DF-9173-ACF55737457E}"/>
              </a:ext>
            </a:extLst>
          </p:cNvPr>
          <p:cNvGrpSpPr>
            <a:grpSpLocks noChangeAspect="1"/>
          </p:cNvGrpSpPr>
          <p:nvPr/>
        </p:nvGrpSpPr>
        <p:grpSpPr>
          <a:xfrm>
            <a:off x="2288514" y="386375"/>
            <a:ext cx="7293272" cy="6419939"/>
            <a:chOff x="2238026" y="-2845"/>
            <a:chExt cx="7952704" cy="700041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0461A4EA-6EB1-54E9-3282-B5CA653CD92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565650" y="0"/>
              <a:ext cx="7060700" cy="68580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DDDC6817-200C-CF25-2D0B-88B44DB1B10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71555" y="489457"/>
              <a:ext cx="1019175" cy="1266825"/>
            </a:xfrm>
            <a:prstGeom prst="rect">
              <a:avLst/>
            </a:prstGeom>
          </p:spPr>
        </p:pic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CB44D587-64E4-BE87-9135-4DA85AD68453}"/>
                </a:ext>
              </a:extLst>
            </p:cNvPr>
            <p:cNvCxnSpPr>
              <a:cxnSpLocks/>
            </p:cNvCxnSpPr>
            <p:nvPr/>
          </p:nvCxnSpPr>
          <p:spPr>
            <a:xfrm>
              <a:off x="9482098" y="3228418"/>
              <a:ext cx="1388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D4EF387-E8FB-8804-A06A-BDC359EDF376}"/>
                </a:ext>
              </a:extLst>
            </p:cNvPr>
            <p:cNvSpPr txBox="1"/>
            <p:nvPr/>
          </p:nvSpPr>
          <p:spPr>
            <a:xfrm>
              <a:off x="9529406" y="3084473"/>
              <a:ext cx="50925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tG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216E49C0-B0A3-A709-032D-802A98A1A7C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044742" y="112571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DA5CDC01-CA02-5989-4112-E48478305782}"/>
                </a:ext>
              </a:extLst>
            </p:cNvPr>
            <p:cNvSpPr txBox="1"/>
            <p:nvPr/>
          </p:nvSpPr>
          <p:spPr>
            <a:xfrm>
              <a:off x="9280136" y="4574921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sdR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1E7075A2-DC8F-DCED-70FE-E1ED5808B8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436010" y="929569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C53AAD7-9549-93BF-E91B-AD9D1E2BF63B}"/>
                </a:ext>
              </a:extLst>
            </p:cNvPr>
            <p:cNvSpPr txBox="1"/>
            <p:nvPr/>
          </p:nvSpPr>
          <p:spPr>
            <a:xfrm>
              <a:off x="8485806" y="786194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86DCDC89-344C-A3A4-0FDE-1C345EEBCBA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00325" y="4025979"/>
              <a:ext cx="140852" cy="8362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7028C3B-07A1-E0E7-E512-D3DAFA0BB0BE}"/>
                </a:ext>
              </a:extLst>
            </p:cNvPr>
            <p:cNvSpPr txBox="1"/>
            <p:nvPr/>
          </p:nvSpPr>
          <p:spPr>
            <a:xfrm>
              <a:off x="2365150" y="4253712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rx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44A58944-2303-1129-413C-DA06E67729B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600325" y="3928993"/>
              <a:ext cx="106218" cy="969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C5F704F3-1553-89DB-4638-DBB163EB2A87}"/>
                </a:ext>
              </a:extLst>
            </p:cNvPr>
            <p:cNvCxnSpPr>
              <a:cxnSpLocks/>
            </p:cNvCxnSpPr>
            <p:nvPr/>
          </p:nvCxnSpPr>
          <p:spPr>
            <a:xfrm>
              <a:off x="2565650" y="3845365"/>
              <a:ext cx="121433" cy="4849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49D38946-D354-98B8-3623-A620F2511691}"/>
                </a:ext>
              </a:extLst>
            </p:cNvPr>
            <p:cNvCxnSpPr>
              <a:cxnSpLocks/>
            </p:cNvCxnSpPr>
            <p:nvPr/>
          </p:nvCxnSpPr>
          <p:spPr>
            <a:xfrm>
              <a:off x="2565650" y="3918104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D00910A2-B96F-D2C8-7E56-530B5790D147}"/>
                </a:ext>
              </a:extLst>
            </p:cNvPr>
            <p:cNvCxnSpPr>
              <a:cxnSpLocks/>
            </p:cNvCxnSpPr>
            <p:nvPr/>
          </p:nvCxnSpPr>
          <p:spPr>
            <a:xfrm>
              <a:off x="2702488" y="4370977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02030D3D-2811-0F1F-F36D-7BDFCF86668B}"/>
                </a:ext>
              </a:extLst>
            </p:cNvPr>
            <p:cNvCxnSpPr>
              <a:cxnSpLocks/>
            </p:cNvCxnSpPr>
            <p:nvPr/>
          </p:nvCxnSpPr>
          <p:spPr>
            <a:xfrm>
              <a:off x="2763166" y="4541561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65F0EF2F-4332-C657-5270-D05CB4BE6789}"/>
                </a:ext>
              </a:extLst>
            </p:cNvPr>
            <p:cNvSpPr txBox="1"/>
            <p:nvPr/>
          </p:nvSpPr>
          <p:spPr>
            <a:xfrm>
              <a:off x="2240795" y="3791514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Y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F1ED9718-D7CE-6AC8-1AE8-9469DAA13DEB}"/>
                </a:ext>
              </a:extLst>
            </p:cNvPr>
            <p:cNvSpPr txBox="1"/>
            <p:nvPr/>
          </p:nvSpPr>
          <p:spPr>
            <a:xfrm>
              <a:off x="2282788" y="3910313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T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E4EB17F-B0BE-6EE5-E5D7-1333EA9DD698}"/>
                </a:ext>
              </a:extLst>
            </p:cNvPr>
            <p:cNvSpPr txBox="1"/>
            <p:nvPr/>
          </p:nvSpPr>
          <p:spPr>
            <a:xfrm>
              <a:off x="2295676" y="4025979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S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CF4525C9-6ECB-57B1-8249-069CFB26BADB}"/>
                </a:ext>
              </a:extLst>
            </p:cNvPr>
            <p:cNvSpPr txBox="1"/>
            <p:nvPr/>
          </p:nvSpPr>
          <p:spPr>
            <a:xfrm>
              <a:off x="2238026" y="3683383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nN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F83C560F-7EE3-76FB-6507-537DE36485F9}"/>
                </a:ext>
              </a:extLst>
            </p:cNvPr>
            <p:cNvSpPr txBox="1"/>
            <p:nvPr/>
          </p:nvSpPr>
          <p:spPr>
            <a:xfrm>
              <a:off x="7092934" y="-2845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BP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C64B06A7-47C4-3B78-6EEC-D8F194FF0C14}"/>
                </a:ext>
              </a:extLst>
            </p:cNvPr>
            <p:cNvCxnSpPr>
              <a:cxnSpLocks/>
            </p:cNvCxnSpPr>
            <p:nvPr/>
          </p:nvCxnSpPr>
          <p:spPr>
            <a:xfrm rot="-2100000" flipV="1">
              <a:off x="8497489" y="983252"/>
              <a:ext cx="91440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8D408B9-9714-B037-1FC6-4F605F7BC0E3}"/>
                </a:ext>
              </a:extLst>
            </p:cNvPr>
            <p:cNvSpPr txBox="1"/>
            <p:nvPr/>
          </p:nvSpPr>
          <p:spPr>
            <a:xfrm>
              <a:off x="8702159" y="1033770"/>
              <a:ext cx="519707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bp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id="{49BA1330-1FE1-C88E-F0D6-60DF5E27A01E}"/>
                </a:ext>
              </a:extLst>
            </p:cNvPr>
            <p:cNvCxnSpPr>
              <a:cxnSpLocks/>
            </p:cNvCxnSpPr>
            <p:nvPr/>
          </p:nvCxnSpPr>
          <p:spPr>
            <a:xfrm>
              <a:off x="9468395" y="3512564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id="{96C5D4FF-3960-BE7A-344A-A5F94FEC1347}"/>
                </a:ext>
              </a:extLst>
            </p:cNvPr>
            <p:cNvCxnSpPr>
              <a:cxnSpLocks/>
            </p:cNvCxnSpPr>
            <p:nvPr/>
          </p:nvCxnSpPr>
          <p:spPr>
            <a:xfrm>
              <a:off x="8643285" y="1176340"/>
              <a:ext cx="14222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>
              <a:extLst>
                <a:ext uri="{FF2B5EF4-FFF2-40B4-BE49-F238E27FC236}">
                  <a16:creationId xmlns:a16="http://schemas.microsoft.com/office/drawing/2014/main" id="{9022A662-4425-F71E-0C05-47A97A2D7A08}"/>
                </a:ext>
              </a:extLst>
            </p:cNvPr>
            <p:cNvCxnSpPr>
              <a:cxnSpLocks/>
            </p:cNvCxnSpPr>
            <p:nvPr/>
          </p:nvCxnSpPr>
          <p:spPr>
            <a:xfrm>
              <a:off x="8760720" y="1333426"/>
              <a:ext cx="14348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BA077A9-7AF1-51BB-29AA-E7B3AA54DA02}"/>
                </a:ext>
              </a:extLst>
            </p:cNvPr>
            <p:cNvSpPr txBox="1"/>
            <p:nvPr/>
          </p:nvSpPr>
          <p:spPr>
            <a:xfrm>
              <a:off x="8819111" y="1205020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pG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85A3D163-74CD-579D-531F-002CEEFF5D08}"/>
                </a:ext>
              </a:extLst>
            </p:cNvPr>
            <p:cNvCxnSpPr>
              <a:cxnSpLocks/>
            </p:cNvCxnSpPr>
            <p:nvPr/>
          </p:nvCxnSpPr>
          <p:spPr>
            <a:xfrm>
              <a:off x="9221867" y="4687970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AFD43A4-D8F9-1D31-45A2-DF301E659EDF}"/>
                </a:ext>
              </a:extLst>
            </p:cNvPr>
            <p:cNvSpPr txBox="1"/>
            <p:nvPr/>
          </p:nvSpPr>
          <p:spPr>
            <a:xfrm>
              <a:off x="9522352" y="3386756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pb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6A4BC552-AFF8-E96F-D580-12CF5C27F60C}"/>
                </a:ext>
              </a:extLst>
            </p:cNvPr>
            <p:cNvCxnSpPr>
              <a:cxnSpLocks/>
            </p:cNvCxnSpPr>
            <p:nvPr/>
          </p:nvCxnSpPr>
          <p:spPr>
            <a:xfrm>
              <a:off x="9462640" y="3696125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20158A9-E228-73AE-AD23-8EECB307E62F}"/>
                </a:ext>
              </a:extLst>
            </p:cNvPr>
            <p:cNvSpPr txBox="1"/>
            <p:nvPr/>
          </p:nvSpPr>
          <p:spPr>
            <a:xfrm>
              <a:off x="9504750" y="3551377"/>
              <a:ext cx="52352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37351097-9760-317B-8CAA-EDC709DDB885}"/>
                </a:ext>
              </a:extLst>
            </p:cNvPr>
            <p:cNvCxnSpPr>
              <a:cxnSpLocks/>
            </p:cNvCxnSpPr>
            <p:nvPr/>
          </p:nvCxnSpPr>
          <p:spPr>
            <a:xfrm>
              <a:off x="8757949" y="5494997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611F9C4-E1DA-6149-DDC1-DAE61E367A20}"/>
                </a:ext>
              </a:extLst>
            </p:cNvPr>
            <p:cNvSpPr txBox="1"/>
            <p:nvPr/>
          </p:nvSpPr>
          <p:spPr>
            <a:xfrm>
              <a:off x="8318325" y="5853681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9706104F-73E5-5C1B-FE1B-98D71AAB1F88}"/>
                </a:ext>
              </a:extLst>
            </p:cNvPr>
            <p:cNvCxnSpPr>
              <a:cxnSpLocks/>
            </p:cNvCxnSpPr>
            <p:nvPr/>
          </p:nvCxnSpPr>
          <p:spPr>
            <a:xfrm>
              <a:off x="8621776" y="5660385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6715CDD-1645-9A86-F358-EB0A4B1964B3}"/>
                </a:ext>
              </a:extLst>
            </p:cNvPr>
            <p:cNvSpPr txBox="1"/>
            <p:nvPr/>
          </p:nvSpPr>
          <p:spPr>
            <a:xfrm>
              <a:off x="8802877" y="5350495"/>
              <a:ext cx="529517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oxX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92202BDA-044A-2571-60FC-376571D311AD}"/>
                </a:ext>
              </a:extLst>
            </p:cNvPr>
            <p:cNvCxnSpPr>
              <a:cxnSpLocks/>
            </p:cNvCxnSpPr>
            <p:nvPr/>
          </p:nvCxnSpPr>
          <p:spPr>
            <a:xfrm>
              <a:off x="7867795" y="6295963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6E1537D-AC66-D24A-7930-7ABA3E5575EF}"/>
                </a:ext>
              </a:extLst>
            </p:cNvPr>
            <p:cNvSpPr txBox="1"/>
            <p:nvPr/>
          </p:nvSpPr>
          <p:spPr>
            <a:xfrm>
              <a:off x="8668741" y="5532368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nh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3FB70260-36B1-15F8-7695-1A62BC836D81}"/>
                </a:ext>
              </a:extLst>
            </p:cNvPr>
            <p:cNvCxnSpPr>
              <a:cxnSpLocks/>
            </p:cNvCxnSpPr>
            <p:nvPr/>
          </p:nvCxnSpPr>
          <p:spPr>
            <a:xfrm>
              <a:off x="8269577" y="6000381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3AFE10ED-6846-DB5B-5125-16BFAAF7CF22}"/>
                </a:ext>
              </a:extLst>
            </p:cNvPr>
            <p:cNvCxnSpPr>
              <a:cxnSpLocks/>
            </p:cNvCxnSpPr>
            <p:nvPr/>
          </p:nvCxnSpPr>
          <p:spPr>
            <a:xfrm>
              <a:off x="8135090" y="6113595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57D686E-D7FA-4399-5B02-229134024DD1}"/>
                </a:ext>
              </a:extLst>
            </p:cNvPr>
            <p:cNvSpPr txBox="1"/>
            <p:nvPr/>
          </p:nvSpPr>
          <p:spPr>
            <a:xfrm>
              <a:off x="7926863" y="6182446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ol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84ECDA9-E82B-00B5-3F0A-EF77C58076A7}"/>
                </a:ext>
              </a:extLst>
            </p:cNvPr>
            <p:cNvSpPr txBox="1"/>
            <p:nvPr/>
          </p:nvSpPr>
          <p:spPr>
            <a:xfrm>
              <a:off x="8186977" y="5987586"/>
              <a:ext cx="470000" cy="4027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naQ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08B97A71-02F6-ABD2-7613-0B83068F86EC}"/>
                </a:ext>
              </a:extLst>
            </p:cNvPr>
            <p:cNvSpPr txBox="1"/>
            <p:nvPr/>
          </p:nvSpPr>
          <p:spPr>
            <a:xfrm>
              <a:off x="6244935" y="6745862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m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9" name="Straight Connector 68">
              <a:extLst>
                <a:ext uri="{FF2B5EF4-FFF2-40B4-BE49-F238E27FC236}">
                  <a16:creationId xmlns:a16="http://schemas.microsoft.com/office/drawing/2014/main" id="{09CE50FD-3F8F-8E5C-87E3-FEE6B62CE275}"/>
                </a:ext>
              </a:extLst>
            </p:cNvPr>
            <p:cNvCxnSpPr>
              <a:cxnSpLocks/>
            </p:cNvCxnSpPr>
            <p:nvPr/>
          </p:nvCxnSpPr>
          <p:spPr>
            <a:xfrm>
              <a:off x="7265886" y="6588640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>
              <a:extLst>
                <a:ext uri="{FF2B5EF4-FFF2-40B4-BE49-F238E27FC236}">
                  <a16:creationId xmlns:a16="http://schemas.microsoft.com/office/drawing/2014/main" id="{01D88780-3FFD-C278-F566-395D6C7375C6}"/>
                </a:ext>
              </a:extLst>
            </p:cNvPr>
            <p:cNvCxnSpPr>
              <a:cxnSpLocks/>
            </p:cNvCxnSpPr>
            <p:nvPr/>
          </p:nvCxnSpPr>
          <p:spPr>
            <a:xfrm>
              <a:off x="7645256" y="6418411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4D38A83-B98D-4624-D31D-FD205FC6B8D4}"/>
                </a:ext>
              </a:extLst>
            </p:cNvPr>
            <p:cNvSpPr txBox="1"/>
            <p:nvPr/>
          </p:nvSpPr>
          <p:spPr>
            <a:xfrm>
              <a:off x="7699508" y="6302181"/>
              <a:ext cx="552718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yA2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61319EFE-32E2-D466-9963-893241D70C93}"/>
                </a:ext>
              </a:extLst>
            </p:cNvPr>
            <p:cNvCxnSpPr>
              <a:cxnSpLocks/>
            </p:cNvCxnSpPr>
            <p:nvPr/>
          </p:nvCxnSpPr>
          <p:spPr>
            <a:xfrm>
              <a:off x="6185191" y="6801408"/>
              <a:ext cx="135079" cy="4100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5F7A5260-1709-FA18-0D5F-AEEB3BC03DFC}"/>
                </a:ext>
              </a:extLst>
            </p:cNvPr>
            <p:cNvSpPr txBox="1"/>
            <p:nvPr/>
          </p:nvSpPr>
          <p:spPr>
            <a:xfrm>
              <a:off x="7318649" y="6467832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rd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601B7247-628C-1BB2-013E-1103A0B6FC18}"/>
                </a:ext>
              </a:extLst>
            </p:cNvPr>
            <p:cNvCxnSpPr>
              <a:cxnSpLocks/>
            </p:cNvCxnSpPr>
            <p:nvPr/>
          </p:nvCxnSpPr>
          <p:spPr>
            <a:xfrm>
              <a:off x="6910254" y="6698915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E4DDAFA4-8480-3E26-DB76-073752F28A05}"/>
                </a:ext>
              </a:extLst>
            </p:cNvPr>
            <p:cNvSpPr txBox="1"/>
            <p:nvPr/>
          </p:nvSpPr>
          <p:spPr>
            <a:xfrm>
              <a:off x="6962514" y="6574656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rd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79F3E67E-604F-91AD-D7CB-DE63D649CAF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25087" y="6721800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BAFF51C8-42BD-9FD1-7572-ED0F7D9A85B3}"/>
                </a:ext>
              </a:extLst>
            </p:cNvPr>
            <p:cNvSpPr txBox="1"/>
            <p:nvPr/>
          </p:nvSpPr>
          <p:spPr>
            <a:xfrm>
              <a:off x="4887012" y="6652756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3EA69A93-73BD-7A40-C243-BA6F6C1BDB2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396078" y="6430485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91B11858-3AE1-29CD-CE38-559A9973EC5D}"/>
                </a:ext>
              </a:extLst>
            </p:cNvPr>
            <p:cNvSpPr txBox="1"/>
            <p:nvPr/>
          </p:nvSpPr>
          <p:spPr>
            <a:xfrm>
              <a:off x="3054010" y="5606809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naE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309D6738-624F-2B18-3F43-D4FE60B640F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71391" y="6361966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95740A5-5F67-617A-B9A6-2180B55CE1BC}"/>
                </a:ext>
              </a:extLst>
            </p:cNvPr>
            <p:cNvSpPr txBox="1"/>
            <p:nvPr/>
          </p:nvSpPr>
          <p:spPr>
            <a:xfrm>
              <a:off x="4080966" y="6396336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c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DDEA5D08-57C3-F16D-69BC-C6B2F0F5379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69215" y="6303954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8729AEF1-7B2A-2723-FF10-F3C62F918D3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410170" y="5660385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5297AD7A-9778-0BAA-9E45-882069F77166}"/>
                </a:ext>
              </a:extLst>
            </p:cNvPr>
            <p:cNvSpPr txBox="1"/>
            <p:nvPr/>
          </p:nvSpPr>
          <p:spPr>
            <a:xfrm>
              <a:off x="3907363" y="6316578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p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9E8A04D2-EBEB-8C6A-3826-424726BEAAB6}"/>
                </a:ext>
              </a:extLst>
            </p:cNvPr>
            <p:cNvSpPr txBox="1"/>
            <p:nvPr/>
          </p:nvSpPr>
          <p:spPr>
            <a:xfrm>
              <a:off x="3894759" y="6226828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xni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8" name="Straight Connector 87">
              <a:extLst>
                <a:ext uri="{FF2B5EF4-FFF2-40B4-BE49-F238E27FC236}">
                  <a16:creationId xmlns:a16="http://schemas.microsoft.com/office/drawing/2014/main" id="{E9949595-6541-3B8F-2B19-7E757A7F43E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15762" y="5288042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2D065BDA-71F4-4FCD-105B-6B77E9EE21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948012" y="4993632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824BBADF-121E-85A7-B1B1-7B1F8F643DD8}"/>
                </a:ext>
              </a:extLst>
            </p:cNvPr>
            <p:cNvSpPr txBox="1"/>
            <p:nvPr/>
          </p:nvSpPr>
          <p:spPr>
            <a:xfrm>
              <a:off x="2769686" y="5231731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bS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F9405D02-0A71-9D04-627C-8618DF4D1918}"/>
                </a:ext>
              </a:extLst>
            </p:cNvPr>
            <p:cNvSpPr txBox="1"/>
            <p:nvPr/>
          </p:nvSpPr>
          <p:spPr>
            <a:xfrm>
              <a:off x="2599962" y="4929527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bT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601B83D-BCB2-141C-CCDF-85DD350658A1}"/>
                </a:ext>
              </a:extLst>
            </p:cNvPr>
            <p:cNvSpPr txBox="1"/>
            <p:nvPr/>
          </p:nvSpPr>
          <p:spPr>
            <a:xfrm>
              <a:off x="2451804" y="4426804"/>
              <a:ext cx="470000" cy="251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t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5BD2B6AC-1E6A-F7CA-5D13-F2A055445EC5}"/>
                </a:ext>
              </a:extLst>
            </p:cNvPr>
            <p:cNvSpPr txBox="1"/>
            <p:nvPr/>
          </p:nvSpPr>
          <p:spPr>
            <a:xfrm>
              <a:off x="5467007" y="2815876"/>
              <a:ext cx="1361996" cy="10068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V01-1</a:t>
              </a:r>
            </a:p>
            <a:p>
              <a:pPr algn="ctr"/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FIB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7,661 bp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91EB5AFC-DC48-6FD7-609A-9B79E05B885E}"/>
              </a:ext>
            </a:extLst>
          </p:cNvPr>
          <p:cNvSpPr txBox="1"/>
          <p:nvPr/>
        </p:nvSpPr>
        <p:spPr>
          <a:xfrm>
            <a:off x="-270" y="0"/>
            <a:ext cx="6475232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Comparative visualization of plasmid pECV01-1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26014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CBB9B7B-C2E9-2A33-4428-D609D1B99818}"/>
              </a:ext>
            </a:extLst>
          </p:cNvPr>
          <p:cNvGrpSpPr>
            <a:grpSpLocks noChangeAspect="1"/>
          </p:cNvGrpSpPr>
          <p:nvPr/>
        </p:nvGrpSpPr>
        <p:grpSpPr>
          <a:xfrm>
            <a:off x="2286000" y="470168"/>
            <a:ext cx="7293205" cy="6310869"/>
            <a:chOff x="1712348" y="-420777"/>
            <a:chExt cx="8397524" cy="7266439"/>
          </a:xfrm>
        </p:grpSpPr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599AED36-334C-CF15-E544-3602D1309F2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68633" y="-254826"/>
              <a:ext cx="6908488" cy="6858000"/>
            </a:xfrm>
            <a:prstGeom prst="rect">
              <a:avLst/>
            </a:prstGeom>
          </p:spPr>
        </p:pic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61DF47AC-B604-9FF1-1704-550EDF4168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71064" y="-166580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3DAE4666-8233-313D-AC2D-BDE56D2F62DC}"/>
                </a:ext>
              </a:extLst>
            </p:cNvPr>
            <p:cNvSpPr txBox="1"/>
            <p:nvPr/>
          </p:nvSpPr>
          <p:spPr>
            <a:xfrm>
              <a:off x="8895944" y="4261693"/>
              <a:ext cx="570297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erC1</a:t>
              </a:r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2DDF72C7-3A5A-C922-0FF6-7889F459F22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196972" y="80443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C947F1C7-5EE8-4BF2-8D8D-E5BEFCF50D75}"/>
                </a:ext>
              </a:extLst>
            </p:cNvPr>
            <p:cNvSpPr txBox="1"/>
            <p:nvPr/>
          </p:nvSpPr>
          <p:spPr>
            <a:xfrm>
              <a:off x="8082348" y="539905"/>
              <a:ext cx="53543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ca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E8CE0ED0-1D23-AD9E-E959-758B677FBC29}"/>
                </a:ext>
              </a:extLst>
            </p:cNvPr>
            <p:cNvSpPr txBox="1"/>
            <p:nvPr/>
          </p:nvSpPr>
          <p:spPr>
            <a:xfrm>
              <a:off x="1938954" y="4261709"/>
              <a:ext cx="532456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903</a:t>
              </a: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F8D2637E-C99B-1A67-16F1-1E3D7DEE18F1}"/>
                </a:ext>
              </a:extLst>
            </p:cNvPr>
            <p:cNvCxnSpPr>
              <a:cxnSpLocks/>
            </p:cNvCxnSpPr>
            <p:nvPr/>
          </p:nvCxnSpPr>
          <p:spPr>
            <a:xfrm>
              <a:off x="2365063" y="2086770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80CFD593-EE66-1397-817D-AC8B646FCA21}"/>
                </a:ext>
              </a:extLst>
            </p:cNvPr>
            <p:cNvCxnSpPr>
              <a:cxnSpLocks/>
            </p:cNvCxnSpPr>
            <p:nvPr/>
          </p:nvCxnSpPr>
          <p:spPr>
            <a:xfrm>
              <a:off x="4777099" y="-165032"/>
              <a:ext cx="112306" cy="5232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DE57BE74-F1E4-5104-938F-961DC1B349E6}"/>
                </a:ext>
              </a:extLst>
            </p:cNvPr>
            <p:cNvCxnSpPr>
              <a:cxnSpLocks/>
            </p:cNvCxnSpPr>
            <p:nvPr/>
          </p:nvCxnSpPr>
          <p:spPr>
            <a:xfrm>
              <a:off x="3963948" y="168972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AF9A995-F9A8-D207-C841-3F059391D4B1}"/>
                </a:ext>
              </a:extLst>
            </p:cNvPr>
            <p:cNvSpPr txBox="1"/>
            <p:nvPr/>
          </p:nvSpPr>
          <p:spPr>
            <a:xfrm>
              <a:off x="1712348" y="3107490"/>
              <a:ext cx="621190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1X3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EEB01F47-1B39-D1EB-FDB7-C882BF16DBF6}"/>
                </a:ext>
              </a:extLst>
            </p:cNvPr>
            <p:cNvSpPr txBox="1"/>
            <p:nvPr/>
          </p:nvSpPr>
          <p:spPr>
            <a:xfrm>
              <a:off x="6523042" y="-312601"/>
              <a:ext cx="619516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Ec15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08EB4A1-69B5-92A3-E23B-7D94480AC1B9}"/>
                </a:ext>
              </a:extLst>
            </p:cNvPr>
            <p:cNvSpPr txBox="1"/>
            <p:nvPr/>
          </p:nvSpPr>
          <p:spPr>
            <a:xfrm>
              <a:off x="8546460" y="1095936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l3</a:t>
              </a:r>
            </a:p>
          </p:txBody>
        </p: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FD40FDF9-1574-6D02-E591-DE6C38609FF9}"/>
                </a:ext>
              </a:extLst>
            </p:cNvPr>
            <p:cNvCxnSpPr>
              <a:cxnSpLocks/>
            </p:cNvCxnSpPr>
            <p:nvPr/>
          </p:nvCxnSpPr>
          <p:spPr>
            <a:xfrm>
              <a:off x="8975917" y="4091232"/>
              <a:ext cx="96851" cy="7561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E102E779-C9BA-641A-7BDD-CDBF981291AD}"/>
                </a:ext>
              </a:extLst>
            </p:cNvPr>
            <p:cNvCxnSpPr>
              <a:cxnSpLocks/>
            </p:cNvCxnSpPr>
            <p:nvPr/>
          </p:nvCxnSpPr>
          <p:spPr>
            <a:xfrm>
              <a:off x="8858791" y="4411155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EA3C4738-ED26-A808-90EF-BDEB906184A6}"/>
                </a:ext>
              </a:extLst>
            </p:cNvPr>
            <p:cNvCxnSpPr>
              <a:cxnSpLocks/>
            </p:cNvCxnSpPr>
            <p:nvPr/>
          </p:nvCxnSpPr>
          <p:spPr>
            <a:xfrm>
              <a:off x="8682291" y="4765277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C6F6258F-DF8B-830B-0896-CA6E45086431}"/>
                </a:ext>
              </a:extLst>
            </p:cNvPr>
            <p:cNvCxnSpPr>
              <a:cxnSpLocks/>
            </p:cNvCxnSpPr>
            <p:nvPr/>
          </p:nvCxnSpPr>
          <p:spPr>
            <a:xfrm>
              <a:off x="8524260" y="5037493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A87B617E-D233-B3FF-51BE-D6DDB90AE399}"/>
                </a:ext>
              </a:extLst>
            </p:cNvPr>
            <p:cNvSpPr txBox="1"/>
            <p:nvPr/>
          </p:nvSpPr>
          <p:spPr>
            <a:xfrm>
              <a:off x="8715291" y="4617533"/>
              <a:ext cx="530045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diV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4CE2825D-15DD-49BF-AEAC-67A4CED99168}"/>
                </a:ext>
              </a:extLst>
            </p:cNvPr>
            <p:cNvSpPr txBox="1"/>
            <p:nvPr/>
          </p:nvSpPr>
          <p:spPr>
            <a:xfrm>
              <a:off x="8575495" y="4926563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in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145584C9-01B4-0A9F-9221-5D5546CB60EC}"/>
                </a:ext>
              </a:extLst>
            </p:cNvPr>
            <p:cNvCxnSpPr>
              <a:cxnSpLocks/>
            </p:cNvCxnSpPr>
            <p:nvPr/>
          </p:nvCxnSpPr>
          <p:spPr>
            <a:xfrm>
              <a:off x="6897921" y="6344438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3A2599EE-06AB-74AE-E534-6E4923404F89}"/>
                </a:ext>
              </a:extLst>
            </p:cNvPr>
            <p:cNvSpPr txBox="1"/>
            <p:nvPr/>
          </p:nvSpPr>
          <p:spPr>
            <a:xfrm>
              <a:off x="6962200" y="6229912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2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515FE397-9820-9F61-A9AC-669D8D2EA99E}"/>
                </a:ext>
              </a:extLst>
            </p:cNvPr>
            <p:cNvSpPr txBox="1"/>
            <p:nvPr/>
          </p:nvSpPr>
          <p:spPr>
            <a:xfrm>
              <a:off x="6023505" y="6507524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npR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F909E444-65D9-714B-979A-BAE00DA211A2}"/>
                </a:ext>
              </a:extLst>
            </p:cNvPr>
            <p:cNvCxnSpPr>
              <a:cxnSpLocks/>
            </p:cNvCxnSpPr>
            <p:nvPr/>
          </p:nvCxnSpPr>
          <p:spPr>
            <a:xfrm>
              <a:off x="5982878" y="6541425"/>
              <a:ext cx="113122" cy="857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531D2C0E-22EF-8597-58C0-2BD086BFC9E1}"/>
                </a:ext>
              </a:extLst>
            </p:cNvPr>
            <p:cNvSpPr txBox="1"/>
            <p:nvPr/>
          </p:nvSpPr>
          <p:spPr>
            <a:xfrm>
              <a:off x="5221032" y="6579878"/>
              <a:ext cx="906779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aTEM-1B</a:t>
              </a:r>
            </a:p>
          </p:txBody>
        </p: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id="{690C64FB-9698-5536-0515-EF8DB2BF5EE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00113" y="6422645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01C2533B-A9D5-3F79-1CFE-0E7ED0312DEF}"/>
                </a:ext>
              </a:extLst>
            </p:cNvPr>
            <p:cNvSpPr txBox="1"/>
            <p:nvPr/>
          </p:nvSpPr>
          <p:spPr>
            <a:xfrm>
              <a:off x="4364355" y="6406748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tR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C9F03598-68F3-4C62-B5DF-4AED379B6C83}"/>
                </a:ext>
              </a:extLst>
            </p:cNvPr>
            <p:cNvSpPr txBox="1"/>
            <p:nvPr/>
          </p:nvSpPr>
          <p:spPr>
            <a:xfrm>
              <a:off x="2622488" y="5380720"/>
              <a:ext cx="631900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As1</a:t>
              </a:r>
            </a:p>
          </p:txBody>
        </p: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id="{DA8B1F50-41C1-400F-4B33-B9E8CD0FD66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540090" y="4722466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id="{D2072119-3490-CD27-95CD-6EE1A518DD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3814" y="4322047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>
              <a:extLst>
                <a:ext uri="{FF2B5EF4-FFF2-40B4-BE49-F238E27FC236}">
                  <a16:creationId xmlns:a16="http://schemas.microsoft.com/office/drawing/2014/main" id="{351F5FD6-D854-E162-4C20-9FE6A41E900D}"/>
                </a:ext>
              </a:extLst>
            </p:cNvPr>
            <p:cNvSpPr txBox="1"/>
            <p:nvPr/>
          </p:nvSpPr>
          <p:spPr>
            <a:xfrm>
              <a:off x="2199746" y="4653214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b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44E5DBF3-B83A-6A77-7F8B-09D93B2C79A7}"/>
                </a:ext>
              </a:extLst>
            </p:cNvPr>
            <p:cNvSpPr txBox="1"/>
            <p:nvPr/>
          </p:nvSpPr>
          <p:spPr>
            <a:xfrm>
              <a:off x="3599316" y="34474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p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2" name="Picture 161">
              <a:extLst>
                <a:ext uri="{FF2B5EF4-FFF2-40B4-BE49-F238E27FC236}">
                  <a16:creationId xmlns:a16="http://schemas.microsoft.com/office/drawing/2014/main" id="{EE0ADC78-3E56-2BC1-FC92-51D7F329DED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909722" y="8804"/>
              <a:ext cx="1200150" cy="1485900"/>
            </a:xfrm>
            <a:prstGeom prst="rect">
              <a:avLst/>
            </a:prstGeom>
          </p:spPr>
        </p:pic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FBCD2123-B0AC-5B98-72C7-560AC1C1F0FD}"/>
                </a:ext>
              </a:extLst>
            </p:cNvPr>
            <p:cNvSpPr txBox="1"/>
            <p:nvPr/>
          </p:nvSpPr>
          <p:spPr>
            <a:xfrm>
              <a:off x="4338442" y="-311094"/>
              <a:ext cx="574016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erC2</a:t>
              </a:r>
            </a:p>
          </p:txBody>
        </p: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id="{548358E8-33F3-67B5-F01F-8A84F06FB20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40153" y="-254826"/>
              <a:ext cx="119431" cy="4246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391C5AFC-004C-F322-B245-32CA68B53414}"/>
                </a:ext>
              </a:extLst>
            </p:cNvPr>
            <p:cNvSpPr txBox="1"/>
            <p:nvPr/>
          </p:nvSpPr>
          <p:spPr>
            <a:xfrm>
              <a:off x="6154016" y="-410451"/>
              <a:ext cx="490947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ap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BCE92B1D-19D1-A9E6-0658-38302C67F4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91637" y="311275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CA503035-F62F-EDDB-027E-ACBBB9434C4C}"/>
                </a:ext>
              </a:extLst>
            </p:cNvPr>
            <p:cNvSpPr txBox="1"/>
            <p:nvPr/>
          </p:nvSpPr>
          <p:spPr>
            <a:xfrm>
              <a:off x="7250409" y="-44833"/>
              <a:ext cx="514762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lt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864DB411-C717-9C25-2341-3B348063CD88}"/>
                </a:ext>
              </a:extLst>
            </p:cNvPr>
            <p:cNvSpPr txBox="1"/>
            <p:nvPr/>
          </p:nvSpPr>
          <p:spPr>
            <a:xfrm>
              <a:off x="7626725" y="170341"/>
              <a:ext cx="514762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26</a:t>
              </a:r>
            </a:p>
          </p:txBody>
        </p: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125E1558-EC82-8AAA-23AD-13C5CECEAF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030175" y="672413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id="{272D0603-3653-A0C9-1020-DE65D0F902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509082" y="1239285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id="{1606A183-18FF-8AD7-7E6A-C7D912A93A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761589" y="1678378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id="{4FF461E3-3C47-CAF9-A9E8-2A6FA9BAA040}"/>
                </a:ext>
              </a:extLst>
            </p:cNvPr>
            <p:cNvCxnSpPr>
              <a:cxnSpLocks/>
            </p:cNvCxnSpPr>
            <p:nvPr/>
          </p:nvCxnSpPr>
          <p:spPr>
            <a:xfrm>
              <a:off x="8909722" y="2080823"/>
              <a:ext cx="1454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id="{B00BAB1E-1FDD-1137-6CB5-9F6EA50E801B}"/>
                </a:ext>
              </a:extLst>
            </p:cNvPr>
            <p:cNvSpPr txBox="1"/>
            <p:nvPr/>
          </p:nvSpPr>
          <p:spPr>
            <a:xfrm>
              <a:off x="8789818" y="1550566"/>
              <a:ext cx="530630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406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07D5375D-7160-D87B-682C-1AE87FD54C76}"/>
                </a:ext>
              </a:extLst>
            </p:cNvPr>
            <p:cNvSpPr txBox="1"/>
            <p:nvPr/>
          </p:nvSpPr>
          <p:spPr>
            <a:xfrm>
              <a:off x="8968254" y="1926497"/>
              <a:ext cx="530630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qacE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id="{ACDC8617-18C8-AADE-AD15-ABBBCF10EFDC}"/>
                </a:ext>
              </a:extLst>
            </p:cNvPr>
            <p:cNvCxnSpPr>
              <a:cxnSpLocks/>
            </p:cNvCxnSpPr>
            <p:nvPr/>
          </p:nvCxnSpPr>
          <p:spPr>
            <a:xfrm>
              <a:off x="9002300" y="2391322"/>
              <a:ext cx="1454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4A06109D-D020-D3AC-172E-A95B13F7E8E6}"/>
                </a:ext>
              </a:extLst>
            </p:cNvPr>
            <p:cNvSpPr txBox="1"/>
            <p:nvPr/>
          </p:nvSpPr>
          <p:spPr>
            <a:xfrm>
              <a:off x="9072767" y="2264811"/>
              <a:ext cx="850599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adA1</a:t>
              </a:r>
            </a:p>
          </p:txBody>
        </p:sp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id="{13AA0546-6450-6AA0-CA77-1DAF65FD313F}"/>
                </a:ext>
              </a:extLst>
            </p:cNvPr>
            <p:cNvCxnSpPr>
              <a:cxnSpLocks/>
            </p:cNvCxnSpPr>
            <p:nvPr/>
          </p:nvCxnSpPr>
          <p:spPr>
            <a:xfrm>
              <a:off x="9077786" y="2919737"/>
              <a:ext cx="1454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id="{C9191724-1870-F0A4-4536-ACD2CDB0D530}"/>
                </a:ext>
              </a:extLst>
            </p:cNvPr>
            <p:cNvSpPr txBox="1"/>
            <p:nvPr/>
          </p:nvSpPr>
          <p:spPr>
            <a:xfrm>
              <a:off x="9140641" y="2778297"/>
              <a:ext cx="607408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lA1</a:t>
              </a:r>
            </a:p>
          </p:txBody>
        </p:sp>
        <p:cxnSp>
          <p:nvCxnSpPr>
            <p:cNvPr id="182" name="Straight Connector 181">
              <a:extLst>
                <a:ext uri="{FF2B5EF4-FFF2-40B4-BE49-F238E27FC236}">
                  <a16:creationId xmlns:a16="http://schemas.microsoft.com/office/drawing/2014/main" id="{8C052835-C7F5-423B-887F-A7AB5D474F94}"/>
                </a:ext>
              </a:extLst>
            </p:cNvPr>
            <p:cNvCxnSpPr>
              <a:cxnSpLocks/>
            </p:cNvCxnSpPr>
            <p:nvPr/>
          </p:nvCxnSpPr>
          <p:spPr>
            <a:xfrm>
              <a:off x="9067813" y="3537883"/>
              <a:ext cx="1454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7356FA99-9E46-4DCB-CE64-373211DDBE9D}"/>
                </a:ext>
              </a:extLst>
            </p:cNvPr>
            <p:cNvSpPr txBox="1"/>
            <p:nvPr/>
          </p:nvSpPr>
          <p:spPr>
            <a:xfrm>
              <a:off x="9116347" y="3390823"/>
              <a:ext cx="57143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adA2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7B30D977-2915-EC09-C98B-D2B4D7DCA045}"/>
                </a:ext>
              </a:extLst>
            </p:cNvPr>
            <p:cNvSpPr txBox="1"/>
            <p:nvPr/>
          </p:nvSpPr>
          <p:spPr>
            <a:xfrm>
              <a:off x="8977755" y="3828892"/>
              <a:ext cx="624227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fA12</a:t>
              </a:r>
            </a:p>
          </p:txBody>
        </p:sp>
        <p:cxnSp>
          <p:nvCxnSpPr>
            <p:cNvPr id="185" name="Straight Connector 184">
              <a:extLst>
                <a:ext uri="{FF2B5EF4-FFF2-40B4-BE49-F238E27FC236}">
                  <a16:creationId xmlns:a16="http://schemas.microsoft.com/office/drawing/2014/main" id="{5A38AA8D-1072-E418-F6F4-B5F6A68245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980929" y="3986912"/>
              <a:ext cx="91839" cy="7511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62D1FC54-DA1C-E6E6-8E7E-0477F39A7ABE}"/>
                </a:ext>
              </a:extLst>
            </p:cNvPr>
            <p:cNvSpPr txBox="1"/>
            <p:nvPr/>
          </p:nvSpPr>
          <p:spPr>
            <a:xfrm>
              <a:off x="8993419" y="4062479"/>
              <a:ext cx="624227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Ssu9</a:t>
              </a:r>
            </a:p>
          </p:txBody>
        </p: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04647D76-DF64-0BE8-12A1-7BA59BA2DD58}"/>
                </a:ext>
              </a:extLst>
            </p:cNvPr>
            <p:cNvCxnSpPr>
              <a:cxnSpLocks/>
            </p:cNvCxnSpPr>
            <p:nvPr/>
          </p:nvCxnSpPr>
          <p:spPr>
            <a:xfrm>
              <a:off x="8074180" y="5587272"/>
              <a:ext cx="13448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BBEE6C14-3C23-C46F-39AE-4711BD0A4EC1}"/>
                </a:ext>
              </a:extLst>
            </p:cNvPr>
            <p:cNvSpPr txBox="1"/>
            <p:nvPr/>
          </p:nvSpPr>
          <p:spPr>
            <a:xfrm>
              <a:off x="8108720" y="5454380"/>
              <a:ext cx="631900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nAs1</a:t>
              </a:r>
            </a:p>
          </p:txBody>
        </p: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7898B1CC-E393-015B-1D4A-BC5B52129DBA}"/>
                </a:ext>
              </a:extLst>
            </p:cNvPr>
            <p:cNvCxnSpPr>
              <a:cxnSpLocks/>
            </p:cNvCxnSpPr>
            <p:nvPr/>
          </p:nvCxnSpPr>
          <p:spPr>
            <a:xfrm>
              <a:off x="5511436" y="6557089"/>
              <a:ext cx="113122" cy="857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Straight Connector 198">
              <a:extLst>
                <a:ext uri="{FF2B5EF4-FFF2-40B4-BE49-F238E27FC236}">
                  <a16:creationId xmlns:a16="http://schemas.microsoft.com/office/drawing/2014/main" id="{27806E6D-A1D3-2034-7EF4-468640A81CE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205582" y="6280213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id="{AED20015-4DD6-D31F-F83D-87C3C26646E4}"/>
                </a:ext>
              </a:extLst>
            </p:cNvPr>
            <p:cNvSpPr txBox="1"/>
            <p:nvPr/>
          </p:nvSpPr>
          <p:spPr>
            <a:xfrm>
              <a:off x="3909091" y="6237255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et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1" name="Straight Connector 200">
              <a:extLst>
                <a:ext uri="{FF2B5EF4-FFF2-40B4-BE49-F238E27FC236}">
                  <a16:creationId xmlns:a16="http://schemas.microsoft.com/office/drawing/2014/main" id="{B1BBA669-BF9F-06B4-1A47-B282CC2713E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04232" y="6013871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id="{13EE58DA-1411-E54F-3B5A-6EF99C8C4D5F}"/>
                </a:ext>
              </a:extLst>
            </p:cNvPr>
            <p:cNvSpPr txBox="1"/>
            <p:nvPr/>
          </p:nvSpPr>
          <p:spPr>
            <a:xfrm>
              <a:off x="3263708" y="5953821"/>
              <a:ext cx="537122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am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3" name="Straight Connector 202">
              <a:extLst>
                <a:ext uri="{FF2B5EF4-FFF2-40B4-BE49-F238E27FC236}">
                  <a16:creationId xmlns:a16="http://schemas.microsoft.com/office/drawing/2014/main" id="{EC6CFF70-F722-4DAC-86E7-EC6C841D59A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014879" y="5401024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Connector 203">
              <a:extLst>
                <a:ext uri="{FF2B5EF4-FFF2-40B4-BE49-F238E27FC236}">
                  <a16:creationId xmlns:a16="http://schemas.microsoft.com/office/drawing/2014/main" id="{DEAB75C0-BBD2-936F-B1C0-E003EB6C419F}"/>
                </a:ext>
              </a:extLst>
            </p:cNvPr>
            <p:cNvCxnSpPr>
              <a:cxnSpLocks/>
            </p:cNvCxnSpPr>
            <p:nvPr/>
          </p:nvCxnSpPr>
          <p:spPr>
            <a:xfrm rot="1320000" flipV="1">
              <a:off x="2180908" y="3205392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Straight Connector 204">
              <a:extLst>
                <a:ext uri="{FF2B5EF4-FFF2-40B4-BE49-F238E27FC236}">
                  <a16:creationId xmlns:a16="http://schemas.microsoft.com/office/drawing/2014/main" id="{D7C25A53-52DE-C51E-29D0-F6AB287F674D}"/>
                </a:ext>
              </a:extLst>
            </p:cNvPr>
            <p:cNvCxnSpPr>
              <a:cxnSpLocks/>
            </p:cNvCxnSpPr>
            <p:nvPr/>
          </p:nvCxnSpPr>
          <p:spPr>
            <a:xfrm rot="1320000" flipV="1">
              <a:off x="2162390" y="3028780"/>
              <a:ext cx="135079" cy="5910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id="{06F25FB8-CDE0-9B64-291F-A60CC1CBE67C}"/>
                </a:ext>
              </a:extLst>
            </p:cNvPr>
            <p:cNvSpPr txBox="1"/>
            <p:nvPr/>
          </p:nvSpPr>
          <p:spPr>
            <a:xfrm>
              <a:off x="1768945" y="2920025"/>
              <a:ext cx="555796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1A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id="{D2372386-7024-44EC-7383-5B4494F396D3}"/>
                </a:ext>
              </a:extLst>
            </p:cNvPr>
            <p:cNvSpPr txBox="1"/>
            <p:nvPr/>
          </p:nvSpPr>
          <p:spPr>
            <a:xfrm>
              <a:off x="1919128" y="1945170"/>
              <a:ext cx="555796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D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8" name="Straight Connector 207">
              <a:extLst>
                <a:ext uri="{FF2B5EF4-FFF2-40B4-BE49-F238E27FC236}">
                  <a16:creationId xmlns:a16="http://schemas.microsoft.com/office/drawing/2014/main" id="{26F59D53-5F52-4436-1ADB-F8AA86D0F341}"/>
                </a:ext>
              </a:extLst>
            </p:cNvPr>
            <p:cNvCxnSpPr>
              <a:cxnSpLocks/>
            </p:cNvCxnSpPr>
            <p:nvPr/>
          </p:nvCxnSpPr>
          <p:spPr>
            <a:xfrm>
              <a:off x="2551647" y="1636690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>
              <a:extLst>
                <a:ext uri="{FF2B5EF4-FFF2-40B4-BE49-F238E27FC236}">
                  <a16:creationId xmlns:a16="http://schemas.microsoft.com/office/drawing/2014/main" id="{FA230D14-D94A-9075-C242-0594895D0560}"/>
                </a:ext>
              </a:extLst>
            </p:cNvPr>
            <p:cNvCxnSpPr>
              <a:cxnSpLocks/>
            </p:cNvCxnSpPr>
            <p:nvPr/>
          </p:nvCxnSpPr>
          <p:spPr>
            <a:xfrm>
              <a:off x="2879238" y="1079790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6997BDAE-26A9-5FE8-1007-FA6AA3181933}"/>
                </a:ext>
              </a:extLst>
            </p:cNvPr>
            <p:cNvSpPr txBox="1"/>
            <p:nvPr/>
          </p:nvSpPr>
          <p:spPr>
            <a:xfrm>
              <a:off x="2117703" y="1498576"/>
              <a:ext cx="53736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umu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510B72BA-2D76-294F-2CE3-565855469261}"/>
                </a:ext>
              </a:extLst>
            </p:cNvPr>
            <p:cNvSpPr txBox="1"/>
            <p:nvPr/>
          </p:nvSpPr>
          <p:spPr>
            <a:xfrm>
              <a:off x="2541082" y="946065"/>
              <a:ext cx="47000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ir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2" name="Straight Connector 211">
              <a:extLst>
                <a:ext uri="{FF2B5EF4-FFF2-40B4-BE49-F238E27FC236}">
                  <a16:creationId xmlns:a16="http://schemas.microsoft.com/office/drawing/2014/main" id="{BD08C9DF-FF49-D2D5-D789-3A79E8448737}"/>
                </a:ext>
              </a:extLst>
            </p:cNvPr>
            <p:cNvCxnSpPr>
              <a:cxnSpLocks/>
            </p:cNvCxnSpPr>
            <p:nvPr/>
          </p:nvCxnSpPr>
          <p:spPr>
            <a:xfrm>
              <a:off x="3211100" y="749352"/>
              <a:ext cx="1144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20569A6D-B9D0-64D5-ED89-D08F3410B437}"/>
                </a:ext>
              </a:extLst>
            </p:cNvPr>
            <p:cNvSpPr txBox="1"/>
            <p:nvPr/>
          </p:nvSpPr>
          <p:spPr>
            <a:xfrm>
              <a:off x="2846220" y="609164"/>
              <a:ext cx="53712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arA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6" name="Straight Connector 215">
              <a:extLst>
                <a:ext uri="{FF2B5EF4-FFF2-40B4-BE49-F238E27FC236}">
                  <a16:creationId xmlns:a16="http://schemas.microsoft.com/office/drawing/2014/main" id="{83048892-954A-19EA-A7DB-60DE4B46E7F5}"/>
                </a:ext>
              </a:extLst>
            </p:cNvPr>
            <p:cNvCxnSpPr>
              <a:cxnSpLocks/>
            </p:cNvCxnSpPr>
            <p:nvPr/>
          </p:nvCxnSpPr>
          <p:spPr>
            <a:xfrm rot="720000" flipH="1" flipV="1">
              <a:off x="5829266" y="-268739"/>
              <a:ext cx="137160" cy="3879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39DDA0D1-43E1-0635-8EA1-1CD9BBB6345D}"/>
                </a:ext>
              </a:extLst>
            </p:cNvPr>
            <p:cNvSpPr txBox="1"/>
            <p:nvPr/>
          </p:nvSpPr>
          <p:spPr>
            <a:xfrm>
              <a:off x="5441138" y="-420777"/>
              <a:ext cx="527531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vgaC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22" name="Straight Connector 221">
              <a:extLst>
                <a:ext uri="{FF2B5EF4-FFF2-40B4-BE49-F238E27FC236}">
                  <a16:creationId xmlns:a16="http://schemas.microsoft.com/office/drawing/2014/main" id="{E5AC9A89-1895-BF5E-536E-A8C5D22CDB5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790933" y="451951"/>
              <a:ext cx="134258" cy="4155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261F7BBC-F9E1-67DC-19A5-0384E34B6B67}"/>
                </a:ext>
              </a:extLst>
            </p:cNvPr>
            <p:cNvSpPr txBox="1"/>
            <p:nvPr/>
          </p:nvSpPr>
          <p:spPr>
            <a:xfrm>
              <a:off x="7855321" y="299292"/>
              <a:ext cx="514762" cy="2657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fB</a:t>
              </a:r>
              <a:endParaRPr lang="en-US" sz="9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744A571-7B26-B1F7-3C5A-7243D23348FE}"/>
                </a:ext>
              </a:extLst>
            </p:cNvPr>
            <p:cNvSpPr txBox="1"/>
            <p:nvPr/>
          </p:nvSpPr>
          <p:spPr>
            <a:xfrm>
              <a:off x="4948376" y="2815876"/>
              <a:ext cx="1408658" cy="10631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CV01-2</a:t>
              </a:r>
            </a:p>
            <a:p>
              <a:pPr algn="ctr"/>
              <a:r>
                <a:rPr lang="en-US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ncR</a:t>
              </a:r>
              <a:endParaRPr 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,489 bp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F50BCE92-CCAC-E00C-A4E5-854225908A13}"/>
              </a:ext>
            </a:extLst>
          </p:cNvPr>
          <p:cNvSpPr txBox="1"/>
          <p:nvPr/>
        </p:nvSpPr>
        <p:spPr>
          <a:xfrm>
            <a:off x="-270" y="0"/>
            <a:ext cx="566105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B. </a:t>
            </a:r>
            <a:r>
              <a:rPr lang="en-US" sz="1600" dirty="0">
                <a:effectLst/>
                <a:latin typeface="Times New Roman" panose="02020603050405020304" pitchFamily="18" charset="0"/>
                <a:ea typeface="Malgun Gothic" panose="020B0503020000020004" pitchFamily="34" charset="-127"/>
              </a:rPr>
              <a:t>Comparative visualization of plasmid pECV01-2</a:t>
            </a:r>
            <a:r>
              <a:rPr lang="en-US" sz="1600" b="1" i="0" u="none" strike="noStrike" baseline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sz="4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1880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24</TotalTime>
  <Words>369</Words>
  <Application>Microsoft Office PowerPoint</Application>
  <PresentationFormat>Widescreen</PresentationFormat>
  <Paragraphs>29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g, Kidon</dc:creator>
  <cp:lastModifiedBy>Sung, Kidon</cp:lastModifiedBy>
  <cp:revision>66</cp:revision>
  <dcterms:created xsi:type="dcterms:W3CDTF">2023-06-02T13:32:44Z</dcterms:created>
  <dcterms:modified xsi:type="dcterms:W3CDTF">2024-05-10T15:07:39Z</dcterms:modified>
</cp:coreProperties>
</file>